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261" r:id="rId2"/>
    <p:sldId id="271" r:id="rId3"/>
    <p:sldId id="272" r:id="rId4"/>
    <p:sldId id="273" r:id="rId5"/>
    <p:sldId id="266" r:id="rId6"/>
    <p:sldId id="269" r:id="rId7"/>
    <p:sldId id="270" r:id="rId8"/>
    <p:sldId id="265" r:id="rId9"/>
    <p:sldId id="284" r:id="rId10"/>
    <p:sldId id="285" r:id="rId11"/>
    <p:sldId id="275" r:id="rId12"/>
    <p:sldId id="264" r:id="rId13"/>
    <p:sldId id="277" r:id="rId14"/>
    <p:sldId id="276" r:id="rId15"/>
    <p:sldId id="280" r:id="rId16"/>
    <p:sldId id="279" r:id="rId17"/>
    <p:sldId id="287" r:id="rId18"/>
    <p:sldId id="288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271" autoAdjust="0"/>
    <p:restoredTop sz="90920" autoAdjust="0"/>
  </p:normalViewPr>
  <p:slideViewPr>
    <p:cSldViewPr snapToGrid="0">
      <p:cViewPr varScale="1">
        <p:scale>
          <a:sx n="77" d="100"/>
          <a:sy n="77" d="100"/>
        </p:scale>
        <p:origin x="917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6D47F1-C476-43CC-A2E3-89253AB97F86}" type="datetimeFigureOut">
              <a:rPr lang="en-IN" smtClean="0"/>
              <a:t>27-12-2022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8B8747-51F4-48DB-A93E-AB244578EF3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840793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0BA2F9-C17D-4ECA-AE7E-0FC56DBA4EF9}" type="slidenum">
              <a:rPr lang="en-IN" smtClean="0"/>
              <a:t>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794574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0BA2F9-C17D-4ECA-AE7E-0FC56DBA4EF9}" type="slidenum">
              <a:rPr lang="en-IN" smtClean="0"/>
              <a:t>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3552861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8B8747-51F4-48DB-A93E-AB244578EF39}" type="slidenum">
              <a:rPr lang="en-IN" smtClean="0"/>
              <a:t>9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9947821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8B8747-51F4-48DB-A93E-AB244578EF39}" type="slidenum">
              <a:rPr lang="en-IN" smtClean="0"/>
              <a:t>1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745842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BA83-672A-4022-B1DE-16FF32EB4EFB}" type="datetimeFigureOut">
              <a:rPr lang="en-IN" smtClean="0"/>
              <a:t>27-1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98A4F-CE94-4323-B089-885A80AC9C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41444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BA83-672A-4022-B1DE-16FF32EB4EFB}" type="datetimeFigureOut">
              <a:rPr lang="en-IN" smtClean="0"/>
              <a:t>27-1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98A4F-CE94-4323-B089-885A80AC9C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13989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BA83-672A-4022-B1DE-16FF32EB4EFB}" type="datetimeFigureOut">
              <a:rPr lang="en-IN" smtClean="0"/>
              <a:t>27-1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98A4F-CE94-4323-B089-885A80AC9C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93464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BA83-672A-4022-B1DE-16FF32EB4EFB}" type="datetimeFigureOut">
              <a:rPr lang="en-IN" smtClean="0"/>
              <a:t>27-1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98A4F-CE94-4323-B089-885A80AC9C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41534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BA83-672A-4022-B1DE-16FF32EB4EFB}" type="datetimeFigureOut">
              <a:rPr lang="en-IN" smtClean="0"/>
              <a:t>27-1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98A4F-CE94-4323-B089-885A80AC9C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71135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BA83-672A-4022-B1DE-16FF32EB4EFB}" type="datetimeFigureOut">
              <a:rPr lang="en-IN" smtClean="0"/>
              <a:t>27-12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98A4F-CE94-4323-B089-885A80AC9C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99102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BA83-672A-4022-B1DE-16FF32EB4EFB}" type="datetimeFigureOut">
              <a:rPr lang="en-IN" smtClean="0"/>
              <a:t>27-12-20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98A4F-CE94-4323-B089-885A80AC9C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15007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BA83-672A-4022-B1DE-16FF32EB4EFB}" type="datetimeFigureOut">
              <a:rPr lang="en-IN" smtClean="0"/>
              <a:t>27-12-20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98A4F-CE94-4323-B089-885A80AC9C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58983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BA83-672A-4022-B1DE-16FF32EB4EFB}" type="datetimeFigureOut">
              <a:rPr lang="en-IN" smtClean="0"/>
              <a:t>27-12-20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98A4F-CE94-4323-B089-885A80AC9C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41878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BA83-672A-4022-B1DE-16FF32EB4EFB}" type="datetimeFigureOut">
              <a:rPr lang="en-IN" smtClean="0"/>
              <a:t>27-12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98A4F-CE94-4323-B089-885A80AC9C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966325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BA83-672A-4022-B1DE-16FF32EB4EFB}" type="datetimeFigureOut">
              <a:rPr lang="en-IN" smtClean="0"/>
              <a:t>27-12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98A4F-CE94-4323-B089-885A80AC9C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48606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2DBA83-672A-4022-B1DE-16FF32EB4EFB}" type="datetimeFigureOut">
              <a:rPr lang="en-IN" smtClean="0"/>
              <a:t>27-1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098A4F-CE94-4323-B089-885A80AC9C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74332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5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6.png"/><Relationship Id="rId4" Type="http://schemas.openxmlformats.org/officeDocument/2006/relationships/image" Target="../media/image55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emf"/><Relationship Id="rId7" Type="http://schemas.openxmlformats.org/officeDocument/2006/relationships/image" Target="../media/image62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1.png"/><Relationship Id="rId5" Type="http://schemas.openxmlformats.org/officeDocument/2006/relationships/image" Target="../media/image60.emf"/><Relationship Id="rId4" Type="http://schemas.openxmlformats.org/officeDocument/2006/relationships/image" Target="../media/image59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png"/><Relationship Id="rId7" Type="http://schemas.openxmlformats.org/officeDocument/2006/relationships/image" Target="../media/image67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6.png"/><Relationship Id="rId5" Type="http://schemas.openxmlformats.org/officeDocument/2006/relationships/image" Target="../media/image65.png"/><Relationship Id="rId4" Type="http://schemas.openxmlformats.org/officeDocument/2006/relationships/image" Target="../media/image64.png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jpe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jpe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3.png"/><Relationship Id="rId5" Type="http://schemas.openxmlformats.org/officeDocument/2006/relationships/image" Target="../media/image72.png"/><Relationship Id="rId4" Type="http://schemas.openxmlformats.org/officeDocument/2006/relationships/image" Target="../media/image71.png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4.jpe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81.png"/><Relationship Id="rId3" Type="http://schemas.openxmlformats.org/officeDocument/2006/relationships/image" Target="../media/image76.png"/><Relationship Id="rId7" Type="http://schemas.openxmlformats.org/officeDocument/2006/relationships/image" Target="../media/image80.png"/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9.png"/><Relationship Id="rId5" Type="http://schemas.openxmlformats.org/officeDocument/2006/relationships/image" Target="../media/image78.png"/><Relationship Id="rId4" Type="http://schemas.openxmlformats.org/officeDocument/2006/relationships/image" Target="../media/image77.png"/><Relationship Id="rId9" Type="http://schemas.openxmlformats.org/officeDocument/2006/relationships/image" Target="../media/image82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emf"/><Relationship Id="rId2" Type="http://schemas.openxmlformats.org/officeDocument/2006/relationships/image" Target="../media/image83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8.wdp"/><Relationship Id="rId13" Type="http://schemas.microsoft.com/office/2007/relationships/hdphoto" Target="../media/hdphoto10.wdp"/><Relationship Id="rId3" Type="http://schemas.openxmlformats.org/officeDocument/2006/relationships/image" Target="../media/image15.png"/><Relationship Id="rId7" Type="http://schemas.openxmlformats.org/officeDocument/2006/relationships/image" Target="../media/image17.png"/><Relationship Id="rId12" Type="http://schemas.openxmlformats.org/officeDocument/2006/relationships/image" Target="../media/image20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microsoft.com/office/2007/relationships/hdphoto" Target="../media/hdphoto7.wdp"/><Relationship Id="rId11" Type="http://schemas.microsoft.com/office/2007/relationships/hdphoto" Target="../media/hdphoto9.wdp"/><Relationship Id="rId5" Type="http://schemas.openxmlformats.org/officeDocument/2006/relationships/image" Target="../media/image16.png"/><Relationship Id="rId15" Type="http://schemas.microsoft.com/office/2007/relationships/hdphoto" Target="../media/hdphoto11.wdp"/><Relationship Id="rId10" Type="http://schemas.openxmlformats.org/officeDocument/2006/relationships/image" Target="../media/image19.png"/><Relationship Id="rId4" Type="http://schemas.microsoft.com/office/2007/relationships/hdphoto" Target="../media/hdphoto6.wdp"/><Relationship Id="rId9" Type="http://schemas.openxmlformats.org/officeDocument/2006/relationships/image" Target="../media/image18.png"/><Relationship Id="rId14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Relationship Id="rId9" Type="http://schemas.openxmlformats.org/officeDocument/2006/relationships/image" Target="../media/image3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3" Type="http://schemas.openxmlformats.org/officeDocument/2006/relationships/image" Target="../media/image40.png"/><Relationship Id="rId7" Type="http://schemas.openxmlformats.org/officeDocument/2006/relationships/image" Target="../media/image44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3.png"/><Relationship Id="rId5" Type="http://schemas.openxmlformats.org/officeDocument/2006/relationships/image" Target="../media/image42.png"/><Relationship Id="rId4" Type="http://schemas.openxmlformats.org/officeDocument/2006/relationships/image" Target="../media/image41.png"/><Relationship Id="rId9" Type="http://schemas.openxmlformats.org/officeDocument/2006/relationships/image" Target="../media/image4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2.png"/><Relationship Id="rId5" Type="http://schemas.openxmlformats.org/officeDocument/2006/relationships/image" Target="../media/image51.png"/><Relationship Id="rId4" Type="http://schemas.openxmlformats.org/officeDocument/2006/relationships/image" Target="../media/image5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61638" y="289036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1692292" y="934237"/>
            <a:ext cx="8779735" cy="5589537"/>
            <a:chOff x="1692292" y="934237"/>
            <a:chExt cx="8779735" cy="5589537"/>
          </a:xfrm>
        </p:grpSpPr>
        <p:grpSp>
          <p:nvGrpSpPr>
            <p:cNvPr id="18" name="Group 17"/>
            <p:cNvGrpSpPr/>
            <p:nvPr/>
          </p:nvGrpSpPr>
          <p:grpSpPr>
            <a:xfrm>
              <a:off x="2425680" y="934237"/>
              <a:ext cx="6072596" cy="3275944"/>
              <a:chOff x="1262978" y="-94321"/>
              <a:chExt cx="6072596" cy="3275944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1262978" y="-94321"/>
                <a:ext cx="8899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5868506" y="-68675"/>
                <a:ext cx="14670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n-US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</a:t>
                </a:r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SG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571633" y="-94321"/>
                <a:ext cx="14670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 </a:t>
                </a:r>
                <a:r>
                  <a:rPr lang="en-US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</a:t>
                </a:r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SG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1262978" y="2786645"/>
                <a:ext cx="8899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5868506" y="2812291"/>
                <a:ext cx="14670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n-US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</a:t>
                </a:r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SG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571633" y="2786645"/>
                <a:ext cx="14670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 </a:t>
                </a:r>
                <a:r>
                  <a:rPr lang="en-US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</a:t>
                </a:r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SG</a:t>
                </a:r>
              </a:p>
            </p:txBody>
          </p:sp>
        </p:grpSp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92292" y="1303129"/>
              <a:ext cx="2272895" cy="1827919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aturation sat="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68132" y="4226754"/>
              <a:ext cx="2284899" cy="1827919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aturation sat="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19584" y="4226754"/>
              <a:ext cx="2272895" cy="1827919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aturation sat="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54258" y="4226754"/>
              <a:ext cx="2323339" cy="1827919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aturation sat="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40840" y="1312712"/>
              <a:ext cx="2284899" cy="1827920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aturation sat="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01392" y="1312712"/>
              <a:ext cx="2323339" cy="1811347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5271220" y="3117837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224078" y="6154442"/>
              <a:ext cx="4539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987973" y="2061815"/>
              <a:ext cx="7561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Wo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8940839" y="4956047"/>
              <a:ext cx="15311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R-8/</a:t>
              </a:r>
              <a:r>
                <a:rPr lang="en-US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Vneo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513217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07875" y="3593857"/>
            <a:ext cx="4804064" cy="278001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07875" y="454445"/>
            <a:ext cx="4767485" cy="278001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2914" y="454445"/>
            <a:ext cx="4767485" cy="2780017"/>
          </a:xfrm>
          <a:prstGeom prst="rect">
            <a:avLst/>
          </a:prstGeom>
        </p:spPr>
      </p:pic>
      <p:pic>
        <p:nvPicPr>
          <p:cNvPr id="56" name="Picture 5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2914" y="3593856"/>
            <a:ext cx="4767485" cy="2780017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8641355" y="6274564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435867" y="6274564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m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8641355" y="3052436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l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435866" y="3052436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k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3031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6" name="Picture 125"/>
          <p:cNvPicPr>
            <a:picLocks noChangeAspect="1"/>
          </p:cNvPicPr>
          <p:nvPr/>
        </p:nvPicPr>
        <p:blipFill rotWithShape="1">
          <a:blip r:embed="rId2"/>
          <a:srcRect l="13618" t="6791" r="12813" b="8691"/>
          <a:stretch/>
        </p:blipFill>
        <p:spPr>
          <a:xfrm>
            <a:off x="7920110" y="4066315"/>
            <a:ext cx="905523" cy="1919709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01862" y="137980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780211" y="2863595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8029772" y="2860145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10031065" y="1352116"/>
            <a:ext cx="1709148" cy="1771004"/>
            <a:chOff x="10560297" y="1997522"/>
            <a:chExt cx="1709148" cy="1771004"/>
          </a:xfrm>
        </p:grpSpPr>
        <p:sp>
          <p:nvSpPr>
            <p:cNvPr id="19" name="TextBox 18"/>
            <p:cNvSpPr txBox="1"/>
            <p:nvPr/>
          </p:nvSpPr>
          <p:spPr>
            <a:xfrm>
              <a:off x="11147253" y="3399194"/>
              <a:ext cx="4539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d)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1" name="Group 20"/>
            <p:cNvGrpSpPr/>
            <p:nvPr/>
          </p:nvGrpSpPr>
          <p:grpSpPr>
            <a:xfrm>
              <a:off x="10560297" y="1997522"/>
              <a:ext cx="1709148" cy="1454883"/>
              <a:chOff x="-1234651" y="7340931"/>
              <a:chExt cx="2433947" cy="1837843"/>
            </a:xfrm>
          </p:grpSpPr>
          <p:pic>
            <p:nvPicPr>
              <p:cNvPr id="22" name="Picture 21">
                <a:extLst>
                  <a:ext uri="{FF2B5EF4-FFF2-40B4-BE49-F238E27FC236}">
                    <a16:creationId xmlns="" xmlns:a16="http://schemas.microsoft.com/office/drawing/2014/main" id="{00786270-71E4-4AD1-B50B-C91B8233D34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0177" t="13261"/>
              <a:stretch/>
            </p:blipFill>
            <p:spPr>
              <a:xfrm>
                <a:off x="-1234651" y="7340931"/>
                <a:ext cx="2433947" cy="1837843"/>
              </a:xfrm>
              <a:prstGeom prst="rect">
                <a:avLst/>
              </a:prstGeom>
            </p:spPr>
          </p:pic>
          <p:sp>
            <p:nvSpPr>
              <p:cNvPr id="23" name="TextBox 22">
                <a:extLst>
                  <a:ext uri="{FF2B5EF4-FFF2-40B4-BE49-F238E27FC236}">
                    <a16:creationId xmlns="" xmlns:a16="http://schemas.microsoft.com/office/drawing/2014/main" id="{9EF56443-6F4F-4830-AFFE-F3BE270A7447}"/>
                  </a:ext>
                </a:extLst>
              </p:cNvPr>
              <p:cNvSpPr txBox="1"/>
              <p:nvPr/>
            </p:nvSpPr>
            <p:spPr>
              <a:xfrm>
                <a:off x="220060" y="8119371"/>
                <a:ext cx="390813" cy="3887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</p:grpSp>
      </p:grpSp>
      <p:sp>
        <p:nvSpPr>
          <p:cNvPr id="106" name="TextBox 105"/>
          <p:cNvSpPr txBox="1"/>
          <p:nvPr/>
        </p:nvSpPr>
        <p:spPr>
          <a:xfrm>
            <a:off x="1537942" y="327234"/>
            <a:ext cx="10455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Wo Cells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7427043" y="234716"/>
            <a:ext cx="16466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TR-8/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Vneo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1527848" y="3596834"/>
            <a:ext cx="10455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Wo Cells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4" name="Group 143"/>
          <p:cNvGrpSpPr/>
          <p:nvPr/>
        </p:nvGrpSpPr>
        <p:grpSpPr>
          <a:xfrm>
            <a:off x="1084754" y="3879683"/>
            <a:ext cx="1442664" cy="2252035"/>
            <a:chOff x="2130805" y="3854178"/>
            <a:chExt cx="1442664" cy="2252035"/>
          </a:xfrm>
        </p:grpSpPr>
        <p:pic>
          <p:nvPicPr>
            <p:cNvPr id="127" name="Picture 12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556421" y="3854178"/>
              <a:ext cx="1017048" cy="2252035"/>
            </a:xfrm>
            <a:prstGeom prst="rect">
              <a:avLst/>
            </a:prstGeom>
          </p:spPr>
        </p:pic>
        <p:sp>
          <p:nvSpPr>
            <p:cNvPr id="134" name="TextBox 18"/>
            <p:cNvSpPr txBox="1">
              <a:spLocks noChangeArrowheads="1"/>
            </p:cNvSpPr>
            <p:nvPr/>
          </p:nvSpPr>
          <p:spPr bwMode="auto">
            <a:xfrm>
              <a:off x="2130805" y="4153860"/>
              <a:ext cx="509749" cy="19389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C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2" name="Group 141"/>
          <p:cNvGrpSpPr/>
          <p:nvPr/>
        </p:nvGrpSpPr>
        <p:grpSpPr>
          <a:xfrm>
            <a:off x="1508191" y="4286427"/>
            <a:ext cx="172623" cy="1565063"/>
            <a:chOff x="6832122" y="1326675"/>
            <a:chExt cx="172623" cy="1565063"/>
          </a:xfrm>
        </p:grpSpPr>
        <p:cxnSp>
          <p:nvCxnSpPr>
            <p:cNvPr id="135" name="Straight Connector 134"/>
            <p:cNvCxnSpPr/>
            <p:nvPr/>
          </p:nvCxnSpPr>
          <p:spPr>
            <a:xfrm>
              <a:off x="6852419" y="1678098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/>
            <p:cNvCxnSpPr/>
            <p:nvPr/>
          </p:nvCxnSpPr>
          <p:spPr>
            <a:xfrm>
              <a:off x="6861297" y="1410696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Connector 136"/>
            <p:cNvCxnSpPr/>
            <p:nvPr/>
          </p:nvCxnSpPr>
          <p:spPr>
            <a:xfrm>
              <a:off x="6855024" y="1566540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Connector 137"/>
            <p:cNvCxnSpPr/>
            <p:nvPr/>
          </p:nvCxnSpPr>
          <p:spPr>
            <a:xfrm>
              <a:off x="6845537" y="1950174"/>
              <a:ext cx="14344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/>
            <p:cNvCxnSpPr/>
            <p:nvPr/>
          </p:nvCxnSpPr>
          <p:spPr>
            <a:xfrm>
              <a:off x="6860671" y="1326675"/>
              <a:ext cx="14344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/>
            <p:cNvCxnSpPr/>
            <p:nvPr/>
          </p:nvCxnSpPr>
          <p:spPr>
            <a:xfrm>
              <a:off x="6832122" y="2600735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Connector 140"/>
            <p:cNvCxnSpPr/>
            <p:nvPr/>
          </p:nvCxnSpPr>
          <p:spPr>
            <a:xfrm>
              <a:off x="6832122" y="2891738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Straight Connector 142"/>
            <p:cNvCxnSpPr/>
            <p:nvPr/>
          </p:nvCxnSpPr>
          <p:spPr>
            <a:xfrm>
              <a:off x="6845537" y="2239172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5" name="TextBox 144">
            <a:extLst>
              <a:ext uri="{FF2B5EF4-FFF2-40B4-BE49-F238E27FC236}">
                <a16:creationId xmlns="" xmlns:a16="http://schemas.microsoft.com/office/drawing/2014/main" id="{490C28A7-A350-4343-BFBF-23EAC6E1EB70}"/>
              </a:ext>
            </a:extLst>
          </p:cNvPr>
          <p:cNvSpPr txBox="1"/>
          <p:nvPr/>
        </p:nvSpPr>
        <p:spPr>
          <a:xfrm>
            <a:off x="1657607" y="5969583"/>
            <a:ext cx="68635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IN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TextBox 149">
            <a:extLst>
              <a:ext uri="{FF2B5EF4-FFF2-40B4-BE49-F238E27FC236}">
                <a16:creationId xmlns="" xmlns:a16="http://schemas.microsoft.com/office/drawing/2014/main" id="{6498ED6F-954D-4BFE-8D7A-0F751F1B983E}"/>
              </a:ext>
            </a:extLst>
          </p:cNvPr>
          <p:cNvSpPr txBox="1"/>
          <p:nvPr/>
        </p:nvSpPr>
        <p:spPr>
          <a:xfrm flipH="1">
            <a:off x="2413772" y="5099695"/>
            <a:ext cx="5370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 </a:t>
            </a:r>
            <a:r>
              <a:rPr lang="en-US" sz="7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Rectangle 150"/>
          <p:cNvSpPr/>
          <p:nvPr/>
        </p:nvSpPr>
        <p:spPr>
          <a:xfrm>
            <a:off x="1766092" y="5104789"/>
            <a:ext cx="692070" cy="1949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Rectangle 152"/>
          <p:cNvSpPr/>
          <p:nvPr/>
        </p:nvSpPr>
        <p:spPr>
          <a:xfrm>
            <a:off x="1084754" y="3886519"/>
            <a:ext cx="1922932" cy="24857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1713564" y="6364867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7427044" y="3592034"/>
            <a:ext cx="16466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TR-8/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Vneo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Rectangle 155"/>
          <p:cNvSpPr/>
          <p:nvPr/>
        </p:nvSpPr>
        <p:spPr>
          <a:xfrm>
            <a:off x="7427043" y="3887089"/>
            <a:ext cx="1854082" cy="247777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="" xmlns:a16="http://schemas.microsoft.com/office/drawing/2014/main" id="{490C28A7-A350-4343-BFBF-23EAC6E1EB70}"/>
              </a:ext>
            </a:extLst>
          </p:cNvPr>
          <p:cNvSpPr txBox="1"/>
          <p:nvPr/>
        </p:nvSpPr>
        <p:spPr>
          <a:xfrm>
            <a:off x="7998058" y="5949315"/>
            <a:ext cx="68635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IN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2" name="Group 161"/>
          <p:cNvGrpSpPr/>
          <p:nvPr/>
        </p:nvGrpSpPr>
        <p:grpSpPr>
          <a:xfrm>
            <a:off x="7906037" y="4277878"/>
            <a:ext cx="172623" cy="1565063"/>
            <a:chOff x="6832122" y="1326675"/>
            <a:chExt cx="172623" cy="1565063"/>
          </a:xfrm>
        </p:grpSpPr>
        <p:cxnSp>
          <p:nvCxnSpPr>
            <p:cNvPr id="163" name="Straight Connector 162"/>
            <p:cNvCxnSpPr/>
            <p:nvPr/>
          </p:nvCxnSpPr>
          <p:spPr>
            <a:xfrm>
              <a:off x="6852419" y="1678098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Straight Connector 163"/>
            <p:cNvCxnSpPr/>
            <p:nvPr/>
          </p:nvCxnSpPr>
          <p:spPr>
            <a:xfrm>
              <a:off x="6861297" y="1410696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Straight Connector 164"/>
            <p:cNvCxnSpPr/>
            <p:nvPr/>
          </p:nvCxnSpPr>
          <p:spPr>
            <a:xfrm>
              <a:off x="6855024" y="1566540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Straight Connector 165"/>
            <p:cNvCxnSpPr/>
            <p:nvPr/>
          </p:nvCxnSpPr>
          <p:spPr>
            <a:xfrm>
              <a:off x="6845537" y="1950174"/>
              <a:ext cx="14344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Connector 166"/>
            <p:cNvCxnSpPr/>
            <p:nvPr/>
          </p:nvCxnSpPr>
          <p:spPr>
            <a:xfrm>
              <a:off x="6860671" y="1326675"/>
              <a:ext cx="14344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Straight Connector 167"/>
            <p:cNvCxnSpPr/>
            <p:nvPr/>
          </p:nvCxnSpPr>
          <p:spPr>
            <a:xfrm>
              <a:off x="6832122" y="2600735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Straight Connector 168"/>
            <p:cNvCxnSpPr/>
            <p:nvPr/>
          </p:nvCxnSpPr>
          <p:spPr>
            <a:xfrm>
              <a:off x="6832122" y="2891738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Straight Connector 169"/>
            <p:cNvCxnSpPr/>
            <p:nvPr/>
          </p:nvCxnSpPr>
          <p:spPr>
            <a:xfrm>
              <a:off x="6845537" y="2239172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1" name="TextBox 18"/>
          <p:cNvSpPr txBox="1">
            <a:spLocks noChangeArrowheads="1"/>
          </p:cNvSpPr>
          <p:nvPr/>
        </p:nvSpPr>
        <p:spPr bwMode="auto">
          <a:xfrm>
            <a:off x="7521987" y="4199228"/>
            <a:ext cx="509749" cy="19389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C0 </a:t>
            </a:r>
            <a:r>
              <a:rPr lang="en-IN" altLang="en-US" sz="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I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0 </a:t>
            </a:r>
            <a:r>
              <a:rPr lang="en-IN" altLang="en-US" sz="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I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altLang="en-US" sz="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IN" altLang="en-US" sz="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I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 </a:t>
            </a:r>
            <a:r>
              <a:rPr lang="en-IN" altLang="en-US" sz="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I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en-US" sz="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IN" altLang="en-US" sz="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IN" altLang="en-US" sz="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en-US" sz="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 </a:t>
            </a:r>
            <a:r>
              <a:rPr lang="en-US" altLang="en-US" sz="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I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en-US" sz="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 </a:t>
            </a:r>
            <a:r>
              <a:rPr lang="en-US" altLang="en-US" sz="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en-US" sz="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en-US" sz="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 </a:t>
            </a:r>
            <a:r>
              <a:rPr lang="en-US" altLang="en-US" sz="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8133486" y="636486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3625800" y="1401071"/>
            <a:ext cx="1704417" cy="1756577"/>
            <a:chOff x="4475279" y="1984072"/>
            <a:chExt cx="1704417" cy="1756577"/>
          </a:xfrm>
        </p:grpSpPr>
        <p:sp>
          <p:nvSpPr>
            <p:cNvPr id="11" name="TextBox 10"/>
            <p:cNvSpPr txBox="1"/>
            <p:nvPr/>
          </p:nvSpPr>
          <p:spPr>
            <a:xfrm>
              <a:off x="5021289" y="3371317"/>
              <a:ext cx="4539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4475279" y="1984072"/>
              <a:ext cx="1704417" cy="1464985"/>
              <a:chOff x="4475279" y="1984072"/>
              <a:chExt cx="1704417" cy="1464985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5"/>
              <a:srcRect l="10426" t="12790"/>
              <a:stretch/>
            </p:blipFill>
            <p:spPr>
              <a:xfrm>
                <a:off x="4475279" y="1984072"/>
                <a:ext cx="1704417" cy="1464985"/>
              </a:xfrm>
              <a:prstGeom prst="rect">
                <a:avLst/>
              </a:prstGeom>
            </p:spPr>
          </p:pic>
          <p:sp>
            <p:nvSpPr>
              <p:cNvPr id="123" name="TextBox 122">
                <a:extLst>
                  <a:ext uri="{FF2B5EF4-FFF2-40B4-BE49-F238E27FC236}">
                    <a16:creationId xmlns="" xmlns:a16="http://schemas.microsoft.com/office/drawing/2014/main" id="{9EF56443-6F4F-4830-AFFE-F3BE270A7447}"/>
                  </a:ext>
                </a:extLst>
              </p:cNvPr>
              <p:cNvSpPr txBox="1"/>
              <p:nvPr/>
            </p:nvSpPr>
            <p:spPr>
              <a:xfrm>
                <a:off x="5512029" y="2536324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</p:grpSp>
      </p:grpSp>
      <p:pic>
        <p:nvPicPr>
          <p:cNvPr id="4" name="Picture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16688" y="701852"/>
            <a:ext cx="1086839" cy="2036753"/>
          </a:xfrm>
          <a:prstGeom prst="rect">
            <a:avLst/>
          </a:prstGeom>
        </p:spPr>
      </p:pic>
      <p:sp>
        <p:nvSpPr>
          <p:cNvPr id="109" name="TextBox 108">
            <a:extLst>
              <a:ext uri="{FF2B5EF4-FFF2-40B4-BE49-F238E27FC236}">
                <a16:creationId xmlns="" xmlns:a16="http://schemas.microsoft.com/office/drawing/2014/main" id="{490C28A7-A350-4343-BFBF-23EAC6E1EB70}"/>
              </a:ext>
            </a:extLst>
          </p:cNvPr>
          <p:cNvSpPr txBox="1"/>
          <p:nvPr/>
        </p:nvSpPr>
        <p:spPr>
          <a:xfrm>
            <a:off x="1754182" y="2656384"/>
            <a:ext cx="5640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rf2</a:t>
            </a:r>
            <a:endParaRPr lang="en-IN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="" xmlns:a16="http://schemas.microsoft.com/office/drawing/2014/main" id="{6498ED6F-954D-4BFE-8D7A-0F751F1B983E}"/>
              </a:ext>
            </a:extLst>
          </p:cNvPr>
          <p:cNvSpPr txBox="1"/>
          <p:nvPr/>
        </p:nvSpPr>
        <p:spPr>
          <a:xfrm flipH="1">
            <a:off x="2598198" y="1477585"/>
            <a:ext cx="5315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1 </a:t>
            </a:r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Rectangle 101"/>
          <p:cNvSpPr/>
          <p:nvPr/>
        </p:nvSpPr>
        <p:spPr>
          <a:xfrm>
            <a:off x="1739940" y="1506811"/>
            <a:ext cx="761325" cy="1685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Rectangle 113"/>
          <p:cNvSpPr/>
          <p:nvPr/>
        </p:nvSpPr>
        <p:spPr>
          <a:xfrm>
            <a:off x="832276" y="638254"/>
            <a:ext cx="2246190" cy="22735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6" name="Group 25"/>
          <p:cNvGrpSpPr/>
          <p:nvPr/>
        </p:nvGrpSpPr>
        <p:grpSpPr>
          <a:xfrm>
            <a:off x="1123667" y="1074885"/>
            <a:ext cx="550989" cy="1661992"/>
            <a:chOff x="1084754" y="1508269"/>
            <a:chExt cx="550989" cy="1661992"/>
          </a:xfrm>
        </p:grpSpPr>
        <p:sp>
          <p:nvSpPr>
            <p:cNvPr id="103" name="TextBox 18"/>
            <p:cNvSpPr txBox="1">
              <a:spLocks noChangeArrowheads="1"/>
            </p:cNvSpPr>
            <p:nvPr/>
          </p:nvSpPr>
          <p:spPr bwMode="auto">
            <a:xfrm>
              <a:off x="1084754" y="1508269"/>
              <a:ext cx="459302" cy="16619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0" name="Group 69"/>
            <p:cNvGrpSpPr/>
            <p:nvPr/>
          </p:nvGrpSpPr>
          <p:grpSpPr>
            <a:xfrm>
              <a:off x="1454399" y="1593851"/>
              <a:ext cx="181344" cy="1208881"/>
              <a:chOff x="6823401" y="1326675"/>
              <a:chExt cx="181344" cy="1208881"/>
            </a:xfrm>
          </p:grpSpPr>
          <p:cxnSp>
            <p:nvCxnSpPr>
              <p:cNvPr id="71" name="Straight Connector 70"/>
              <p:cNvCxnSpPr/>
              <p:nvPr/>
            </p:nvCxnSpPr>
            <p:spPr>
              <a:xfrm>
                <a:off x="6852419" y="1678098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/>
              <p:cNvCxnSpPr/>
              <p:nvPr/>
            </p:nvCxnSpPr>
            <p:spPr>
              <a:xfrm>
                <a:off x="6861297" y="1410696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>
                <a:off x="6855024" y="1566540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/>
              <p:cNvCxnSpPr/>
              <p:nvPr/>
            </p:nvCxnSpPr>
            <p:spPr>
              <a:xfrm>
                <a:off x="6845537" y="1886436"/>
                <a:ext cx="14344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Straight Connector 74"/>
              <p:cNvCxnSpPr/>
              <p:nvPr/>
            </p:nvCxnSpPr>
            <p:spPr>
              <a:xfrm>
                <a:off x="6860671" y="1326675"/>
                <a:ext cx="14344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Connector 75"/>
              <p:cNvCxnSpPr/>
              <p:nvPr/>
            </p:nvCxnSpPr>
            <p:spPr>
              <a:xfrm>
                <a:off x="6823401" y="2442360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Straight Connector 76"/>
              <p:cNvCxnSpPr/>
              <p:nvPr/>
            </p:nvCxnSpPr>
            <p:spPr>
              <a:xfrm>
                <a:off x="6831053" y="2535556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/>
              <p:cNvCxnSpPr/>
              <p:nvPr/>
            </p:nvCxnSpPr>
            <p:spPr>
              <a:xfrm>
                <a:off x="6834170" y="2146323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5" name="Group 24"/>
          <p:cNvGrpSpPr/>
          <p:nvPr/>
        </p:nvGrpSpPr>
        <p:grpSpPr>
          <a:xfrm>
            <a:off x="7284333" y="583931"/>
            <a:ext cx="1898326" cy="2288218"/>
            <a:chOff x="7284333" y="1107433"/>
            <a:chExt cx="1898326" cy="2288218"/>
          </a:xfrm>
        </p:grpSpPr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827488" y="1280266"/>
              <a:ext cx="894029" cy="1930272"/>
            </a:xfrm>
            <a:prstGeom prst="rect">
              <a:avLst/>
            </a:prstGeom>
          </p:spPr>
        </p:pic>
        <p:grpSp>
          <p:nvGrpSpPr>
            <p:cNvPr id="8" name="Group 7"/>
            <p:cNvGrpSpPr/>
            <p:nvPr/>
          </p:nvGrpSpPr>
          <p:grpSpPr>
            <a:xfrm>
              <a:off x="7284333" y="1107433"/>
              <a:ext cx="1898326" cy="2288218"/>
              <a:chOff x="8166732" y="1027569"/>
              <a:chExt cx="1898326" cy="2288218"/>
            </a:xfrm>
          </p:grpSpPr>
          <p:grpSp>
            <p:nvGrpSpPr>
              <p:cNvPr id="32" name="Group 31"/>
              <p:cNvGrpSpPr/>
              <p:nvPr/>
            </p:nvGrpSpPr>
            <p:grpSpPr>
              <a:xfrm>
                <a:off x="8758894" y="1886389"/>
                <a:ext cx="1305345" cy="230832"/>
                <a:chOff x="9421759" y="2586458"/>
                <a:chExt cx="1539749" cy="328944"/>
              </a:xfrm>
            </p:grpSpPr>
            <p:sp>
              <p:nvSpPr>
                <p:cNvPr id="16" name="TextBox 15">
                  <a:extLst>
                    <a:ext uri="{FF2B5EF4-FFF2-40B4-BE49-F238E27FC236}">
                      <a16:creationId xmlns="" xmlns:a16="http://schemas.microsoft.com/office/drawing/2014/main" id="{6498ED6F-954D-4BFE-8D7A-0F751F1B983E}"/>
                    </a:ext>
                  </a:extLst>
                </p:cNvPr>
                <p:cNvSpPr txBox="1"/>
                <p:nvPr/>
              </p:nvSpPr>
              <p:spPr>
                <a:xfrm flipH="1">
                  <a:off x="10313176" y="2586458"/>
                  <a:ext cx="648332" cy="3289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1 </a:t>
                  </a:r>
                  <a:r>
                    <a:rPr lang="en-US" sz="9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" name="Rectangle 26"/>
                <p:cNvSpPr/>
                <p:nvPr/>
              </p:nvSpPr>
              <p:spPr>
                <a:xfrm>
                  <a:off x="9421759" y="2625327"/>
                  <a:ext cx="937034" cy="225355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5" name="TextBox 34">
                <a:extLst>
                  <a:ext uri="{FF2B5EF4-FFF2-40B4-BE49-F238E27FC236}">
                    <a16:creationId xmlns="" xmlns:a16="http://schemas.microsoft.com/office/drawing/2014/main" id="{490C28A7-A350-4343-BFBF-23EAC6E1EB70}"/>
                  </a:ext>
                </a:extLst>
              </p:cNvPr>
              <p:cNvSpPr txBox="1"/>
              <p:nvPr/>
            </p:nvSpPr>
            <p:spPr>
              <a:xfrm>
                <a:off x="8868682" y="3054177"/>
                <a:ext cx="88947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rf2</a:t>
                </a:r>
                <a:endParaRPr lang="en-IN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" name="Rectangle 114"/>
              <p:cNvSpPr/>
              <p:nvPr/>
            </p:nvSpPr>
            <p:spPr>
              <a:xfrm>
                <a:off x="8166732" y="1027569"/>
                <a:ext cx="1898326" cy="223722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92" name="Group 91"/>
          <p:cNvGrpSpPr/>
          <p:nvPr/>
        </p:nvGrpSpPr>
        <p:grpSpPr>
          <a:xfrm>
            <a:off x="7338648" y="1026669"/>
            <a:ext cx="550989" cy="1661992"/>
            <a:chOff x="1084754" y="1508269"/>
            <a:chExt cx="550989" cy="1661992"/>
          </a:xfrm>
        </p:grpSpPr>
        <p:sp>
          <p:nvSpPr>
            <p:cNvPr id="93" name="TextBox 18"/>
            <p:cNvSpPr txBox="1">
              <a:spLocks noChangeArrowheads="1"/>
            </p:cNvSpPr>
            <p:nvPr/>
          </p:nvSpPr>
          <p:spPr bwMode="auto">
            <a:xfrm>
              <a:off x="1084754" y="1508269"/>
              <a:ext cx="459302" cy="16619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4" name="Group 93"/>
            <p:cNvGrpSpPr/>
            <p:nvPr/>
          </p:nvGrpSpPr>
          <p:grpSpPr>
            <a:xfrm>
              <a:off x="1454399" y="1593851"/>
              <a:ext cx="181344" cy="1208881"/>
              <a:chOff x="6823401" y="1326675"/>
              <a:chExt cx="181344" cy="1208881"/>
            </a:xfrm>
          </p:grpSpPr>
          <p:cxnSp>
            <p:nvCxnSpPr>
              <p:cNvPr id="95" name="Straight Connector 94"/>
              <p:cNvCxnSpPr/>
              <p:nvPr/>
            </p:nvCxnSpPr>
            <p:spPr>
              <a:xfrm>
                <a:off x="6852419" y="1678098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Connector 95"/>
              <p:cNvCxnSpPr/>
              <p:nvPr/>
            </p:nvCxnSpPr>
            <p:spPr>
              <a:xfrm>
                <a:off x="6861297" y="1410696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Straight Connector 96"/>
              <p:cNvCxnSpPr/>
              <p:nvPr/>
            </p:nvCxnSpPr>
            <p:spPr>
              <a:xfrm>
                <a:off x="6855024" y="1566540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Straight Connector 97"/>
              <p:cNvCxnSpPr/>
              <p:nvPr/>
            </p:nvCxnSpPr>
            <p:spPr>
              <a:xfrm>
                <a:off x="6845537" y="1886436"/>
                <a:ext cx="14344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98"/>
              <p:cNvCxnSpPr/>
              <p:nvPr/>
            </p:nvCxnSpPr>
            <p:spPr>
              <a:xfrm>
                <a:off x="6860671" y="1326675"/>
                <a:ext cx="14344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Straight Connector 100"/>
              <p:cNvCxnSpPr/>
              <p:nvPr/>
            </p:nvCxnSpPr>
            <p:spPr>
              <a:xfrm>
                <a:off x="6823401" y="2442360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103"/>
              <p:cNvCxnSpPr/>
              <p:nvPr/>
            </p:nvCxnSpPr>
            <p:spPr>
              <a:xfrm>
                <a:off x="6831053" y="2535556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/>
              <p:cNvCxnSpPr/>
              <p:nvPr/>
            </p:nvCxnSpPr>
            <p:spPr>
              <a:xfrm>
                <a:off x="6834170" y="2146323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86" name="TextBox 85">
            <a:extLst>
              <a:ext uri="{FF2B5EF4-FFF2-40B4-BE49-F238E27FC236}">
                <a16:creationId xmlns="" xmlns:a16="http://schemas.microsoft.com/office/drawing/2014/main" id="{6498ED6F-954D-4BFE-8D7A-0F751F1B983E}"/>
              </a:ext>
            </a:extLst>
          </p:cNvPr>
          <p:cNvSpPr txBox="1"/>
          <p:nvPr/>
        </p:nvSpPr>
        <p:spPr>
          <a:xfrm flipH="1">
            <a:off x="8744042" y="5082905"/>
            <a:ext cx="5370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 </a:t>
            </a:r>
            <a:r>
              <a:rPr lang="en-US" sz="7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Rectangle 86"/>
          <p:cNvSpPr/>
          <p:nvPr/>
        </p:nvSpPr>
        <p:spPr>
          <a:xfrm>
            <a:off x="8096362" y="5087999"/>
            <a:ext cx="692070" cy="1949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 rot="16200000">
            <a:off x="9293537" y="1890237"/>
            <a:ext cx="12410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ld change w.r.t Control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 rot="16200000">
            <a:off x="2947401" y="1958792"/>
            <a:ext cx="12410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ld change w.r.t Control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4212550" y="1032535"/>
            <a:ext cx="4507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rf2</a:t>
            </a:r>
            <a:endParaRPr lang="en-I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0618021" y="1063088"/>
            <a:ext cx="4507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rf2</a:t>
            </a:r>
            <a:endParaRPr lang="en-I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0073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6750566"/>
              </p:ext>
            </p:extLst>
          </p:nvPr>
        </p:nvGraphicFramePr>
        <p:xfrm>
          <a:off x="1358282" y="772360"/>
          <a:ext cx="9277166" cy="5871739"/>
        </p:xfrm>
        <a:graphic>
          <a:graphicData uri="http://schemas.openxmlformats.org/drawingml/2006/table">
            <a:tbl>
              <a:tblPr firstRow="1" firstCol="1" bandRow="1">
                <a:tableStyleId>{616DA210-FB5B-4158-B5E0-FEB733F419BA}</a:tableStyleId>
              </a:tblPr>
              <a:tblGrid>
                <a:gridCol w="714919"/>
                <a:gridCol w="1450327"/>
                <a:gridCol w="2810146"/>
                <a:gridCol w="2731057"/>
                <a:gridCol w="1570717"/>
              </a:tblGrid>
              <a:tr h="5374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.No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s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</a:t>
                      </a: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5</a:t>
                      </a:r>
                      <a:r>
                        <a:rPr lang="en-US" sz="1200" dirty="0" smtClean="0"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’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– 3</a:t>
                      </a:r>
                      <a:r>
                        <a:rPr lang="en-US" sz="1200" dirty="0" smtClean="0"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’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</a:t>
                      </a: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5</a:t>
                      </a:r>
                      <a:r>
                        <a:rPr lang="en-US" sz="1200" dirty="0" smtClean="0"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’</a:t>
                      </a:r>
                      <a:r>
                        <a:rPr lang="en-US" sz="1200" baseline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– 3</a:t>
                      </a:r>
                      <a:r>
                        <a:rPr lang="en-US" sz="1200" baseline="0" dirty="0" smtClean="0"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’</a:t>
                      </a:r>
                      <a:r>
                        <a:rPr lang="en-US" sz="1200" baseline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mplicon Size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p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5751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N-1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IN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TGTTGGACTTACTTCACCCAAA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ACGGAGGGTTTCATGTAGT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9 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3147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N-2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CCCTATTTGTGTTATGGC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ATTGGTTGTGGGTGTATGT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4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4252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FSD2A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TTGATGAGGAGAGGCGG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TCTGTGGCCTTCTGCAT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2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5356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1A5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TGTGGTACGCCCCTGT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GGCAAAGAGTAAACCCA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6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3147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YSF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GAACAGCGTGAACCCTGTA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CTCGGAGTGGGACCTT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7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3147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hCG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ACTGCCCCACCATGACCC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GAGTGCACATTGACAGC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2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3147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M1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TCTCCAAGAGTTATGGTCTGGG	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ACGCTTGTAGATCGCCA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0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4252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P-2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ACAGCTGCACCACTGAG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TTGTTGCCCAGGAAAGTG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4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7566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P-9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CGAACTTTGACAGCGACA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ATTCACGTCGTCCTTAT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7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646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P-1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TGCTGGAAAACTGCAGGA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GTTTGCAGGGGATGGAT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7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5357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P-2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CTGCGAGTGCAAGATCAC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GAGAAACTCCTGCTTGGG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7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646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PA</a:t>
                      </a:r>
                      <a:endParaRPr lang="en-I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AGGAAATGGGACAGGG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GTTCGCCTGTTCGTATCT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9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42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-1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CCTGGAACTGCCCTACC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GAGAACTTGGGCAGAAC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4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7566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C-8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ACAAGCGTCGCAATGAG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AGTACGCATGGCTCTCCTT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2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7566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GGATTTGGTCGTATTGGG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GCTCCTGGAAGATGGTGAT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4</a:t>
                      </a:r>
                      <a:endParaRPr lang="en-I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61869" y="207719"/>
            <a:ext cx="10534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9740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175152" y="70446"/>
            <a:ext cx="1040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endParaRPr lang="en-I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5457195" y="3254271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7214900" y="6472664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876993" y="332633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0" name="Group 69"/>
          <p:cNvGrpSpPr/>
          <p:nvPr/>
        </p:nvGrpSpPr>
        <p:grpSpPr>
          <a:xfrm>
            <a:off x="4469440" y="132228"/>
            <a:ext cx="2325720" cy="3104455"/>
            <a:chOff x="4986783" y="371159"/>
            <a:chExt cx="2325720" cy="3104455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629854" y="1232092"/>
              <a:ext cx="1091279" cy="2243522"/>
            </a:xfrm>
            <a:prstGeom prst="rect">
              <a:avLst/>
            </a:prstGeom>
          </p:spPr>
        </p:pic>
        <p:grpSp>
          <p:nvGrpSpPr>
            <p:cNvPr id="27" name="Group 26"/>
            <p:cNvGrpSpPr/>
            <p:nvPr/>
          </p:nvGrpSpPr>
          <p:grpSpPr>
            <a:xfrm>
              <a:off x="5589283" y="371159"/>
              <a:ext cx="1708638" cy="1782956"/>
              <a:chOff x="1993453" y="518067"/>
              <a:chExt cx="1708638" cy="1782956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1993453" y="518067"/>
                <a:ext cx="91563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P-2</a:t>
                </a:r>
                <a:endParaRPr lang="en-IN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3105453" y="2039413"/>
                <a:ext cx="59663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2 </a:t>
                </a:r>
                <a:r>
                  <a:rPr lang="en-US" sz="11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9" name="Group 48"/>
            <p:cNvGrpSpPr/>
            <p:nvPr/>
          </p:nvGrpSpPr>
          <p:grpSpPr>
            <a:xfrm>
              <a:off x="5748460" y="900750"/>
              <a:ext cx="1564043" cy="366562"/>
              <a:chOff x="3533165" y="4161446"/>
              <a:chExt cx="1564043" cy="366562"/>
            </a:xfrm>
          </p:grpSpPr>
          <p:sp>
            <p:nvSpPr>
              <p:cNvPr id="50" name="TextBox 49"/>
              <p:cNvSpPr txBox="1"/>
              <p:nvPr/>
            </p:nvSpPr>
            <p:spPr>
              <a:xfrm rot="19018214">
                <a:off x="3840469" y="4161446"/>
                <a:ext cx="89800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 </a:t>
                </a:r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</a:t>
                </a:r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SG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 rot="19018214">
                <a:off x="3533165" y="4281787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 rot="19018214">
                <a:off x="4199205" y="4183378"/>
                <a:ext cx="89800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</a:t>
                </a:r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SG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5" name="Group 74"/>
            <p:cNvGrpSpPr/>
            <p:nvPr/>
          </p:nvGrpSpPr>
          <p:grpSpPr>
            <a:xfrm>
              <a:off x="4986783" y="1417853"/>
              <a:ext cx="565306" cy="1866119"/>
              <a:chOff x="4463792" y="1518153"/>
              <a:chExt cx="565306" cy="1866119"/>
            </a:xfrm>
          </p:grpSpPr>
          <p:grpSp>
            <p:nvGrpSpPr>
              <p:cNvPr id="76" name="Group 75"/>
              <p:cNvGrpSpPr/>
              <p:nvPr/>
            </p:nvGrpSpPr>
            <p:grpSpPr>
              <a:xfrm>
                <a:off x="4463792" y="1618149"/>
                <a:ext cx="565306" cy="1766123"/>
                <a:chOff x="5133355" y="3712733"/>
                <a:chExt cx="565306" cy="1766123"/>
              </a:xfrm>
            </p:grpSpPr>
            <p:sp>
              <p:nvSpPr>
                <p:cNvPr id="79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5133355" y="3816863"/>
                  <a:ext cx="565306" cy="16619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IN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 </a:t>
                  </a:r>
                  <a:r>
                    <a:rPr lang="en-IN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IN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 </a:t>
                  </a:r>
                  <a:r>
                    <a:rPr lang="en-IN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IN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 </a:t>
                  </a:r>
                  <a:r>
                    <a:rPr lang="en-IN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US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7 </a:t>
                  </a:r>
                  <a:r>
                    <a:rPr lang="en-US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US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 </a:t>
                  </a:r>
                  <a:r>
                    <a:rPr lang="en-US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80" name="Straight Connector 79"/>
                <p:cNvCxnSpPr/>
                <p:nvPr/>
              </p:nvCxnSpPr>
              <p:spPr>
                <a:xfrm>
                  <a:off x="5518266" y="4170041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" name="Straight Connector 80"/>
                <p:cNvCxnSpPr/>
                <p:nvPr/>
              </p:nvCxnSpPr>
              <p:spPr>
                <a:xfrm>
                  <a:off x="5517281" y="4018007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Straight Connector 81"/>
                <p:cNvCxnSpPr/>
                <p:nvPr/>
              </p:nvCxnSpPr>
              <p:spPr>
                <a:xfrm>
                  <a:off x="5510225" y="4435791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Straight Connector 82"/>
                <p:cNvCxnSpPr/>
                <p:nvPr/>
              </p:nvCxnSpPr>
              <p:spPr>
                <a:xfrm>
                  <a:off x="5511507" y="4731664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Straight Connector 83"/>
                <p:cNvCxnSpPr/>
                <p:nvPr/>
              </p:nvCxnSpPr>
              <p:spPr>
                <a:xfrm>
                  <a:off x="5496916" y="5085956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Straight Connector 84"/>
                <p:cNvCxnSpPr/>
                <p:nvPr/>
              </p:nvCxnSpPr>
              <p:spPr>
                <a:xfrm>
                  <a:off x="5510224" y="3816863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Straight Connector 85"/>
                <p:cNvCxnSpPr/>
                <p:nvPr/>
              </p:nvCxnSpPr>
              <p:spPr>
                <a:xfrm>
                  <a:off x="5496915" y="3712733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7" name="Rectangle 76"/>
              <p:cNvSpPr/>
              <p:nvPr/>
            </p:nvSpPr>
            <p:spPr>
              <a:xfrm>
                <a:off x="4465934" y="1624638"/>
                <a:ext cx="45717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 </a:t>
                </a:r>
                <a:r>
                  <a:rPr lang="en-IN" altLang="en-US" sz="6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Rectangle 77"/>
              <p:cNvSpPr/>
              <p:nvPr/>
            </p:nvSpPr>
            <p:spPr>
              <a:xfrm>
                <a:off x="4476083" y="1518153"/>
                <a:ext cx="45717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 </a:t>
                </a:r>
                <a:r>
                  <a:rPr lang="en-IN" altLang="en-US" sz="6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53" name="Group 52"/>
          <p:cNvGrpSpPr/>
          <p:nvPr/>
        </p:nvGrpSpPr>
        <p:grpSpPr>
          <a:xfrm>
            <a:off x="795666" y="163078"/>
            <a:ext cx="2386298" cy="3134862"/>
            <a:chOff x="1462098" y="409000"/>
            <a:chExt cx="2386298" cy="3134862"/>
          </a:xfrm>
        </p:grpSpPr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069031" y="1282050"/>
              <a:ext cx="1182727" cy="2261812"/>
            </a:xfrm>
            <a:prstGeom prst="rect">
              <a:avLst/>
            </a:prstGeom>
          </p:spPr>
        </p:pic>
        <p:grpSp>
          <p:nvGrpSpPr>
            <p:cNvPr id="58" name="Group 57"/>
            <p:cNvGrpSpPr/>
            <p:nvPr/>
          </p:nvGrpSpPr>
          <p:grpSpPr>
            <a:xfrm>
              <a:off x="2045492" y="409000"/>
              <a:ext cx="1802904" cy="1757494"/>
              <a:chOff x="1663618" y="734160"/>
              <a:chExt cx="1802904" cy="1757494"/>
            </a:xfrm>
          </p:grpSpPr>
          <p:grpSp>
            <p:nvGrpSpPr>
              <p:cNvPr id="26" name="Group 25"/>
              <p:cNvGrpSpPr/>
              <p:nvPr/>
            </p:nvGrpSpPr>
            <p:grpSpPr>
              <a:xfrm>
                <a:off x="1888068" y="734160"/>
                <a:ext cx="1578454" cy="1757494"/>
                <a:chOff x="5996161" y="303394"/>
                <a:chExt cx="1578454" cy="1757494"/>
              </a:xfrm>
            </p:grpSpPr>
            <p:sp>
              <p:nvSpPr>
                <p:cNvPr id="9" name="TextBox 8"/>
                <p:cNvSpPr txBox="1"/>
                <p:nvPr/>
              </p:nvSpPr>
              <p:spPr>
                <a:xfrm>
                  <a:off x="5996161" y="303394"/>
                  <a:ext cx="91563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MP-9</a:t>
                  </a:r>
                  <a:endParaRPr lang="en-IN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6977977" y="1799278"/>
                  <a:ext cx="59663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2 </a:t>
                  </a:r>
                  <a:r>
                    <a:rPr lang="en-US" sz="11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sz="1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2" name="Rectangle 31"/>
              <p:cNvSpPr/>
              <p:nvPr/>
            </p:nvSpPr>
            <p:spPr>
              <a:xfrm>
                <a:off x="1663618" y="2100643"/>
                <a:ext cx="1132705" cy="37212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57" name="Group 56"/>
              <p:cNvGrpSpPr/>
              <p:nvPr/>
            </p:nvGrpSpPr>
            <p:grpSpPr>
              <a:xfrm>
                <a:off x="1854068" y="1369653"/>
                <a:ext cx="1564043" cy="366562"/>
                <a:chOff x="1854068" y="1369653"/>
                <a:chExt cx="1564043" cy="366562"/>
              </a:xfrm>
            </p:grpSpPr>
            <p:sp>
              <p:nvSpPr>
                <p:cNvPr id="54" name="TextBox 53"/>
                <p:cNvSpPr txBox="1"/>
                <p:nvPr/>
              </p:nvSpPr>
              <p:spPr>
                <a:xfrm rot="19018214">
                  <a:off x="2161372" y="1369653"/>
                  <a:ext cx="89800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 </a:t>
                  </a:r>
                  <a:r>
                    <a:rPr lang="en-US" sz="10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M</a:t>
                  </a:r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MSG</a:t>
                  </a:r>
                  <a:endPara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 rot="19018214">
                  <a:off x="1854068" y="1489994"/>
                  <a:ext cx="61266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trol</a:t>
                  </a:r>
                  <a:endPara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" name="TextBox 55"/>
                <p:cNvSpPr txBox="1"/>
                <p:nvPr/>
              </p:nvSpPr>
              <p:spPr>
                <a:xfrm rot="19018214">
                  <a:off x="2520108" y="1391585"/>
                  <a:ext cx="89800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 </a:t>
                  </a:r>
                  <a:r>
                    <a:rPr lang="en-US" sz="10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M</a:t>
                  </a:r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MSG</a:t>
                  </a:r>
                  <a:endPara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12" name="Group 111"/>
            <p:cNvGrpSpPr/>
            <p:nvPr/>
          </p:nvGrpSpPr>
          <p:grpSpPr>
            <a:xfrm>
              <a:off x="1462098" y="1541553"/>
              <a:ext cx="565306" cy="1866119"/>
              <a:chOff x="4463792" y="1518153"/>
              <a:chExt cx="565306" cy="1866119"/>
            </a:xfrm>
          </p:grpSpPr>
          <p:grpSp>
            <p:nvGrpSpPr>
              <p:cNvPr id="113" name="Group 112"/>
              <p:cNvGrpSpPr/>
              <p:nvPr/>
            </p:nvGrpSpPr>
            <p:grpSpPr>
              <a:xfrm>
                <a:off x="4463792" y="1618149"/>
                <a:ext cx="565306" cy="1766123"/>
                <a:chOff x="5133355" y="3712733"/>
                <a:chExt cx="565306" cy="1766123"/>
              </a:xfrm>
            </p:grpSpPr>
            <p:sp>
              <p:nvSpPr>
                <p:cNvPr id="116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5133355" y="3816863"/>
                  <a:ext cx="565306" cy="16619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IN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 </a:t>
                  </a:r>
                  <a:r>
                    <a:rPr lang="en-IN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IN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 </a:t>
                  </a:r>
                  <a:r>
                    <a:rPr lang="en-IN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IN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 </a:t>
                  </a:r>
                  <a:r>
                    <a:rPr lang="en-IN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US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7 </a:t>
                  </a:r>
                  <a:r>
                    <a:rPr lang="en-US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US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 </a:t>
                  </a:r>
                  <a:r>
                    <a:rPr lang="en-US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17" name="Straight Connector 116"/>
                <p:cNvCxnSpPr/>
                <p:nvPr/>
              </p:nvCxnSpPr>
              <p:spPr>
                <a:xfrm>
                  <a:off x="5518266" y="4170041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8" name="Straight Connector 117"/>
                <p:cNvCxnSpPr/>
                <p:nvPr/>
              </p:nvCxnSpPr>
              <p:spPr>
                <a:xfrm>
                  <a:off x="5517281" y="4018007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9" name="Straight Connector 118"/>
                <p:cNvCxnSpPr/>
                <p:nvPr/>
              </p:nvCxnSpPr>
              <p:spPr>
                <a:xfrm>
                  <a:off x="5510225" y="4435791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0" name="Straight Connector 119"/>
                <p:cNvCxnSpPr/>
                <p:nvPr/>
              </p:nvCxnSpPr>
              <p:spPr>
                <a:xfrm>
                  <a:off x="5511507" y="4731664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1" name="Straight Connector 120"/>
                <p:cNvCxnSpPr/>
                <p:nvPr/>
              </p:nvCxnSpPr>
              <p:spPr>
                <a:xfrm>
                  <a:off x="5496916" y="5085956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2" name="Straight Connector 121"/>
                <p:cNvCxnSpPr/>
                <p:nvPr/>
              </p:nvCxnSpPr>
              <p:spPr>
                <a:xfrm>
                  <a:off x="5510224" y="3816863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3" name="Straight Connector 122"/>
                <p:cNvCxnSpPr/>
                <p:nvPr/>
              </p:nvCxnSpPr>
              <p:spPr>
                <a:xfrm>
                  <a:off x="5496915" y="3712733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4" name="Rectangle 113"/>
              <p:cNvSpPr/>
              <p:nvPr/>
            </p:nvSpPr>
            <p:spPr>
              <a:xfrm>
                <a:off x="4465934" y="1624638"/>
                <a:ext cx="45717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 </a:t>
                </a:r>
                <a:r>
                  <a:rPr lang="en-IN" altLang="en-US" sz="6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" name="Rectangle 114"/>
              <p:cNvSpPr/>
              <p:nvPr/>
            </p:nvSpPr>
            <p:spPr>
              <a:xfrm>
                <a:off x="4476083" y="1518153"/>
                <a:ext cx="45717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 </a:t>
                </a:r>
                <a:r>
                  <a:rPr lang="en-IN" altLang="en-US" sz="6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34" name="Rectangle 33"/>
          <p:cNvSpPr/>
          <p:nvPr/>
        </p:nvSpPr>
        <p:spPr>
          <a:xfrm>
            <a:off x="5498723" y="1593051"/>
            <a:ext cx="1132705" cy="372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2201470" y="3617320"/>
            <a:ext cx="2251311" cy="3054877"/>
            <a:chOff x="2144724" y="3676502"/>
            <a:chExt cx="2251311" cy="3054877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755247" y="4658941"/>
              <a:ext cx="1059077" cy="2072438"/>
            </a:xfrm>
            <a:prstGeom prst="rect">
              <a:avLst/>
            </a:prstGeom>
          </p:spPr>
        </p:pic>
        <p:sp>
          <p:nvSpPr>
            <p:cNvPr id="36" name="Rectangle 35"/>
            <p:cNvSpPr/>
            <p:nvPr/>
          </p:nvSpPr>
          <p:spPr>
            <a:xfrm>
              <a:off x="2679118" y="5738990"/>
              <a:ext cx="1135392" cy="34225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8" name="Group 27"/>
            <p:cNvGrpSpPr/>
            <p:nvPr/>
          </p:nvGrpSpPr>
          <p:grpSpPr>
            <a:xfrm>
              <a:off x="2954361" y="3676502"/>
              <a:ext cx="1426419" cy="2358513"/>
              <a:chOff x="2482583" y="3287031"/>
              <a:chExt cx="1423042" cy="2564386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2482583" y="3287031"/>
                <a:ext cx="926261" cy="4015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P-1</a:t>
                </a:r>
                <a:endParaRPr lang="en-IN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310399" y="5566971"/>
                <a:ext cx="595226" cy="2844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6 </a:t>
                </a:r>
                <a:r>
                  <a:rPr lang="en-US" sz="11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0" name="Group 39"/>
            <p:cNvGrpSpPr/>
            <p:nvPr/>
          </p:nvGrpSpPr>
          <p:grpSpPr>
            <a:xfrm>
              <a:off x="2785579" y="4240092"/>
              <a:ext cx="1610456" cy="356900"/>
              <a:chOff x="2670580" y="4167325"/>
              <a:chExt cx="1606644" cy="388053"/>
            </a:xfrm>
          </p:grpSpPr>
          <p:sp>
            <p:nvSpPr>
              <p:cNvPr id="37" name="TextBox 36"/>
              <p:cNvSpPr txBox="1"/>
              <p:nvPr/>
            </p:nvSpPr>
            <p:spPr>
              <a:xfrm rot="19018214">
                <a:off x="2978222" y="4167325"/>
                <a:ext cx="895877" cy="2677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 </a:t>
                </a:r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</a:t>
                </a:r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SG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 rot="19018214">
                <a:off x="2670580" y="4287665"/>
                <a:ext cx="611218" cy="2677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 rot="19018214">
                <a:off x="3381347" y="4189257"/>
                <a:ext cx="895877" cy="2677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</a:t>
                </a:r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SG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9" name="Group 58"/>
            <p:cNvGrpSpPr/>
            <p:nvPr/>
          </p:nvGrpSpPr>
          <p:grpSpPr>
            <a:xfrm>
              <a:off x="2144724" y="4740146"/>
              <a:ext cx="550989" cy="1938992"/>
              <a:chOff x="2144724" y="4740146"/>
              <a:chExt cx="550989" cy="1938992"/>
            </a:xfrm>
          </p:grpSpPr>
          <p:sp>
            <p:nvSpPr>
              <p:cNvPr id="109" name="TextBox 18"/>
              <p:cNvSpPr txBox="1">
                <a:spLocks noChangeArrowheads="1"/>
              </p:cNvSpPr>
              <p:nvPr/>
            </p:nvSpPr>
            <p:spPr bwMode="auto">
              <a:xfrm>
                <a:off x="2144724" y="4740146"/>
                <a:ext cx="459302" cy="19389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r>
                  <a: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 </a:t>
                </a:r>
                <a:r>
                  <a:rPr lang="en-IN" altLang="en-US" sz="6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 </a:t>
                </a:r>
                <a:r>
                  <a:rPr lang="en-IN" altLang="en-US" sz="6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 </a:t>
                </a:r>
                <a:r>
                  <a:rPr lang="en-IN" altLang="en-US" sz="6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I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 </a:t>
                </a:r>
                <a:r>
                  <a:rPr lang="en-IN" altLang="en-US" sz="6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I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n-IN" altLang="en-US" sz="6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7 </a:t>
                </a:r>
                <a:r>
                  <a:rPr lang="en-US" altLang="en-US" sz="6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US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 </a:t>
                </a:r>
                <a:r>
                  <a:rPr lang="en-US" altLang="en-US" sz="6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US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US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</a:t>
                </a:r>
                <a:r>
                  <a:rPr lang="en-US" altLang="en-US" sz="6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US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I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I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10" name="Group 109"/>
              <p:cNvGrpSpPr/>
              <p:nvPr/>
            </p:nvGrpSpPr>
            <p:grpSpPr>
              <a:xfrm>
                <a:off x="2545992" y="4825728"/>
                <a:ext cx="149721" cy="1451417"/>
                <a:chOff x="6855024" y="1326675"/>
                <a:chExt cx="149721" cy="1451417"/>
              </a:xfrm>
            </p:grpSpPr>
            <p:cxnSp>
              <p:nvCxnSpPr>
                <p:cNvPr id="111" name="Straight Connector 110"/>
                <p:cNvCxnSpPr/>
                <p:nvPr/>
              </p:nvCxnSpPr>
              <p:spPr>
                <a:xfrm>
                  <a:off x="6855024" y="1665960"/>
                  <a:ext cx="14344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4" name="Straight Connector 123"/>
                <p:cNvCxnSpPr/>
                <p:nvPr/>
              </p:nvCxnSpPr>
              <p:spPr>
                <a:xfrm>
                  <a:off x="6861297" y="1410696"/>
                  <a:ext cx="14344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5" name="Straight Connector 124"/>
                <p:cNvCxnSpPr/>
                <p:nvPr/>
              </p:nvCxnSpPr>
              <p:spPr>
                <a:xfrm>
                  <a:off x="6855024" y="1536060"/>
                  <a:ext cx="14344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" name="Straight Connector 125"/>
                <p:cNvCxnSpPr/>
                <p:nvPr/>
              </p:nvCxnSpPr>
              <p:spPr>
                <a:xfrm>
                  <a:off x="6855024" y="1977040"/>
                  <a:ext cx="143449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7" name="Straight Connector 126"/>
                <p:cNvCxnSpPr/>
                <p:nvPr/>
              </p:nvCxnSpPr>
              <p:spPr>
                <a:xfrm>
                  <a:off x="6860671" y="1326675"/>
                  <a:ext cx="143449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8" name="Straight Connector 127"/>
                <p:cNvCxnSpPr/>
                <p:nvPr/>
              </p:nvCxnSpPr>
              <p:spPr>
                <a:xfrm>
                  <a:off x="6860672" y="2507822"/>
                  <a:ext cx="14344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9" name="Straight Connector 128"/>
                <p:cNvCxnSpPr/>
                <p:nvPr/>
              </p:nvCxnSpPr>
              <p:spPr>
                <a:xfrm>
                  <a:off x="6855024" y="2778092"/>
                  <a:ext cx="14344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0" name="Straight Connector 129"/>
                <p:cNvCxnSpPr/>
                <p:nvPr/>
              </p:nvCxnSpPr>
              <p:spPr>
                <a:xfrm>
                  <a:off x="6860672" y="2155802"/>
                  <a:ext cx="14344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23" name="Group 22"/>
          <p:cNvGrpSpPr/>
          <p:nvPr/>
        </p:nvGrpSpPr>
        <p:grpSpPr>
          <a:xfrm>
            <a:off x="6157305" y="3607942"/>
            <a:ext cx="2456819" cy="3021084"/>
            <a:chOff x="6206709" y="3716722"/>
            <a:chExt cx="2456819" cy="3021084"/>
          </a:xfrm>
        </p:grpSpPr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6"/>
            <a:srcRect b="10073"/>
            <a:stretch/>
          </p:blipFill>
          <p:spPr>
            <a:xfrm>
              <a:off x="6780609" y="4566695"/>
              <a:ext cx="1588828" cy="2108426"/>
            </a:xfrm>
            <a:prstGeom prst="rect">
              <a:avLst/>
            </a:prstGeom>
          </p:spPr>
        </p:pic>
        <p:grpSp>
          <p:nvGrpSpPr>
            <p:cNvPr id="62" name="Group 61"/>
            <p:cNvGrpSpPr/>
            <p:nvPr/>
          </p:nvGrpSpPr>
          <p:grpSpPr>
            <a:xfrm>
              <a:off x="6799698" y="3716722"/>
              <a:ext cx="1863830" cy="2581885"/>
              <a:chOff x="6675197" y="3598268"/>
              <a:chExt cx="1859418" cy="2807253"/>
            </a:xfrm>
          </p:grpSpPr>
          <p:grpSp>
            <p:nvGrpSpPr>
              <p:cNvPr id="29" name="Group 28"/>
              <p:cNvGrpSpPr/>
              <p:nvPr/>
            </p:nvGrpSpPr>
            <p:grpSpPr>
              <a:xfrm>
                <a:off x="7019723" y="3598268"/>
                <a:ext cx="1514892" cy="2756989"/>
                <a:chOff x="6614652" y="3322450"/>
                <a:chExt cx="1514892" cy="2756992"/>
              </a:xfrm>
            </p:grpSpPr>
            <p:sp>
              <p:nvSpPr>
                <p:cNvPr id="8" name="TextBox 7"/>
                <p:cNvSpPr txBox="1"/>
                <p:nvPr/>
              </p:nvSpPr>
              <p:spPr>
                <a:xfrm>
                  <a:off x="6614652" y="3322450"/>
                  <a:ext cx="926261" cy="40157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IMP-2</a:t>
                  </a:r>
                  <a:endParaRPr lang="en-IN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7534318" y="5794996"/>
                  <a:ext cx="595226" cy="2844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2 </a:t>
                  </a:r>
                  <a:r>
                    <a:rPr lang="en-US" sz="11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sz="1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5" name="Rectangle 34"/>
              <p:cNvSpPr/>
              <p:nvPr/>
            </p:nvSpPr>
            <p:spPr>
              <a:xfrm>
                <a:off x="6675197" y="6033393"/>
                <a:ext cx="1132705" cy="37212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41" name="Group 40"/>
              <p:cNvGrpSpPr/>
              <p:nvPr/>
            </p:nvGrpSpPr>
            <p:grpSpPr>
              <a:xfrm>
                <a:off x="6789478" y="4185816"/>
                <a:ext cx="1562255" cy="388054"/>
                <a:chOff x="2889990" y="4084322"/>
                <a:chExt cx="1562255" cy="388055"/>
              </a:xfrm>
            </p:grpSpPr>
            <p:sp>
              <p:nvSpPr>
                <p:cNvPr id="42" name="TextBox 41"/>
                <p:cNvSpPr txBox="1"/>
                <p:nvPr/>
              </p:nvSpPr>
              <p:spPr>
                <a:xfrm rot="19018214">
                  <a:off x="3197632" y="4084322"/>
                  <a:ext cx="895877" cy="26771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 </a:t>
                  </a:r>
                  <a:r>
                    <a:rPr lang="en-US" sz="10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M</a:t>
                  </a:r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MSG</a:t>
                  </a:r>
                  <a:endPara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 rot="19018214">
                  <a:off x="2889990" y="4204663"/>
                  <a:ext cx="611218" cy="26771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trol</a:t>
                  </a:r>
                  <a:endPara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" name="TextBox 43"/>
                <p:cNvSpPr txBox="1"/>
                <p:nvPr/>
              </p:nvSpPr>
              <p:spPr>
                <a:xfrm rot="19018214">
                  <a:off x="3556368" y="4106254"/>
                  <a:ext cx="895877" cy="26771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 </a:t>
                  </a:r>
                  <a:r>
                    <a:rPr lang="en-US" sz="10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M</a:t>
                  </a:r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MSG</a:t>
                  </a:r>
                  <a:endPara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132" name="TextBox 18"/>
            <p:cNvSpPr txBox="1">
              <a:spLocks noChangeArrowheads="1"/>
            </p:cNvSpPr>
            <p:nvPr/>
          </p:nvSpPr>
          <p:spPr bwMode="auto">
            <a:xfrm>
              <a:off x="6206709" y="4798814"/>
              <a:ext cx="459302" cy="19389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4" name="Straight Connector 133"/>
            <p:cNvCxnSpPr/>
            <p:nvPr/>
          </p:nvCxnSpPr>
          <p:spPr>
            <a:xfrm>
              <a:off x="6607977" y="5223681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/>
            <p:cNvCxnSpPr/>
            <p:nvPr/>
          </p:nvCxnSpPr>
          <p:spPr>
            <a:xfrm>
              <a:off x="6614250" y="4968417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/>
            <p:cNvCxnSpPr/>
            <p:nvPr/>
          </p:nvCxnSpPr>
          <p:spPr>
            <a:xfrm>
              <a:off x="6607977" y="5093781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Connector 136"/>
            <p:cNvCxnSpPr/>
            <p:nvPr/>
          </p:nvCxnSpPr>
          <p:spPr>
            <a:xfrm>
              <a:off x="6607977" y="5534761"/>
              <a:ext cx="14344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Connector 137"/>
            <p:cNvCxnSpPr/>
            <p:nvPr/>
          </p:nvCxnSpPr>
          <p:spPr>
            <a:xfrm>
              <a:off x="6613624" y="4884396"/>
              <a:ext cx="14344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/>
            <p:cNvCxnSpPr/>
            <p:nvPr/>
          </p:nvCxnSpPr>
          <p:spPr>
            <a:xfrm>
              <a:off x="6613625" y="6065543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/>
            <p:cNvCxnSpPr/>
            <p:nvPr/>
          </p:nvCxnSpPr>
          <p:spPr>
            <a:xfrm>
              <a:off x="6607977" y="6335813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Connector 140"/>
            <p:cNvCxnSpPr/>
            <p:nvPr/>
          </p:nvCxnSpPr>
          <p:spPr>
            <a:xfrm>
              <a:off x="6613625" y="5713523"/>
              <a:ext cx="1434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8" name="TextBox 67"/>
          <p:cNvSpPr txBox="1"/>
          <p:nvPr/>
        </p:nvSpPr>
        <p:spPr>
          <a:xfrm>
            <a:off x="3175601" y="6470091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5" name="Group 24"/>
          <p:cNvGrpSpPr/>
          <p:nvPr/>
        </p:nvGrpSpPr>
        <p:grpSpPr>
          <a:xfrm>
            <a:off x="8443439" y="107068"/>
            <a:ext cx="2599234" cy="3383098"/>
            <a:chOff x="8543957" y="352282"/>
            <a:chExt cx="2599234" cy="3383098"/>
          </a:xfrm>
        </p:grpSpPr>
        <p:grpSp>
          <p:nvGrpSpPr>
            <p:cNvPr id="61" name="Group 60"/>
            <p:cNvGrpSpPr/>
            <p:nvPr/>
          </p:nvGrpSpPr>
          <p:grpSpPr>
            <a:xfrm>
              <a:off x="8800916" y="352282"/>
              <a:ext cx="2342275" cy="3344094"/>
              <a:chOff x="9117338" y="732377"/>
              <a:chExt cx="2342275" cy="3344094"/>
            </a:xfrm>
          </p:grpSpPr>
          <p:grpSp>
            <p:nvGrpSpPr>
              <p:cNvPr id="30" name="Group 29"/>
              <p:cNvGrpSpPr/>
              <p:nvPr/>
            </p:nvGrpSpPr>
            <p:grpSpPr>
              <a:xfrm>
                <a:off x="9117338" y="732377"/>
                <a:ext cx="2342275" cy="3344094"/>
                <a:chOff x="8712267" y="414471"/>
                <a:chExt cx="2342275" cy="3344094"/>
              </a:xfrm>
            </p:grpSpPr>
            <p:sp>
              <p:nvSpPr>
                <p:cNvPr id="11" name="TextBox 10"/>
                <p:cNvSpPr txBox="1"/>
                <p:nvPr/>
              </p:nvSpPr>
              <p:spPr>
                <a:xfrm>
                  <a:off x="9430087" y="414471"/>
                  <a:ext cx="97975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  <a:endParaRPr lang="en-IN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12" name="Picture 11"/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724" t="18470" r="49091" b="10869"/>
                <a:stretch/>
              </p:blipFill>
              <p:spPr>
                <a:xfrm>
                  <a:off x="8712267" y="1258307"/>
                  <a:ext cx="1739369" cy="2500258"/>
                </a:xfrm>
                <a:prstGeom prst="rect">
                  <a:avLst/>
                </a:prstGeom>
              </p:spPr>
            </p:pic>
            <p:sp>
              <p:nvSpPr>
                <p:cNvPr id="17" name="TextBox 16"/>
                <p:cNvSpPr txBox="1"/>
                <p:nvPr/>
              </p:nvSpPr>
              <p:spPr>
                <a:xfrm>
                  <a:off x="10457904" y="2341081"/>
                  <a:ext cx="59663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7 </a:t>
                  </a:r>
                  <a:r>
                    <a:rPr lang="en-US" sz="11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sz="1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3" name="Rectangle 32"/>
              <p:cNvSpPr/>
              <p:nvPr/>
            </p:nvSpPr>
            <p:spPr>
              <a:xfrm>
                <a:off x="9571602" y="2668644"/>
                <a:ext cx="1132705" cy="37212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45" name="Group 44"/>
              <p:cNvGrpSpPr/>
              <p:nvPr/>
            </p:nvGrpSpPr>
            <p:grpSpPr>
              <a:xfrm>
                <a:off x="9797020" y="1517103"/>
                <a:ext cx="1564043" cy="366562"/>
                <a:chOff x="3533165" y="4161446"/>
                <a:chExt cx="1564043" cy="366562"/>
              </a:xfrm>
            </p:grpSpPr>
            <p:sp>
              <p:nvSpPr>
                <p:cNvPr id="46" name="TextBox 45"/>
                <p:cNvSpPr txBox="1"/>
                <p:nvPr/>
              </p:nvSpPr>
              <p:spPr>
                <a:xfrm rot="19018214">
                  <a:off x="3840469" y="4161446"/>
                  <a:ext cx="89800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 </a:t>
                  </a:r>
                  <a:r>
                    <a:rPr lang="en-US" sz="10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M</a:t>
                  </a:r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MSG</a:t>
                  </a:r>
                  <a:endPara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 rot="19018214">
                  <a:off x="3533165" y="4281787"/>
                  <a:ext cx="61266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trol</a:t>
                  </a:r>
                  <a:endPara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 rot="19018214">
                  <a:off x="4199205" y="4183378"/>
                  <a:ext cx="89800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 </a:t>
                  </a:r>
                  <a:r>
                    <a:rPr lang="en-US" sz="10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M</a:t>
                  </a:r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MSG</a:t>
                  </a:r>
                  <a:endPara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9" name="Group 18"/>
            <p:cNvGrpSpPr/>
            <p:nvPr/>
          </p:nvGrpSpPr>
          <p:grpSpPr>
            <a:xfrm>
              <a:off x="8940056" y="1613284"/>
              <a:ext cx="187408" cy="1692301"/>
              <a:chOff x="8940056" y="1613284"/>
              <a:chExt cx="187408" cy="1692301"/>
            </a:xfrm>
          </p:grpSpPr>
          <p:cxnSp>
            <p:nvCxnSpPr>
              <p:cNvPr id="97" name="Straight Connector 96"/>
              <p:cNvCxnSpPr/>
              <p:nvPr/>
            </p:nvCxnSpPr>
            <p:spPr>
              <a:xfrm>
                <a:off x="8958257" y="1986427"/>
                <a:ext cx="1692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Straight Connector 97"/>
              <p:cNvCxnSpPr/>
              <p:nvPr/>
            </p:nvCxnSpPr>
            <p:spPr>
              <a:xfrm>
                <a:off x="8957272" y="1834393"/>
                <a:ext cx="1692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98"/>
              <p:cNvCxnSpPr/>
              <p:nvPr/>
            </p:nvCxnSpPr>
            <p:spPr>
              <a:xfrm>
                <a:off x="8958160" y="1725614"/>
                <a:ext cx="1692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Straight Connector 99"/>
              <p:cNvCxnSpPr/>
              <p:nvPr/>
            </p:nvCxnSpPr>
            <p:spPr>
              <a:xfrm>
                <a:off x="8950215" y="1613284"/>
                <a:ext cx="1692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Straight Connector 100"/>
              <p:cNvCxnSpPr/>
              <p:nvPr/>
            </p:nvCxnSpPr>
            <p:spPr>
              <a:xfrm>
                <a:off x="8950216" y="2231857"/>
                <a:ext cx="1692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Straight Connector 101"/>
              <p:cNvCxnSpPr/>
              <p:nvPr/>
            </p:nvCxnSpPr>
            <p:spPr>
              <a:xfrm>
                <a:off x="8951498" y="2497250"/>
                <a:ext cx="1692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Straight Connector 102"/>
              <p:cNvCxnSpPr/>
              <p:nvPr/>
            </p:nvCxnSpPr>
            <p:spPr>
              <a:xfrm>
                <a:off x="8940056" y="3305585"/>
                <a:ext cx="1692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4" name="TextBox 18"/>
            <p:cNvSpPr txBox="1">
              <a:spLocks noChangeArrowheads="1"/>
            </p:cNvSpPr>
            <p:nvPr/>
          </p:nvSpPr>
          <p:spPr bwMode="auto">
            <a:xfrm>
              <a:off x="8543957" y="1427056"/>
              <a:ext cx="565306" cy="23083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0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4" name="TextBox 63"/>
          <p:cNvSpPr txBox="1"/>
          <p:nvPr/>
        </p:nvSpPr>
        <p:spPr>
          <a:xfrm>
            <a:off x="9570082" y="3307170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27995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2765992" y="1569056"/>
            <a:ext cx="5491062" cy="3639427"/>
            <a:chOff x="289122" y="983129"/>
            <a:chExt cx="5491062" cy="3639427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377" t="33189" r="25216" b="20732"/>
            <a:stretch/>
          </p:blipFill>
          <p:spPr>
            <a:xfrm>
              <a:off x="905522" y="1289742"/>
              <a:ext cx="4570472" cy="3332814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5167516" y="2229221"/>
              <a:ext cx="6126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2 </a:t>
              </a:r>
              <a:r>
                <a:rPr lang="en-US" sz="11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67515" y="2657222"/>
              <a:ext cx="6126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2 </a:t>
              </a:r>
              <a:r>
                <a:rPr lang="en-US" sz="11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89122" y="2229221"/>
              <a:ext cx="6078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P9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89122" y="2657222"/>
              <a:ext cx="6078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P2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 rot="19018214">
              <a:off x="4048118" y="983129"/>
              <a:ext cx="8980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SG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9018214">
              <a:off x="3652036" y="1103470"/>
              <a:ext cx="6126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9018214">
              <a:off x="4513392" y="1005061"/>
              <a:ext cx="8980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SG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9018214">
              <a:off x="2045576" y="983130"/>
              <a:ext cx="8980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SG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9018214">
              <a:off x="1649494" y="1103471"/>
              <a:ext cx="6126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9018214">
              <a:off x="2510850" y="1005062"/>
              <a:ext cx="8980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SG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2885243" y="2157274"/>
              <a:ext cx="2059619" cy="941033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460229" y="342118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57889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55650" y="4380440"/>
            <a:ext cx="2971800" cy="2371725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307074" y="97128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Rectangle 98"/>
          <p:cNvSpPr/>
          <p:nvPr/>
        </p:nvSpPr>
        <p:spPr>
          <a:xfrm>
            <a:off x="8034147" y="6058726"/>
            <a:ext cx="2552859" cy="3831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8" name="Group 27"/>
          <p:cNvGrpSpPr/>
          <p:nvPr/>
        </p:nvGrpSpPr>
        <p:grpSpPr>
          <a:xfrm>
            <a:off x="8327243" y="451546"/>
            <a:ext cx="3827499" cy="3076067"/>
            <a:chOff x="9480202" y="1813156"/>
            <a:chExt cx="3827499" cy="3076067"/>
          </a:xfrm>
        </p:grpSpPr>
        <p:grpSp>
          <p:nvGrpSpPr>
            <p:cNvPr id="119" name="Group 118"/>
            <p:cNvGrpSpPr/>
            <p:nvPr/>
          </p:nvGrpSpPr>
          <p:grpSpPr>
            <a:xfrm>
              <a:off x="9480202" y="1813156"/>
              <a:ext cx="3827499" cy="3076067"/>
              <a:chOff x="8329819" y="408422"/>
              <a:chExt cx="3827499" cy="3076067"/>
            </a:xfrm>
          </p:grpSpPr>
          <p:grpSp>
            <p:nvGrpSpPr>
              <p:cNvPr id="120" name="Group 119"/>
              <p:cNvGrpSpPr/>
              <p:nvPr/>
            </p:nvGrpSpPr>
            <p:grpSpPr>
              <a:xfrm>
                <a:off x="8329819" y="408422"/>
                <a:ext cx="3827499" cy="3076067"/>
                <a:chOff x="8167259" y="408422"/>
                <a:chExt cx="3827499" cy="3076067"/>
              </a:xfrm>
            </p:grpSpPr>
            <p:grpSp>
              <p:nvGrpSpPr>
                <p:cNvPr id="127" name="Group 126"/>
                <p:cNvGrpSpPr/>
                <p:nvPr/>
              </p:nvGrpSpPr>
              <p:grpSpPr>
                <a:xfrm>
                  <a:off x="8174724" y="408422"/>
                  <a:ext cx="3820034" cy="2931211"/>
                  <a:chOff x="8380990" y="684923"/>
                  <a:chExt cx="3820034" cy="2931211"/>
                </a:xfrm>
              </p:grpSpPr>
              <p:grpSp>
                <p:nvGrpSpPr>
                  <p:cNvPr id="129" name="Group 128"/>
                  <p:cNvGrpSpPr/>
                  <p:nvPr/>
                </p:nvGrpSpPr>
                <p:grpSpPr>
                  <a:xfrm>
                    <a:off x="8380990" y="684923"/>
                    <a:ext cx="3820034" cy="2931211"/>
                    <a:chOff x="8333578" y="757840"/>
                    <a:chExt cx="3820034" cy="2931211"/>
                  </a:xfrm>
                </p:grpSpPr>
                <p:pic>
                  <p:nvPicPr>
                    <p:cNvPr id="139" name="Picture 138"/>
                    <p:cNvPicPr>
                      <a:picLocks noChangeAspect="1"/>
                    </p:cNvPicPr>
                    <p:nvPr/>
                  </p:nvPicPr>
                  <p:blipFill rotWithShape="1">
                    <a:blip r:embed="rId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0550" r="15425" b="34680"/>
                    <a:stretch/>
                  </p:blipFill>
                  <p:spPr>
                    <a:xfrm rot="21418405">
                      <a:off x="8333578" y="1491827"/>
                      <a:ext cx="3724550" cy="2197224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40" name="TextBox 139"/>
                    <p:cNvSpPr txBox="1"/>
                    <p:nvPr/>
                  </p:nvSpPr>
                  <p:spPr>
                    <a:xfrm>
                      <a:off x="9957171" y="757840"/>
                      <a:ext cx="979755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n-IN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41" name="TextBox 140"/>
                    <p:cNvSpPr txBox="1"/>
                    <p:nvPr/>
                  </p:nvSpPr>
                  <p:spPr>
                    <a:xfrm>
                      <a:off x="11556974" y="2460384"/>
                      <a:ext cx="596638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 </a:t>
                      </a:r>
                      <a:r>
                        <a:rPr lang="en-US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Da</a:t>
                      </a:r>
                      <a:endParaRPr lang="en-IN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130" name="Group 129"/>
                  <p:cNvGrpSpPr/>
                  <p:nvPr/>
                </p:nvGrpSpPr>
                <p:grpSpPr>
                  <a:xfrm>
                    <a:off x="9019766" y="1345748"/>
                    <a:ext cx="2971596" cy="308530"/>
                    <a:chOff x="871931" y="1056382"/>
                    <a:chExt cx="2971596" cy="308530"/>
                  </a:xfrm>
                </p:grpSpPr>
                <p:sp>
                  <p:nvSpPr>
                    <p:cNvPr id="131" name="TextBox 130"/>
                    <p:cNvSpPr txBox="1"/>
                    <p:nvPr/>
                  </p:nvSpPr>
                  <p:spPr>
                    <a:xfrm rot="19018214">
                      <a:off x="871931" y="1149468"/>
                      <a:ext cx="52610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</a:t>
                      </a:r>
                      <a:endParaRPr lang="en-I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2" name="TextBox 131"/>
                    <p:cNvSpPr txBox="1"/>
                    <p:nvPr/>
                  </p:nvSpPr>
                  <p:spPr>
                    <a:xfrm rot="19018214">
                      <a:off x="1516833" y="1107383"/>
                      <a:ext cx="52610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</a:t>
                      </a:r>
                      <a:endParaRPr lang="en-I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3" name="TextBox 132"/>
                    <p:cNvSpPr txBox="1"/>
                    <p:nvPr/>
                  </p:nvSpPr>
                  <p:spPr>
                    <a:xfrm rot="19018214">
                      <a:off x="2164713" y="1089804"/>
                      <a:ext cx="52610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</a:t>
                      </a:r>
                      <a:endParaRPr lang="en-I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4" name="TextBox 133"/>
                    <p:cNvSpPr txBox="1"/>
                    <p:nvPr/>
                  </p:nvSpPr>
                  <p:spPr>
                    <a:xfrm rot="19018214">
                      <a:off x="2762048" y="1108954"/>
                      <a:ext cx="52610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</a:t>
                      </a:r>
                      <a:endParaRPr lang="en-I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5" name="TextBox 134"/>
                    <p:cNvSpPr txBox="1"/>
                    <p:nvPr/>
                  </p:nvSpPr>
                  <p:spPr>
                    <a:xfrm rot="19018214">
                      <a:off x="1785102" y="1056382"/>
                      <a:ext cx="75373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 </a:t>
                      </a:r>
                      <a:r>
                        <a:rPr lang="en-US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SG</a:t>
                      </a:r>
                      <a:endParaRPr lang="en-I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6" name="TextBox 135"/>
                    <p:cNvSpPr txBox="1"/>
                    <p:nvPr/>
                  </p:nvSpPr>
                  <p:spPr>
                    <a:xfrm rot="19018214">
                      <a:off x="2391803" y="1056383"/>
                      <a:ext cx="75373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 </a:t>
                      </a:r>
                      <a:r>
                        <a:rPr lang="en-US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SG</a:t>
                      </a:r>
                      <a:endParaRPr lang="en-I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7" name="TextBox 136"/>
                    <p:cNvSpPr txBox="1"/>
                    <p:nvPr/>
                  </p:nvSpPr>
                  <p:spPr>
                    <a:xfrm rot="19018214">
                      <a:off x="3089795" y="1062904"/>
                      <a:ext cx="75373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 </a:t>
                      </a:r>
                      <a:r>
                        <a:rPr lang="en-US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SG</a:t>
                      </a:r>
                      <a:endParaRPr lang="en-I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8" name="TextBox 137"/>
                    <p:cNvSpPr txBox="1"/>
                    <p:nvPr/>
                  </p:nvSpPr>
                  <p:spPr>
                    <a:xfrm rot="19018214">
                      <a:off x="1161563" y="1080918"/>
                      <a:ext cx="75373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 </a:t>
                      </a:r>
                      <a:r>
                        <a:rPr lang="en-US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SG</a:t>
                      </a:r>
                      <a:endParaRPr lang="en-I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  <p:sp>
              <p:nvSpPr>
                <p:cNvPr id="128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8167259" y="1360831"/>
                  <a:ext cx="565306" cy="21236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IN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 </a:t>
                  </a:r>
                  <a:r>
                    <a:rPr lang="en-IN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IN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 </a:t>
                  </a:r>
                  <a:r>
                    <a:rPr lang="en-IN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IN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 </a:t>
                  </a:r>
                  <a:r>
                    <a:rPr lang="en-IN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US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7 </a:t>
                  </a:r>
                  <a:r>
                    <a:rPr lang="en-US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US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r>
                    <a:rPr lang="en-US" alt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  <a:r>
                    <a:rPr lang="en-US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US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21" name="Group 120"/>
              <p:cNvGrpSpPr/>
              <p:nvPr/>
            </p:nvGrpSpPr>
            <p:grpSpPr>
              <a:xfrm>
                <a:off x="8696529" y="1561975"/>
                <a:ext cx="187408" cy="1511832"/>
                <a:chOff x="8940056" y="1834393"/>
                <a:chExt cx="187408" cy="1511832"/>
              </a:xfrm>
            </p:grpSpPr>
            <p:cxnSp>
              <p:nvCxnSpPr>
                <p:cNvPr id="122" name="Straight Connector 121"/>
                <p:cNvCxnSpPr/>
                <p:nvPr/>
              </p:nvCxnSpPr>
              <p:spPr>
                <a:xfrm>
                  <a:off x="8958257" y="1986427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3" name="Straight Connector 122"/>
                <p:cNvCxnSpPr/>
                <p:nvPr/>
              </p:nvCxnSpPr>
              <p:spPr>
                <a:xfrm>
                  <a:off x="8957272" y="1834393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4" name="Straight Connector 123"/>
                <p:cNvCxnSpPr/>
                <p:nvPr/>
              </p:nvCxnSpPr>
              <p:spPr>
                <a:xfrm>
                  <a:off x="8950216" y="2252177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5" name="Straight Connector 124"/>
                <p:cNvCxnSpPr/>
                <p:nvPr/>
              </p:nvCxnSpPr>
              <p:spPr>
                <a:xfrm>
                  <a:off x="8951498" y="2548050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" name="Straight Connector 125"/>
                <p:cNvCxnSpPr/>
                <p:nvPr/>
              </p:nvCxnSpPr>
              <p:spPr>
                <a:xfrm>
                  <a:off x="8940056" y="3346225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01" name="Rectangle 100"/>
            <p:cNvSpPr/>
            <p:nvPr/>
          </p:nvSpPr>
          <p:spPr>
            <a:xfrm>
              <a:off x="10115761" y="3480609"/>
              <a:ext cx="2655559" cy="37212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7" name="Group 46"/>
          <p:cNvGrpSpPr/>
          <p:nvPr/>
        </p:nvGrpSpPr>
        <p:grpSpPr>
          <a:xfrm>
            <a:off x="393668" y="488726"/>
            <a:ext cx="3661782" cy="3275576"/>
            <a:chOff x="393668" y="488726"/>
            <a:chExt cx="3661782" cy="3275576"/>
          </a:xfrm>
        </p:grpSpPr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07186" y="868451"/>
              <a:ext cx="3048264" cy="2895851"/>
            </a:xfrm>
            <a:prstGeom prst="rect">
              <a:avLst/>
            </a:prstGeom>
          </p:spPr>
        </p:pic>
        <p:grpSp>
          <p:nvGrpSpPr>
            <p:cNvPr id="41" name="Group 40"/>
            <p:cNvGrpSpPr/>
            <p:nvPr/>
          </p:nvGrpSpPr>
          <p:grpSpPr>
            <a:xfrm>
              <a:off x="973038" y="488726"/>
              <a:ext cx="3006564" cy="1637576"/>
              <a:chOff x="2669362" y="624304"/>
              <a:chExt cx="3006564" cy="1664020"/>
            </a:xfrm>
          </p:grpSpPr>
          <p:grpSp>
            <p:nvGrpSpPr>
              <p:cNvPr id="96" name="Group 95"/>
              <p:cNvGrpSpPr/>
              <p:nvPr/>
            </p:nvGrpSpPr>
            <p:grpSpPr>
              <a:xfrm>
                <a:off x="2691595" y="624304"/>
                <a:ext cx="2984331" cy="1619970"/>
                <a:chOff x="871931" y="593040"/>
                <a:chExt cx="2984331" cy="1619970"/>
              </a:xfrm>
            </p:grpSpPr>
            <p:grpSp>
              <p:nvGrpSpPr>
                <p:cNvPr id="2" name="Group 1"/>
                <p:cNvGrpSpPr/>
                <p:nvPr/>
              </p:nvGrpSpPr>
              <p:grpSpPr>
                <a:xfrm>
                  <a:off x="1511360" y="593040"/>
                  <a:ext cx="2344902" cy="1619970"/>
                  <a:chOff x="5793703" y="588734"/>
                  <a:chExt cx="2344902" cy="1619970"/>
                </a:xfrm>
              </p:grpSpPr>
              <p:sp>
                <p:nvSpPr>
                  <p:cNvPr id="10" name="TextBox 9"/>
                  <p:cNvSpPr txBox="1"/>
                  <p:nvPr/>
                </p:nvSpPr>
                <p:spPr>
                  <a:xfrm>
                    <a:off x="5793703" y="588734"/>
                    <a:ext cx="915635" cy="37529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MP-9</a:t>
                    </a:r>
                    <a:endParaRPr lang="en-IN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" name="TextBox 15"/>
                  <p:cNvSpPr txBox="1"/>
                  <p:nvPr/>
                </p:nvSpPr>
                <p:spPr>
                  <a:xfrm>
                    <a:off x="7541967" y="1942869"/>
                    <a:ext cx="596638" cy="26583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92 </a:t>
                    </a:r>
                    <a:r>
                      <a:rPr lang="en-US" sz="11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en-IN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37" name="Group 36"/>
                <p:cNvGrpSpPr/>
                <p:nvPr/>
              </p:nvGrpSpPr>
              <p:grpSpPr>
                <a:xfrm>
                  <a:off x="871931" y="1054641"/>
                  <a:ext cx="2823488" cy="312011"/>
                  <a:chOff x="871931" y="1054641"/>
                  <a:chExt cx="2823488" cy="312011"/>
                </a:xfrm>
              </p:grpSpPr>
              <p:sp>
                <p:nvSpPr>
                  <p:cNvPr id="29" name="TextBox 28"/>
                  <p:cNvSpPr txBox="1"/>
                  <p:nvPr/>
                </p:nvSpPr>
                <p:spPr>
                  <a:xfrm rot="19018214">
                    <a:off x="871931" y="1147729"/>
                    <a:ext cx="526106" cy="218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trol</a:t>
                    </a:r>
                    <a:endParaRPr lang="en-I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0" name="TextBox 29"/>
                  <p:cNvSpPr txBox="1"/>
                  <p:nvPr/>
                </p:nvSpPr>
                <p:spPr>
                  <a:xfrm rot="19018214">
                    <a:off x="1505085" y="1111826"/>
                    <a:ext cx="526106" cy="218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trol</a:t>
                    </a:r>
                    <a:endParaRPr lang="en-I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1" name="TextBox 30"/>
                  <p:cNvSpPr txBox="1"/>
                  <p:nvPr/>
                </p:nvSpPr>
                <p:spPr>
                  <a:xfrm rot="19018214">
                    <a:off x="2136559" y="1088064"/>
                    <a:ext cx="526106" cy="218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trol</a:t>
                    </a:r>
                    <a:endParaRPr lang="en-I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2" name="TextBox 31"/>
                  <p:cNvSpPr txBox="1"/>
                  <p:nvPr/>
                </p:nvSpPr>
                <p:spPr>
                  <a:xfrm rot="19018214">
                    <a:off x="2694408" y="1135874"/>
                    <a:ext cx="526106" cy="218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trol</a:t>
                    </a:r>
                    <a:endParaRPr lang="en-I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3" name="TextBox 32"/>
                  <p:cNvSpPr txBox="1"/>
                  <p:nvPr/>
                </p:nvSpPr>
                <p:spPr>
                  <a:xfrm rot="19018214">
                    <a:off x="1740269" y="1054641"/>
                    <a:ext cx="753732" cy="218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 </a:t>
                    </a:r>
                    <a:r>
                      <a:rPr lang="en-US" sz="8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M</a:t>
                    </a:r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MSG</a:t>
                    </a:r>
                    <a:endParaRPr lang="en-I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4" name="TextBox 33"/>
                  <p:cNvSpPr txBox="1"/>
                  <p:nvPr/>
                </p:nvSpPr>
                <p:spPr>
                  <a:xfrm rot="19018214">
                    <a:off x="2362113" y="1054642"/>
                    <a:ext cx="753732" cy="218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 </a:t>
                    </a:r>
                    <a:r>
                      <a:rPr lang="en-US" sz="8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M</a:t>
                    </a:r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MSG</a:t>
                    </a:r>
                    <a:endParaRPr lang="en-I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5" name="TextBox 34"/>
                  <p:cNvSpPr txBox="1"/>
                  <p:nvPr/>
                </p:nvSpPr>
                <p:spPr>
                  <a:xfrm rot="19018214">
                    <a:off x="2941687" y="1080858"/>
                    <a:ext cx="753732" cy="218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 </a:t>
                    </a:r>
                    <a:r>
                      <a:rPr lang="en-US" sz="8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M</a:t>
                    </a:r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MSG</a:t>
                    </a:r>
                    <a:endParaRPr lang="en-I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6" name="TextBox 35"/>
                  <p:cNvSpPr txBox="1"/>
                  <p:nvPr/>
                </p:nvSpPr>
                <p:spPr>
                  <a:xfrm rot="19018214">
                    <a:off x="1115735" y="1096037"/>
                    <a:ext cx="753732" cy="218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 </a:t>
                    </a:r>
                    <a:r>
                      <a:rPr lang="en-US" sz="8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M</a:t>
                    </a:r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MSG</a:t>
                    </a:r>
                    <a:endParaRPr lang="en-I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97" name="Rectangle 96"/>
              <p:cNvSpPr/>
              <p:nvPr/>
            </p:nvSpPr>
            <p:spPr>
              <a:xfrm>
                <a:off x="2669362" y="1905202"/>
                <a:ext cx="2449902" cy="38312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44" name="Group 143"/>
            <p:cNvGrpSpPr/>
            <p:nvPr/>
          </p:nvGrpSpPr>
          <p:grpSpPr>
            <a:xfrm>
              <a:off x="393668" y="1505188"/>
              <a:ext cx="565306" cy="1866119"/>
              <a:chOff x="4463792" y="1518153"/>
              <a:chExt cx="565306" cy="1866119"/>
            </a:xfrm>
          </p:grpSpPr>
          <p:grpSp>
            <p:nvGrpSpPr>
              <p:cNvPr id="145" name="Group 144"/>
              <p:cNvGrpSpPr/>
              <p:nvPr/>
            </p:nvGrpSpPr>
            <p:grpSpPr>
              <a:xfrm>
                <a:off x="4463792" y="1618149"/>
                <a:ext cx="565306" cy="1766123"/>
                <a:chOff x="5133355" y="3712733"/>
                <a:chExt cx="565306" cy="1766123"/>
              </a:xfrm>
            </p:grpSpPr>
            <p:sp>
              <p:nvSpPr>
                <p:cNvPr id="148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5133355" y="3816863"/>
                  <a:ext cx="565306" cy="16619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IN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 </a:t>
                  </a:r>
                  <a:r>
                    <a:rPr lang="en-IN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IN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 </a:t>
                  </a:r>
                  <a:r>
                    <a:rPr lang="en-IN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IN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 </a:t>
                  </a:r>
                  <a:r>
                    <a:rPr lang="en-IN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US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7 </a:t>
                  </a:r>
                  <a:r>
                    <a:rPr lang="en-US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US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 </a:t>
                  </a:r>
                  <a:r>
                    <a:rPr lang="en-US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49" name="Straight Connector 148"/>
                <p:cNvCxnSpPr/>
                <p:nvPr/>
              </p:nvCxnSpPr>
              <p:spPr>
                <a:xfrm>
                  <a:off x="5518266" y="4170041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0" name="Straight Connector 149"/>
                <p:cNvCxnSpPr/>
                <p:nvPr/>
              </p:nvCxnSpPr>
              <p:spPr>
                <a:xfrm>
                  <a:off x="5517281" y="4018007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1" name="Straight Connector 150"/>
                <p:cNvCxnSpPr/>
                <p:nvPr/>
              </p:nvCxnSpPr>
              <p:spPr>
                <a:xfrm>
                  <a:off x="5510225" y="4435791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2" name="Straight Connector 151"/>
                <p:cNvCxnSpPr/>
                <p:nvPr/>
              </p:nvCxnSpPr>
              <p:spPr>
                <a:xfrm>
                  <a:off x="5511507" y="4731664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3" name="Straight Connector 152"/>
                <p:cNvCxnSpPr/>
                <p:nvPr/>
              </p:nvCxnSpPr>
              <p:spPr>
                <a:xfrm>
                  <a:off x="5496916" y="5085956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4" name="Straight Connector 153"/>
                <p:cNvCxnSpPr/>
                <p:nvPr/>
              </p:nvCxnSpPr>
              <p:spPr>
                <a:xfrm>
                  <a:off x="5510224" y="3816863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5" name="Straight Connector 154"/>
                <p:cNvCxnSpPr/>
                <p:nvPr/>
              </p:nvCxnSpPr>
              <p:spPr>
                <a:xfrm>
                  <a:off x="5496915" y="3712733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6" name="Rectangle 145"/>
              <p:cNvSpPr/>
              <p:nvPr/>
            </p:nvSpPr>
            <p:spPr>
              <a:xfrm>
                <a:off x="4465934" y="1624638"/>
                <a:ext cx="45717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 </a:t>
                </a:r>
                <a:r>
                  <a:rPr lang="en-IN" altLang="en-US" sz="6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7" name="Rectangle 146"/>
              <p:cNvSpPr/>
              <p:nvPr/>
            </p:nvSpPr>
            <p:spPr>
              <a:xfrm>
                <a:off x="4476083" y="1518153"/>
                <a:ext cx="45717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 </a:t>
                </a:r>
                <a:r>
                  <a:rPr lang="en-IN" altLang="en-US" sz="6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45" name="Group 44"/>
          <p:cNvGrpSpPr/>
          <p:nvPr/>
        </p:nvGrpSpPr>
        <p:grpSpPr>
          <a:xfrm>
            <a:off x="4447020" y="433409"/>
            <a:ext cx="3814610" cy="3172466"/>
            <a:chOff x="4447020" y="433409"/>
            <a:chExt cx="3814610" cy="3172466"/>
          </a:xfrm>
        </p:grpSpPr>
        <p:grpSp>
          <p:nvGrpSpPr>
            <p:cNvPr id="13" name="Group 12"/>
            <p:cNvGrpSpPr/>
            <p:nvPr/>
          </p:nvGrpSpPr>
          <p:grpSpPr>
            <a:xfrm>
              <a:off x="5015635" y="433409"/>
              <a:ext cx="3245995" cy="3172466"/>
              <a:chOff x="5015635" y="433409"/>
              <a:chExt cx="3245995" cy="3172466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015635" y="1088009"/>
                <a:ext cx="3066554" cy="2517866"/>
              </a:xfrm>
              <a:prstGeom prst="rect">
                <a:avLst/>
              </a:prstGeom>
            </p:spPr>
          </p:pic>
          <p:grpSp>
            <p:nvGrpSpPr>
              <p:cNvPr id="39" name="Group 38"/>
              <p:cNvGrpSpPr/>
              <p:nvPr/>
            </p:nvGrpSpPr>
            <p:grpSpPr>
              <a:xfrm>
                <a:off x="5026087" y="433409"/>
                <a:ext cx="3235543" cy="1890626"/>
                <a:chOff x="5027896" y="433409"/>
                <a:chExt cx="3233821" cy="1890626"/>
              </a:xfrm>
            </p:grpSpPr>
            <p:sp>
              <p:nvSpPr>
                <p:cNvPr id="7" name="TextBox 6"/>
                <p:cNvSpPr txBox="1"/>
                <p:nvPr/>
              </p:nvSpPr>
              <p:spPr>
                <a:xfrm>
                  <a:off x="6129953" y="433409"/>
                  <a:ext cx="91514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MP-2</a:t>
                  </a:r>
                  <a:endParaRPr lang="en-IN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8" name="Group 37"/>
                <p:cNvGrpSpPr/>
                <p:nvPr/>
              </p:nvGrpSpPr>
              <p:grpSpPr>
                <a:xfrm>
                  <a:off x="5027896" y="932334"/>
                  <a:ext cx="3233821" cy="1391701"/>
                  <a:chOff x="5077583" y="2753995"/>
                  <a:chExt cx="3233821" cy="1391701"/>
                </a:xfrm>
              </p:grpSpPr>
              <p:grpSp>
                <p:nvGrpSpPr>
                  <p:cNvPr id="92" name="Group 91"/>
                  <p:cNvGrpSpPr/>
                  <p:nvPr/>
                </p:nvGrpSpPr>
                <p:grpSpPr>
                  <a:xfrm>
                    <a:off x="5128881" y="2753995"/>
                    <a:ext cx="3182523" cy="1318902"/>
                    <a:chOff x="5137695" y="1731918"/>
                    <a:chExt cx="3244944" cy="1442888"/>
                  </a:xfrm>
                </p:grpSpPr>
                <p:sp>
                  <p:nvSpPr>
                    <p:cNvPr id="17" name="TextBox 16"/>
                    <p:cNvSpPr txBox="1"/>
                    <p:nvPr/>
                  </p:nvSpPr>
                  <p:spPr>
                    <a:xfrm>
                      <a:off x="7774623" y="2888603"/>
                      <a:ext cx="608016" cy="286203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 </a:t>
                      </a:r>
                      <a:r>
                        <a:rPr lang="en-US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Da</a:t>
                      </a:r>
                      <a:endParaRPr lang="en-IN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84" name="TextBox 83"/>
                    <p:cNvSpPr txBox="1"/>
                    <p:nvPr/>
                  </p:nvSpPr>
                  <p:spPr>
                    <a:xfrm rot="19018214">
                      <a:off x="5137695" y="1825004"/>
                      <a:ext cx="536139" cy="23569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</a:t>
                      </a:r>
                      <a:endParaRPr lang="en-I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85" name="TextBox 84"/>
                    <p:cNvSpPr txBox="1"/>
                    <p:nvPr/>
                  </p:nvSpPr>
                  <p:spPr>
                    <a:xfrm rot="19018214">
                      <a:off x="5782597" y="1782919"/>
                      <a:ext cx="536139" cy="23569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</a:t>
                      </a:r>
                      <a:endParaRPr lang="en-I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86" name="TextBox 85"/>
                    <p:cNvSpPr txBox="1"/>
                    <p:nvPr/>
                  </p:nvSpPr>
                  <p:spPr>
                    <a:xfrm rot="19018214">
                      <a:off x="6430477" y="1765340"/>
                      <a:ext cx="536139" cy="23569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</a:t>
                      </a:r>
                      <a:endParaRPr lang="en-I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87" name="TextBox 86"/>
                    <p:cNvSpPr txBox="1"/>
                    <p:nvPr/>
                  </p:nvSpPr>
                  <p:spPr>
                    <a:xfrm rot="19018214">
                      <a:off x="7027812" y="1784490"/>
                      <a:ext cx="536139" cy="23569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</a:t>
                      </a:r>
                      <a:endParaRPr lang="en-I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88" name="TextBox 87"/>
                    <p:cNvSpPr txBox="1"/>
                    <p:nvPr/>
                  </p:nvSpPr>
                  <p:spPr>
                    <a:xfrm rot="19018214">
                      <a:off x="6048697" y="1731918"/>
                      <a:ext cx="768106" cy="23569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 </a:t>
                      </a:r>
                      <a:r>
                        <a:rPr lang="en-US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SG</a:t>
                      </a:r>
                      <a:endParaRPr lang="en-I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89" name="TextBox 88"/>
                    <p:cNvSpPr txBox="1"/>
                    <p:nvPr/>
                  </p:nvSpPr>
                  <p:spPr>
                    <a:xfrm rot="19018214">
                      <a:off x="6655397" y="1731919"/>
                      <a:ext cx="768106" cy="23569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 </a:t>
                      </a:r>
                      <a:r>
                        <a:rPr lang="en-US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SG</a:t>
                      </a:r>
                      <a:endParaRPr lang="en-I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90" name="TextBox 89"/>
                    <p:cNvSpPr txBox="1"/>
                    <p:nvPr/>
                  </p:nvSpPr>
                  <p:spPr>
                    <a:xfrm rot="19018214">
                      <a:off x="7353390" y="1738439"/>
                      <a:ext cx="768106" cy="23569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 </a:t>
                      </a:r>
                      <a:r>
                        <a:rPr lang="en-US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SG</a:t>
                      </a:r>
                      <a:endParaRPr lang="en-I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91" name="TextBox 90"/>
                    <p:cNvSpPr txBox="1"/>
                    <p:nvPr/>
                  </p:nvSpPr>
                  <p:spPr>
                    <a:xfrm rot="19018214">
                      <a:off x="5425158" y="1756454"/>
                      <a:ext cx="768106" cy="23569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 </a:t>
                      </a:r>
                      <a:r>
                        <a:rPr lang="en-US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SG</a:t>
                      </a:r>
                      <a:endParaRPr lang="en-I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100" name="Rectangle 99"/>
                  <p:cNvSpPr/>
                  <p:nvPr/>
                </p:nvSpPr>
                <p:spPr>
                  <a:xfrm>
                    <a:off x="5077583" y="3833232"/>
                    <a:ext cx="2655559" cy="312464"/>
                  </a:xfrm>
                  <a:prstGeom prst="rect">
                    <a:avLst/>
                  </a:prstGeom>
                  <a:noFill/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</p:grpSp>
        <p:grpSp>
          <p:nvGrpSpPr>
            <p:cNvPr id="156" name="Group 155"/>
            <p:cNvGrpSpPr/>
            <p:nvPr/>
          </p:nvGrpSpPr>
          <p:grpSpPr>
            <a:xfrm>
              <a:off x="4447020" y="1505188"/>
              <a:ext cx="565306" cy="1866119"/>
              <a:chOff x="4463792" y="1518153"/>
              <a:chExt cx="565306" cy="1866119"/>
            </a:xfrm>
          </p:grpSpPr>
          <p:grpSp>
            <p:nvGrpSpPr>
              <p:cNvPr id="157" name="Group 156"/>
              <p:cNvGrpSpPr/>
              <p:nvPr/>
            </p:nvGrpSpPr>
            <p:grpSpPr>
              <a:xfrm>
                <a:off x="4463792" y="1618149"/>
                <a:ext cx="565306" cy="1766123"/>
                <a:chOff x="5133355" y="3712733"/>
                <a:chExt cx="565306" cy="1766123"/>
              </a:xfrm>
            </p:grpSpPr>
            <p:sp>
              <p:nvSpPr>
                <p:cNvPr id="160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5133355" y="3816863"/>
                  <a:ext cx="565306" cy="16619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IN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 </a:t>
                  </a:r>
                  <a:r>
                    <a:rPr lang="en-IN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IN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 </a:t>
                  </a:r>
                  <a:r>
                    <a:rPr lang="en-IN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IN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 </a:t>
                  </a:r>
                  <a:r>
                    <a:rPr lang="en-IN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US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7 </a:t>
                  </a:r>
                  <a:r>
                    <a:rPr lang="en-US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US" altLang="en-US" sz="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 </a:t>
                  </a:r>
                  <a:r>
                    <a:rPr lang="en-US" altLang="en-US" sz="6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en-US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US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endParaRPr lang="en-I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61" name="Straight Connector 160"/>
                <p:cNvCxnSpPr/>
                <p:nvPr/>
              </p:nvCxnSpPr>
              <p:spPr>
                <a:xfrm>
                  <a:off x="5518266" y="4170041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2" name="Straight Connector 161"/>
                <p:cNvCxnSpPr/>
                <p:nvPr/>
              </p:nvCxnSpPr>
              <p:spPr>
                <a:xfrm>
                  <a:off x="5517281" y="4018007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3" name="Straight Connector 162"/>
                <p:cNvCxnSpPr/>
                <p:nvPr/>
              </p:nvCxnSpPr>
              <p:spPr>
                <a:xfrm>
                  <a:off x="5510225" y="4435791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4" name="Straight Connector 163"/>
                <p:cNvCxnSpPr/>
                <p:nvPr/>
              </p:nvCxnSpPr>
              <p:spPr>
                <a:xfrm>
                  <a:off x="5511507" y="4731664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5" name="Straight Connector 164"/>
                <p:cNvCxnSpPr/>
                <p:nvPr/>
              </p:nvCxnSpPr>
              <p:spPr>
                <a:xfrm>
                  <a:off x="5496916" y="5085956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6" name="Straight Connector 165"/>
                <p:cNvCxnSpPr/>
                <p:nvPr/>
              </p:nvCxnSpPr>
              <p:spPr>
                <a:xfrm>
                  <a:off x="5510224" y="3816863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7" name="Straight Connector 166"/>
                <p:cNvCxnSpPr/>
                <p:nvPr/>
              </p:nvCxnSpPr>
              <p:spPr>
                <a:xfrm>
                  <a:off x="5496915" y="3712733"/>
                  <a:ext cx="16920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8" name="Rectangle 157"/>
              <p:cNvSpPr/>
              <p:nvPr/>
            </p:nvSpPr>
            <p:spPr>
              <a:xfrm>
                <a:off x="4465934" y="1624638"/>
                <a:ext cx="45717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 </a:t>
                </a:r>
                <a:r>
                  <a:rPr lang="en-IN" altLang="en-US" sz="6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9" name="Rectangle 158"/>
              <p:cNvSpPr/>
              <p:nvPr/>
            </p:nvSpPr>
            <p:spPr>
              <a:xfrm>
                <a:off x="4476083" y="1518153"/>
                <a:ext cx="457176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IN" altLang="en-US" sz="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 </a:t>
                </a:r>
                <a:r>
                  <a:rPr lang="en-IN" altLang="en-US" sz="6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5" name="Group 14"/>
          <p:cNvGrpSpPr/>
          <p:nvPr/>
        </p:nvGrpSpPr>
        <p:grpSpPr>
          <a:xfrm>
            <a:off x="1640857" y="3722607"/>
            <a:ext cx="3156175" cy="2986048"/>
            <a:chOff x="1640857" y="3722607"/>
            <a:chExt cx="3156175" cy="2986048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640857" y="4498855"/>
              <a:ext cx="2705100" cy="2209800"/>
            </a:xfrm>
            <a:prstGeom prst="rect">
              <a:avLst/>
            </a:prstGeom>
          </p:spPr>
        </p:pic>
        <p:grpSp>
          <p:nvGrpSpPr>
            <p:cNvPr id="42" name="Group 41"/>
            <p:cNvGrpSpPr/>
            <p:nvPr/>
          </p:nvGrpSpPr>
          <p:grpSpPr>
            <a:xfrm>
              <a:off x="1772285" y="3722607"/>
              <a:ext cx="3024747" cy="2378772"/>
              <a:chOff x="1986552" y="3606049"/>
              <a:chExt cx="3289960" cy="2664404"/>
            </a:xfrm>
          </p:grpSpPr>
          <p:grpSp>
            <p:nvGrpSpPr>
              <p:cNvPr id="95" name="Group 94"/>
              <p:cNvGrpSpPr/>
              <p:nvPr/>
            </p:nvGrpSpPr>
            <p:grpSpPr>
              <a:xfrm>
                <a:off x="1986552" y="3606049"/>
                <a:ext cx="3289960" cy="2598690"/>
                <a:chOff x="1539065" y="3339633"/>
                <a:chExt cx="3289960" cy="2598690"/>
              </a:xfrm>
            </p:grpSpPr>
            <p:grpSp>
              <p:nvGrpSpPr>
                <p:cNvPr id="4" name="Group 3"/>
                <p:cNvGrpSpPr/>
                <p:nvPr/>
              </p:nvGrpSpPr>
              <p:grpSpPr>
                <a:xfrm>
                  <a:off x="2481687" y="3339633"/>
                  <a:ext cx="2347338" cy="2598690"/>
                  <a:chOff x="1878289" y="3276409"/>
                  <a:chExt cx="2347338" cy="2598690"/>
                </a:xfrm>
              </p:grpSpPr>
              <p:sp>
                <p:nvSpPr>
                  <p:cNvPr id="8" name="TextBox 7"/>
                  <p:cNvSpPr txBox="1"/>
                  <p:nvPr/>
                </p:nvSpPr>
                <p:spPr>
                  <a:xfrm>
                    <a:off x="1878289" y="3276409"/>
                    <a:ext cx="1009868" cy="41368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IMP-1</a:t>
                    </a:r>
                    <a:endParaRPr lang="en-IN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" name="TextBox 17"/>
                  <p:cNvSpPr txBox="1"/>
                  <p:nvPr/>
                </p:nvSpPr>
                <p:spPr>
                  <a:xfrm>
                    <a:off x="3576675" y="5582076"/>
                    <a:ext cx="648952" cy="2930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6 </a:t>
                    </a:r>
                    <a:r>
                      <a:rPr lang="en-US" sz="11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en-IN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64" name="Group 63"/>
                <p:cNvGrpSpPr/>
                <p:nvPr/>
              </p:nvGrpSpPr>
              <p:grpSpPr>
                <a:xfrm>
                  <a:off x="1539065" y="3873153"/>
                  <a:ext cx="3027704" cy="334399"/>
                  <a:chOff x="848867" y="1043447"/>
                  <a:chExt cx="3027704" cy="334399"/>
                </a:xfrm>
              </p:grpSpPr>
              <p:sp>
                <p:nvSpPr>
                  <p:cNvPr id="65" name="TextBox 64"/>
                  <p:cNvSpPr txBox="1"/>
                  <p:nvPr/>
                </p:nvSpPr>
                <p:spPr>
                  <a:xfrm rot="19018214">
                    <a:off x="848867" y="1136533"/>
                    <a:ext cx="572236" cy="2413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trol</a:t>
                    </a:r>
                    <a:endParaRPr lang="en-I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6" name="TextBox 65"/>
                  <p:cNvSpPr txBox="1"/>
                  <p:nvPr/>
                </p:nvSpPr>
                <p:spPr>
                  <a:xfrm rot="19018214">
                    <a:off x="1493768" y="1094449"/>
                    <a:ext cx="572236" cy="24131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trol</a:t>
                    </a:r>
                    <a:endParaRPr lang="en-I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7" name="TextBox 66"/>
                  <p:cNvSpPr txBox="1"/>
                  <p:nvPr/>
                </p:nvSpPr>
                <p:spPr>
                  <a:xfrm rot="19018214">
                    <a:off x="2141649" y="1076869"/>
                    <a:ext cx="572236" cy="24131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trol</a:t>
                    </a:r>
                    <a:endParaRPr lang="en-I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8" name="TextBox 67"/>
                  <p:cNvSpPr txBox="1"/>
                  <p:nvPr/>
                </p:nvSpPr>
                <p:spPr>
                  <a:xfrm rot="19018214">
                    <a:off x="2738984" y="1096019"/>
                    <a:ext cx="572236" cy="24131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trol</a:t>
                    </a:r>
                    <a:endParaRPr lang="en-I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9" name="TextBox 68"/>
                  <p:cNvSpPr txBox="1"/>
                  <p:nvPr/>
                </p:nvSpPr>
                <p:spPr>
                  <a:xfrm rot="19018214">
                    <a:off x="1752058" y="1043447"/>
                    <a:ext cx="819820" cy="24131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 </a:t>
                    </a:r>
                    <a:r>
                      <a:rPr lang="en-US" sz="8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M</a:t>
                    </a:r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MSG</a:t>
                    </a:r>
                    <a:endParaRPr lang="en-I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0" name="TextBox 69"/>
                  <p:cNvSpPr txBox="1"/>
                  <p:nvPr/>
                </p:nvSpPr>
                <p:spPr>
                  <a:xfrm rot="19018214">
                    <a:off x="2358760" y="1043448"/>
                    <a:ext cx="819820" cy="24131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 </a:t>
                    </a:r>
                    <a:r>
                      <a:rPr lang="en-US" sz="8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M</a:t>
                    </a:r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MSG</a:t>
                    </a:r>
                    <a:endParaRPr lang="en-I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1" name="TextBox 70"/>
                  <p:cNvSpPr txBox="1"/>
                  <p:nvPr/>
                </p:nvSpPr>
                <p:spPr>
                  <a:xfrm rot="19018214">
                    <a:off x="3056751" y="1049969"/>
                    <a:ext cx="819820" cy="24131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 </a:t>
                    </a:r>
                    <a:r>
                      <a:rPr lang="en-US" sz="8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M</a:t>
                    </a:r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MSG</a:t>
                    </a:r>
                    <a:endParaRPr lang="en-I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2" name="TextBox 71"/>
                  <p:cNvSpPr txBox="1"/>
                  <p:nvPr/>
                </p:nvSpPr>
                <p:spPr>
                  <a:xfrm rot="19018214">
                    <a:off x="1128520" y="1067983"/>
                    <a:ext cx="819820" cy="24131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 </a:t>
                    </a:r>
                    <a:r>
                      <a:rPr lang="en-US" sz="8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M</a:t>
                    </a:r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MSG</a:t>
                    </a:r>
                    <a:endParaRPr lang="en-I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98" name="Rectangle 97"/>
              <p:cNvSpPr/>
              <p:nvPr/>
            </p:nvSpPr>
            <p:spPr>
              <a:xfrm>
                <a:off x="2093417" y="5887331"/>
                <a:ext cx="2552859" cy="38312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42" name="Group 141"/>
          <p:cNvGrpSpPr/>
          <p:nvPr/>
        </p:nvGrpSpPr>
        <p:grpSpPr>
          <a:xfrm>
            <a:off x="1315222" y="4732581"/>
            <a:ext cx="550989" cy="1938992"/>
            <a:chOff x="2144724" y="4740146"/>
            <a:chExt cx="550989" cy="1938992"/>
          </a:xfrm>
        </p:grpSpPr>
        <p:sp>
          <p:nvSpPr>
            <p:cNvPr id="143" name="TextBox 18"/>
            <p:cNvSpPr txBox="1">
              <a:spLocks noChangeArrowheads="1"/>
            </p:cNvSpPr>
            <p:nvPr/>
          </p:nvSpPr>
          <p:spPr bwMode="auto">
            <a:xfrm>
              <a:off x="2144724" y="4740146"/>
              <a:ext cx="459302" cy="19389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68" name="Group 167"/>
            <p:cNvGrpSpPr/>
            <p:nvPr/>
          </p:nvGrpSpPr>
          <p:grpSpPr>
            <a:xfrm>
              <a:off x="2545992" y="4825728"/>
              <a:ext cx="149721" cy="1451417"/>
              <a:chOff x="6855024" y="1326675"/>
              <a:chExt cx="149721" cy="1451417"/>
            </a:xfrm>
          </p:grpSpPr>
          <p:cxnSp>
            <p:nvCxnSpPr>
              <p:cNvPr id="169" name="Straight Connector 168"/>
              <p:cNvCxnSpPr/>
              <p:nvPr/>
            </p:nvCxnSpPr>
            <p:spPr>
              <a:xfrm>
                <a:off x="6855024" y="1665960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Straight Connector 169"/>
              <p:cNvCxnSpPr/>
              <p:nvPr/>
            </p:nvCxnSpPr>
            <p:spPr>
              <a:xfrm>
                <a:off x="6861297" y="1410696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1" name="Straight Connector 170"/>
              <p:cNvCxnSpPr/>
              <p:nvPr/>
            </p:nvCxnSpPr>
            <p:spPr>
              <a:xfrm>
                <a:off x="6855024" y="1536060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Straight Connector 171"/>
              <p:cNvCxnSpPr/>
              <p:nvPr/>
            </p:nvCxnSpPr>
            <p:spPr>
              <a:xfrm>
                <a:off x="6855024" y="1875440"/>
                <a:ext cx="14344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Straight Connector 172"/>
              <p:cNvCxnSpPr/>
              <p:nvPr/>
            </p:nvCxnSpPr>
            <p:spPr>
              <a:xfrm>
                <a:off x="6860671" y="1326675"/>
                <a:ext cx="14344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Straight Connector 173"/>
              <p:cNvCxnSpPr/>
              <p:nvPr/>
            </p:nvCxnSpPr>
            <p:spPr>
              <a:xfrm>
                <a:off x="6860672" y="2507822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Straight Connector 174"/>
              <p:cNvCxnSpPr/>
              <p:nvPr/>
            </p:nvCxnSpPr>
            <p:spPr>
              <a:xfrm>
                <a:off x="6855024" y="2778092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Straight Connector 175"/>
              <p:cNvCxnSpPr/>
              <p:nvPr/>
            </p:nvCxnSpPr>
            <p:spPr>
              <a:xfrm>
                <a:off x="6860672" y="2054202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94" name="Group 93"/>
          <p:cNvGrpSpPr/>
          <p:nvPr/>
        </p:nvGrpSpPr>
        <p:grpSpPr>
          <a:xfrm>
            <a:off x="7849192" y="3705143"/>
            <a:ext cx="3334452" cy="2635359"/>
            <a:chOff x="7266769" y="3474418"/>
            <a:chExt cx="3334452" cy="2635359"/>
          </a:xfrm>
        </p:grpSpPr>
        <p:grpSp>
          <p:nvGrpSpPr>
            <p:cNvPr id="25" name="Group 24"/>
            <p:cNvGrpSpPr/>
            <p:nvPr/>
          </p:nvGrpSpPr>
          <p:grpSpPr>
            <a:xfrm>
              <a:off x="8299459" y="3474418"/>
              <a:ext cx="2301762" cy="2635359"/>
              <a:chOff x="6745867" y="3486549"/>
              <a:chExt cx="2301762" cy="2635359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6745867" y="3486549"/>
                <a:ext cx="9284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P-2</a:t>
                </a:r>
                <a:endParaRPr lang="en-IN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8450991" y="5860298"/>
                <a:ext cx="59663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2 </a:t>
                </a:r>
                <a:r>
                  <a:rPr lang="en-US" sz="11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IN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5" name="Group 54"/>
            <p:cNvGrpSpPr/>
            <p:nvPr/>
          </p:nvGrpSpPr>
          <p:grpSpPr>
            <a:xfrm>
              <a:off x="7266769" y="3918955"/>
              <a:ext cx="2971596" cy="308530"/>
              <a:chOff x="871931" y="1056382"/>
              <a:chExt cx="2971596" cy="308530"/>
            </a:xfrm>
          </p:grpSpPr>
          <p:sp>
            <p:nvSpPr>
              <p:cNvPr id="56" name="TextBox 55"/>
              <p:cNvSpPr txBox="1"/>
              <p:nvPr/>
            </p:nvSpPr>
            <p:spPr>
              <a:xfrm rot="19018214">
                <a:off x="871931" y="1149468"/>
                <a:ext cx="5261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 rot="19018214">
                <a:off x="1516833" y="1107383"/>
                <a:ext cx="5261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 rot="19018214">
                <a:off x="2164713" y="1089804"/>
                <a:ext cx="5261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 rot="19018214">
                <a:off x="2762048" y="1108954"/>
                <a:ext cx="5261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 rot="19018214">
                <a:off x="1785102" y="1056382"/>
                <a:ext cx="7537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 </a:t>
                </a:r>
                <a:r>
                  <a:rPr lang="en-US" sz="8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</a:t>
                </a:r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SG</a:t>
                </a:r>
                <a:endPara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 rot="19018214">
                <a:off x="2391803" y="1056383"/>
                <a:ext cx="7537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 </a:t>
                </a:r>
                <a:r>
                  <a:rPr lang="en-US" sz="8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</a:t>
                </a:r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SG</a:t>
                </a:r>
                <a:endPara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 rot="19018214">
                <a:off x="3089795" y="1062904"/>
                <a:ext cx="7537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 </a:t>
                </a:r>
                <a:r>
                  <a:rPr lang="en-US" sz="8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</a:t>
                </a:r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SG</a:t>
                </a:r>
                <a:endPara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 rot="19018214">
                <a:off x="1161563" y="1080918"/>
                <a:ext cx="7537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 </a:t>
                </a:r>
                <a:r>
                  <a:rPr lang="en-US" sz="8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</a:t>
                </a:r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SG</a:t>
                </a:r>
                <a:endPara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77" name="Group 176"/>
          <p:cNvGrpSpPr/>
          <p:nvPr/>
        </p:nvGrpSpPr>
        <p:grpSpPr>
          <a:xfrm>
            <a:off x="7476005" y="4780464"/>
            <a:ext cx="550989" cy="1938992"/>
            <a:chOff x="2144724" y="4740146"/>
            <a:chExt cx="550989" cy="1938992"/>
          </a:xfrm>
        </p:grpSpPr>
        <p:sp>
          <p:nvSpPr>
            <p:cNvPr id="178" name="TextBox 18"/>
            <p:cNvSpPr txBox="1">
              <a:spLocks noChangeArrowheads="1"/>
            </p:cNvSpPr>
            <p:nvPr/>
          </p:nvSpPr>
          <p:spPr bwMode="auto">
            <a:xfrm>
              <a:off x="2144724" y="4740146"/>
              <a:ext cx="459302" cy="19389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n-IN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</a:t>
              </a:r>
              <a:r>
                <a:rPr lang="en-US" altLang="en-US" sz="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79" name="Group 178"/>
            <p:cNvGrpSpPr/>
            <p:nvPr/>
          </p:nvGrpSpPr>
          <p:grpSpPr>
            <a:xfrm>
              <a:off x="2545992" y="4825728"/>
              <a:ext cx="149721" cy="1451417"/>
              <a:chOff x="6855024" y="1326675"/>
              <a:chExt cx="149721" cy="1451417"/>
            </a:xfrm>
          </p:grpSpPr>
          <p:cxnSp>
            <p:nvCxnSpPr>
              <p:cNvPr id="180" name="Straight Connector 179"/>
              <p:cNvCxnSpPr/>
              <p:nvPr/>
            </p:nvCxnSpPr>
            <p:spPr>
              <a:xfrm>
                <a:off x="6855024" y="1665960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Straight Connector 180"/>
              <p:cNvCxnSpPr/>
              <p:nvPr/>
            </p:nvCxnSpPr>
            <p:spPr>
              <a:xfrm>
                <a:off x="6861297" y="1410696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Straight Connector 181"/>
              <p:cNvCxnSpPr/>
              <p:nvPr/>
            </p:nvCxnSpPr>
            <p:spPr>
              <a:xfrm>
                <a:off x="6855024" y="1536060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Straight Connector 182"/>
              <p:cNvCxnSpPr/>
              <p:nvPr/>
            </p:nvCxnSpPr>
            <p:spPr>
              <a:xfrm>
                <a:off x="6855024" y="1875440"/>
                <a:ext cx="14344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Straight Connector 183"/>
              <p:cNvCxnSpPr/>
              <p:nvPr/>
            </p:nvCxnSpPr>
            <p:spPr>
              <a:xfrm>
                <a:off x="6860671" y="1326675"/>
                <a:ext cx="14344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Straight Connector 184"/>
              <p:cNvCxnSpPr/>
              <p:nvPr/>
            </p:nvCxnSpPr>
            <p:spPr>
              <a:xfrm>
                <a:off x="6860672" y="2507822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Straight Connector 185"/>
              <p:cNvCxnSpPr/>
              <p:nvPr/>
            </p:nvCxnSpPr>
            <p:spPr>
              <a:xfrm>
                <a:off x="6855024" y="2778092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Straight Connector 186"/>
              <p:cNvCxnSpPr/>
              <p:nvPr/>
            </p:nvCxnSpPr>
            <p:spPr>
              <a:xfrm>
                <a:off x="6860672" y="2054202"/>
                <a:ext cx="1434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88" name="TextBox 187"/>
          <p:cNvSpPr txBox="1"/>
          <p:nvPr/>
        </p:nvSpPr>
        <p:spPr>
          <a:xfrm>
            <a:off x="6470242" y="3236543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TextBox 188"/>
          <p:cNvSpPr txBox="1"/>
          <p:nvPr/>
        </p:nvSpPr>
        <p:spPr>
          <a:xfrm>
            <a:off x="9315723" y="6470091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1876993" y="332633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TextBox 190"/>
          <p:cNvSpPr txBox="1"/>
          <p:nvPr/>
        </p:nvSpPr>
        <p:spPr>
          <a:xfrm>
            <a:off x="2806092" y="6470091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10503864" y="3134251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58590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60229" y="342118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" name="Group 23"/>
          <p:cNvGrpSpPr/>
          <p:nvPr/>
        </p:nvGrpSpPr>
        <p:grpSpPr>
          <a:xfrm>
            <a:off x="2686018" y="1713833"/>
            <a:ext cx="6256339" cy="3550626"/>
            <a:chOff x="1398756" y="1589546"/>
            <a:chExt cx="6256339" cy="3550626"/>
          </a:xfrm>
        </p:grpSpPr>
        <p:sp>
          <p:nvSpPr>
            <p:cNvPr id="12" name="TextBox 11"/>
            <p:cNvSpPr txBox="1"/>
            <p:nvPr/>
          </p:nvSpPr>
          <p:spPr>
            <a:xfrm rot="19018214">
              <a:off x="3502572" y="1607384"/>
              <a:ext cx="8980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SG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 rot="19018214">
              <a:off x="4318395" y="1601438"/>
              <a:ext cx="8980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SG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19018214">
              <a:off x="5134218" y="1595492"/>
              <a:ext cx="8980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SG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9018214">
              <a:off x="5950041" y="1589546"/>
              <a:ext cx="8980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SG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1398756" y="1709887"/>
              <a:ext cx="6256339" cy="3430285"/>
              <a:chOff x="1398756" y="1709887"/>
              <a:chExt cx="6256339" cy="3430285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87" t="24000" r="32054" b="25028"/>
              <a:stretch/>
            </p:blipFill>
            <p:spPr>
              <a:xfrm>
                <a:off x="2151270" y="2111740"/>
                <a:ext cx="4743672" cy="3028432"/>
              </a:xfrm>
              <a:prstGeom prst="rect">
                <a:avLst/>
              </a:prstGeom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7042427" y="3656692"/>
                <a:ext cx="61266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2 </a:t>
                </a:r>
                <a:r>
                  <a:rPr lang="en-US" sz="11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7042426" y="4448678"/>
                <a:ext cx="61266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2 </a:t>
                </a:r>
                <a:r>
                  <a:rPr lang="en-US" sz="11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1398756" y="3836080"/>
                <a:ext cx="6703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P-9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1398756" y="4597763"/>
                <a:ext cx="6703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P-2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9018214">
                <a:off x="3106490" y="1727725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2530136" y="3583016"/>
                <a:ext cx="3968317" cy="1361845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 rot="19018214">
                <a:off x="3922313" y="1721779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19018214">
                <a:off x="4738136" y="1715833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9018214">
                <a:off x="5553959" y="1709887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7855186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74"/>
          <p:cNvSpPr txBox="1"/>
          <p:nvPr/>
        </p:nvSpPr>
        <p:spPr>
          <a:xfrm>
            <a:off x="460229" y="342118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.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545470" y="985427"/>
            <a:ext cx="9868951" cy="5581331"/>
            <a:chOff x="1139359" y="985427"/>
            <a:chExt cx="9868951" cy="5581331"/>
          </a:xfrm>
        </p:grpSpPr>
        <p:grpSp>
          <p:nvGrpSpPr>
            <p:cNvPr id="5" name="Group 4"/>
            <p:cNvGrpSpPr/>
            <p:nvPr/>
          </p:nvGrpSpPr>
          <p:grpSpPr>
            <a:xfrm>
              <a:off x="1139359" y="985427"/>
              <a:ext cx="9868951" cy="5581331"/>
              <a:chOff x="733264" y="255656"/>
              <a:chExt cx="9524632" cy="5103733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935119" y="2860320"/>
                <a:ext cx="2322777" cy="2499069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582718" y="2847619"/>
                <a:ext cx="2322777" cy="2511770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241506" y="2847619"/>
                <a:ext cx="2316681" cy="2511770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733264" y="2847619"/>
                <a:ext cx="2469094" cy="2511770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7931262" y="255656"/>
                <a:ext cx="2322777" cy="2560542"/>
              </a:xfrm>
              <a:prstGeom prst="rect">
                <a:avLst/>
              </a:prstGeom>
            </p:spPr>
          </p:pic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581956" y="257024"/>
                <a:ext cx="2322777" cy="2560542"/>
              </a:xfrm>
              <a:prstGeom prst="rect">
                <a:avLst/>
              </a:prstGeom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232650" y="255656"/>
                <a:ext cx="2316681" cy="2560542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737028" y="264665"/>
                <a:ext cx="2462997" cy="2560542"/>
              </a:xfrm>
              <a:prstGeom prst="rect">
                <a:avLst/>
              </a:prstGeom>
            </p:spPr>
          </p:pic>
          <p:grpSp>
            <p:nvGrpSpPr>
              <p:cNvPr id="14" name="Group 13">
                <a:extLst>
                  <a:ext uri="{FF2B5EF4-FFF2-40B4-BE49-F238E27FC236}">
                    <a16:creationId xmlns="" xmlns:a16="http://schemas.microsoft.com/office/drawing/2014/main" id="{2856BEBF-E1A5-1C7B-283F-836FACD1C7BD}"/>
                  </a:ext>
                </a:extLst>
              </p:cNvPr>
              <p:cNvGrpSpPr/>
              <p:nvPr/>
            </p:nvGrpSpPr>
            <p:grpSpPr>
              <a:xfrm rot="17501476">
                <a:off x="827766" y="3767012"/>
                <a:ext cx="383828" cy="135173"/>
                <a:chOff x="4055221" y="4559068"/>
                <a:chExt cx="261723" cy="101389"/>
              </a:xfrm>
            </p:grpSpPr>
            <p:cxnSp>
              <p:nvCxnSpPr>
                <p:cNvPr id="72" name="Straight Arrow Connector 71">
                  <a:extLst>
                    <a:ext uri="{FF2B5EF4-FFF2-40B4-BE49-F238E27FC236}">
                      <a16:creationId xmlns="" xmlns:a16="http://schemas.microsoft.com/office/drawing/2014/main" id="{EAA7EEB4-F8B2-4D00-82D5-FCF12FE239F5}"/>
                    </a:ext>
                  </a:extLst>
                </p:cNvPr>
                <p:cNvCxnSpPr/>
                <p:nvPr/>
              </p:nvCxnSpPr>
              <p:spPr>
                <a:xfrm flipV="1">
                  <a:off x="4083796" y="4559068"/>
                  <a:ext cx="233148" cy="101389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Straight Arrow Connector 72">
                  <a:extLst>
                    <a:ext uri="{FF2B5EF4-FFF2-40B4-BE49-F238E27FC236}">
                      <a16:creationId xmlns="" xmlns:a16="http://schemas.microsoft.com/office/drawing/2014/main" id="{ECCFBE79-D838-7A40-2DE8-57688B3DEE88}"/>
                    </a:ext>
                  </a:extLst>
                </p:cNvPr>
                <p:cNvCxnSpPr/>
                <p:nvPr/>
              </p:nvCxnSpPr>
              <p:spPr>
                <a:xfrm flipV="1">
                  <a:off x="4055221" y="4559068"/>
                  <a:ext cx="233148" cy="10138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" name="Group 14">
                <a:extLst>
                  <a:ext uri="{FF2B5EF4-FFF2-40B4-BE49-F238E27FC236}">
                    <a16:creationId xmlns="" xmlns:a16="http://schemas.microsoft.com/office/drawing/2014/main" id="{480C5692-6A90-DB69-5F7A-B9168E93140B}"/>
                  </a:ext>
                </a:extLst>
              </p:cNvPr>
              <p:cNvGrpSpPr/>
              <p:nvPr/>
            </p:nvGrpSpPr>
            <p:grpSpPr>
              <a:xfrm>
                <a:off x="6140114" y="4578414"/>
                <a:ext cx="383827" cy="135173"/>
                <a:chOff x="4055221" y="4559068"/>
                <a:chExt cx="261723" cy="101389"/>
              </a:xfrm>
            </p:grpSpPr>
            <p:cxnSp>
              <p:nvCxnSpPr>
                <p:cNvPr id="70" name="Straight Arrow Connector 69">
                  <a:extLst>
                    <a:ext uri="{FF2B5EF4-FFF2-40B4-BE49-F238E27FC236}">
                      <a16:creationId xmlns="" xmlns:a16="http://schemas.microsoft.com/office/drawing/2014/main" id="{479646DE-A8F0-48FA-535D-A25DA304CF71}"/>
                    </a:ext>
                  </a:extLst>
                </p:cNvPr>
                <p:cNvCxnSpPr/>
                <p:nvPr/>
              </p:nvCxnSpPr>
              <p:spPr>
                <a:xfrm flipV="1">
                  <a:off x="4083796" y="4559068"/>
                  <a:ext cx="233148" cy="101389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1" name="Straight Arrow Connector 70">
                  <a:extLst>
                    <a:ext uri="{FF2B5EF4-FFF2-40B4-BE49-F238E27FC236}">
                      <a16:creationId xmlns="" xmlns:a16="http://schemas.microsoft.com/office/drawing/2014/main" id="{BD014603-94E0-6D9D-B7BD-EDE9D2BADEBC}"/>
                    </a:ext>
                  </a:extLst>
                </p:cNvPr>
                <p:cNvCxnSpPr/>
                <p:nvPr/>
              </p:nvCxnSpPr>
              <p:spPr>
                <a:xfrm flipV="1">
                  <a:off x="4055221" y="4559068"/>
                  <a:ext cx="233148" cy="10138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6" name="Group 15">
                <a:extLst>
                  <a:ext uri="{FF2B5EF4-FFF2-40B4-BE49-F238E27FC236}">
                    <a16:creationId xmlns="" xmlns:a16="http://schemas.microsoft.com/office/drawing/2014/main" id="{A27702C7-E909-9F28-CA06-9DE16B076225}"/>
                  </a:ext>
                </a:extLst>
              </p:cNvPr>
              <p:cNvGrpSpPr/>
              <p:nvPr/>
            </p:nvGrpSpPr>
            <p:grpSpPr>
              <a:xfrm>
                <a:off x="8008669" y="3638742"/>
                <a:ext cx="451435" cy="1064796"/>
                <a:chOff x="9221432" y="4314500"/>
                <a:chExt cx="254400" cy="600050"/>
              </a:xfrm>
            </p:grpSpPr>
            <p:grpSp>
              <p:nvGrpSpPr>
                <p:cNvPr id="64" name="Group 63">
                  <a:extLst>
                    <a:ext uri="{FF2B5EF4-FFF2-40B4-BE49-F238E27FC236}">
                      <a16:creationId xmlns="" xmlns:a16="http://schemas.microsoft.com/office/drawing/2014/main" id="{25DDC418-B727-0E69-D9CF-E67D50B001FA}"/>
                    </a:ext>
                  </a:extLst>
                </p:cNvPr>
                <p:cNvGrpSpPr/>
                <p:nvPr/>
              </p:nvGrpSpPr>
              <p:grpSpPr>
                <a:xfrm rot="1254146">
                  <a:off x="9259532" y="4838375"/>
                  <a:ext cx="216300" cy="76175"/>
                  <a:chOff x="4055221" y="4559068"/>
                  <a:chExt cx="261723" cy="101389"/>
                </a:xfrm>
              </p:grpSpPr>
              <p:cxnSp>
                <p:nvCxnSpPr>
                  <p:cNvPr id="68" name="Straight Arrow Connector 67">
                    <a:extLst>
                      <a:ext uri="{FF2B5EF4-FFF2-40B4-BE49-F238E27FC236}">
                        <a16:creationId xmlns="" xmlns:a16="http://schemas.microsoft.com/office/drawing/2014/main" id="{748A3898-FB8A-9A5B-6176-9F373AEA6031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4083796" y="4559068"/>
                    <a:ext cx="233148" cy="101389"/>
                  </a:xfrm>
                  <a:prstGeom prst="straightConnector1">
                    <a:avLst/>
                  </a:prstGeom>
                  <a:ln w="381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" name="Straight Arrow Connector 68">
                    <a:extLst>
                      <a:ext uri="{FF2B5EF4-FFF2-40B4-BE49-F238E27FC236}">
                        <a16:creationId xmlns="" xmlns:a16="http://schemas.microsoft.com/office/drawing/2014/main" id="{F423E783-488B-3767-DE23-B4988435234D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4055221" y="4559068"/>
                    <a:ext cx="233148" cy="101389"/>
                  </a:xfrm>
                  <a:prstGeom prst="straightConnector1">
                    <a:avLst/>
                  </a:prstGeom>
                  <a:ln w="28575">
                    <a:solidFill>
                      <a:schemeClr val="bg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5" name="Group 64">
                  <a:extLst>
                    <a:ext uri="{FF2B5EF4-FFF2-40B4-BE49-F238E27FC236}">
                      <a16:creationId xmlns="" xmlns:a16="http://schemas.microsoft.com/office/drawing/2014/main" id="{BBC4FBC5-F263-2C23-C457-F9F95A6F3DE9}"/>
                    </a:ext>
                  </a:extLst>
                </p:cNvPr>
                <p:cNvGrpSpPr/>
                <p:nvPr/>
              </p:nvGrpSpPr>
              <p:grpSpPr>
                <a:xfrm rot="1254146">
                  <a:off x="9221432" y="4314500"/>
                  <a:ext cx="216300" cy="76175"/>
                  <a:chOff x="4055221" y="4559068"/>
                  <a:chExt cx="261723" cy="101389"/>
                </a:xfrm>
              </p:grpSpPr>
              <p:cxnSp>
                <p:nvCxnSpPr>
                  <p:cNvPr id="66" name="Straight Arrow Connector 65">
                    <a:extLst>
                      <a:ext uri="{FF2B5EF4-FFF2-40B4-BE49-F238E27FC236}">
                        <a16:creationId xmlns="" xmlns:a16="http://schemas.microsoft.com/office/drawing/2014/main" id="{7CE4DAED-7764-B67C-1297-4764E5C87636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4083796" y="4559068"/>
                    <a:ext cx="233148" cy="101389"/>
                  </a:xfrm>
                  <a:prstGeom prst="straightConnector1">
                    <a:avLst/>
                  </a:prstGeom>
                  <a:ln w="381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7" name="Straight Arrow Connector 66">
                    <a:extLst>
                      <a:ext uri="{FF2B5EF4-FFF2-40B4-BE49-F238E27FC236}">
                        <a16:creationId xmlns="" xmlns:a16="http://schemas.microsoft.com/office/drawing/2014/main" id="{B34C00F0-2076-E2C1-38B6-93BA3D266E20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4055221" y="4559068"/>
                    <a:ext cx="233148" cy="101389"/>
                  </a:xfrm>
                  <a:prstGeom prst="straightConnector1">
                    <a:avLst/>
                  </a:prstGeom>
                  <a:ln w="28575">
                    <a:solidFill>
                      <a:schemeClr val="bg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7" name="Group 16">
                <a:extLst>
                  <a:ext uri="{FF2B5EF4-FFF2-40B4-BE49-F238E27FC236}">
                    <a16:creationId xmlns="" xmlns:a16="http://schemas.microsoft.com/office/drawing/2014/main" id="{93CD3242-0E02-4765-E165-7B9A5513AF07}"/>
                  </a:ext>
                </a:extLst>
              </p:cNvPr>
              <p:cNvGrpSpPr/>
              <p:nvPr/>
            </p:nvGrpSpPr>
            <p:grpSpPr>
              <a:xfrm rot="20857905">
                <a:off x="4572095" y="4128735"/>
                <a:ext cx="383827" cy="135173"/>
                <a:chOff x="4055221" y="4559068"/>
                <a:chExt cx="261723" cy="101389"/>
              </a:xfrm>
            </p:grpSpPr>
            <p:cxnSp>
              <p:nvCxnSpPr>
                <p:cNvPr id="62" name="Straight Arrow Connector 61">
                  <a:extLst>
                    <a:ext uri="{FF2B5EF4-FFF2-40B4-BE49-F238E27FC236}">
                      <a16:creationId xmlns="" xmlns:a16="http://schemas.microsoft.com/office/drawing/2014/main" id="{3960423A-A9FF-EC51-6E19-0C0812787C55}"/>
                    </a:ext>
                  </a:extLst>
                </p:cNvPr>
                <p:cNvCxnSpPr/>
                <p:nvPr/>
              </p:nvCxnSpPr>
              <p:spPr>
                <a:xfrm flipV="1">
                  <a:off x="4083796" y="4559068"/>
                  <a:ext cx="233148" cy="101389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Straight Arrow Connector 62">
                  <a:extLst>
                    <a:ext uri="{FF2B5EF4-FFF2-40B4-BE49-F238E27FC236}">
                      <a16:creationId xmlns="" xmlns:a16="http://schemas.microsoft.com/office/drawing/2014/main" id="{62FC0C3A-7743-C89D-C08D-ED0247077F9F}"/>
                    </a:ext>
                  </a:extLst>
                </p:cNvPr>
                <p:cNvCxnSpPr/>
                <p:nvPr/>
              </p:nvCxnSpPr>
              <p:spPr>
                <a:xfrm flipV="1">
                  <a:off x="4055221" y="4559068"/>
                  <a:ext cx="233148" cy="10138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" name="Group 17">
                <a:extLst>
                  <a:ext uri="{FF2B5EF4-FFF2-40B4-BE49-F238E27FC236}">
                    <a16:creationId xmlns="" xmlns:a16="http://schemas.microsoft.com/office/drawing/2014/main" id="{E26E87E3-817F-AFA7-F1EE-546879C2B002}"/>
                  </a:ext>
                </a:extLst>
              </p:cNvPr>
              <p:cNvGrpSpPr/>
              <p:nvPr/>
            </p:nvGrpSpPr>
            <p:grpSpPr>
              <a:xfrm rot="20857905">
                <a:off x="3735145" y="3473089"/>
                <a:ext cx="383827" cy="135173"/>
                <a:chOff x="4055221" y="4559068"/>
                <a:chExt cx="261723" cy="101389"/>
              </a:xfrm>
            </p:grpSpPr>
            <p:cxnSp>
              <p:nvCxnSpPr>
                <p:cNvPr id="60" name="Straight Arrow Connector 59">
                  <a:extLst>
                    <a:ext uri="{FF2B5EF4-FFF2-40B4-BE49-F238E27FC236}">
                      <a16:creationId xmlns="" xmlns:a16="http://schemas.microsoft.com/office/drawing/2014/main" id="{4E8370E3-7D3B-9890-E1E6-FF1586C78C94}"/>
                    </a:ext>
                  </a:extLst>
                </p:cNvPr>
                <p:cNvCxnSpPr/>
                <p:nvPr/>
              </p:nvCxnSpPr>
              <p:spPr>
                <a:xfrm flipV="1">
                  <a:off x="4083796" y="4559068"/>
                  <a:ext cx="233148" cy="101389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Straight Arrow Connector 60">
                  <a:extLst>
                    <a:ext uri="{FF2B5EF4-FFF2-40B4-BE49-F238E27FC236}">
                      <a16:creationId xmlns="" xmlns:a16="http://schemas.microsoft.com/office/drawing/2014/main" id="{EDB496E3-1FF9-8131-7A86-EA6B311C3242}"/>
                    </a:ext>
                  </a:extLst>
                </p:cNvPr>
                <p:cNvCxnSpPr/>
                <p:nvPr/>
              </p:nvCxnSpPr>
              <p:spPr>
                <a:xfrm flipV="1">
                  <a:off x="4055221" y="4559068"/>
                  <a:ext cx="233148" cy="10138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" name="Group 18">
                <a:extLst>
                  <a:ext uri="{FF2B5EF4-FFF2-40B4-BE49-F238E27FC236}">
                    <a16:creationId xmlns="" xmlns:a16="http://schemas.microsoft.com/office/drawing/2014/main" id="{858345B8-4365-E992-4A51-B6882849A584}"/>
                  </a:ext>
                </a:extLst>
              </p:cNvPr>
              <p:cNvGrpSpPr/>
              <p:nvPr/>
            </p:nvGrpSpPr>
            <p:grpSpPr>
              <a:xfrm rot="1261455">
                <a:off x="3668546" y="1888708"/>
                <a:ext cx="383827" cy="135173"/>
                <a:chOff x="4055221" y="4559068"/>
                <a:chExt cx="261723" cy="101389"/>
              </a:xfrm>
            </p:grpSpPr>
            <p:cxnSp>
              <p:nvCxnSpPr>
                <p:cNvPr id="58" name="Straight Arrow Connector 57">
                  <a:extLst>
                    <a:ext uri="{FF2B5EF4-FFF2-40B4-BE49-F238E27FC236}">
                      <a16:creationId xmlns="" xmlns:a16="http://schemas.microsoft.com/office/drawing/2014/main" id="{C712E723-FAEC-20DE-CA51-321831953B80}"/>
                    </a:ext>
                  </a:extLst>
                </p:cNvPr>
                <p:cNvCxnSpPr/>
                <p:nvPr/>
              </p:nvCxnSpPr>
              <p:spPr>
                <a:xfrm flipV="1">
                  <a:off x="4083796" y="4559068"/>
                  <a:ext cx="233148" cy="101389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Straight Arrow Connector 58">
                  <a:extLst>
                    <a:ext uri="{FF2B5EF4-FFF2-40B4-BE49-F238E27FC236}">
                      <a16:creationId xmlns="" xmlns:a16="http://schemas.microsoft.com/office/drawing/2014/main" id="{CB9CC096-DC02-D5FC-A4EB-D5F1F624AD68}"/>
                    </a:ext>
                  </a:extLst>
                </p:cNvPr>
                <p:cNvCxnSpPr/>
                <p:nvPr/>
              </p:nvCxnSpPr>
              <p:spPr>
                <a:xfrm flipV="1">
                  <a:off x="4055221" y="4559068"/>
                  <a:ext cx="233148" cy="10138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" name="Group 19">
                <a:extLst>
                  <a:ext uri="{FF2B5EF4-FFF2-40B4-BE49-F238E27FC236}">
                    <a16:creationId xmlns="" xmlns:a16="http://schemas.microsoft.com/office/drawing/2014/main" id="{1DE03038-D4F3-7F99-EFAC-90EE45DE9EBF}"/>
                  </a:ext>
                </a:extLst>
              </p:cNvPr>
              <p:cNvGrpSpPr/>
              <p:nvPr/>
            </p:nvGrpSpPr>
            <p:grpSpPr>
              <a:xfrm rot="20857905">
                <a:off x="4631972" y="1726130"/>
                <a:ext cx="383827" cy="135173"/>
                <a:chOff x="4055221" y="4559068"/>
                <a:chExt cx="261723" cy="101389"/>
              </a:xfrm>
            </p:grpSpPr>
            <p:cxnSp>
              <p:nvCxnSpPr>
                <p:cNvPr id="56" name="Straight Arrow Connector 55">
                  <a:extLst>
                    <a:ext uri="{FF2B5EF4-FFF2-40B4-BE49-F238E27FC236}">
                      <a16:creationId xmlns="" xmlns:a16="http://schemas.microsoft.com/office/drawing/2014/main" id="{28C677D2-36CF-9342-813A-488CDC27FF9D}"/>
                    </a:ext>
                  </a:extLst>
                </p:cNvPr>
                <p:cNvCxnSpPr/>
                <p:nvPr/>
              </p:nvCxnSpPr>
              <p:spPr>
                <a:xfrm flipV="1">
                  <a:off x="4083796" y="4559068"/>
                  <a:ext cx="233148" cy="101389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Straight Arrow Connector 56">
                  <a:extLst>
                    <a:ext uri="{FF2B5EF4-FFF2-40B4-BE49-F238E27FC236}">
                      <a16:creationId xmlns="" xmlns:a16="http://schemas.microsoft.com/office/drawing/2014/main" id="{BCC5C0B0-F63C-B36E-89DA-ED0D5515EF14}"/>
                    </a:ext>
                  </a:extLst>
                </p:cNvPr>
                <p:cNvCxnSpPr/>
                <p:nvPr/>
              </p:nvCxnSpPr>
              <p:spPr>
                <a:xfrm flipV="1">
                  <a:off x="4055221" y="4559068"/>
                  <a:ext cx="233148" cy="10138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1" name="Group 20">
                <a:extLst>
                  <a:ext uri="{FF2B5EF4-FFF2-40B4-BE49-F238E27FC236}">
                    <a16:creationId xmlns="" xmlns:a16="http://schemas.microsoft.com/office/drawing/2014/main" id="{C8326C94-BA3B-2170-0E00-FF2CF4EE5056}"/>
                  </a:ext>
                </a:extLst>
              </p:cNvPr>
              <p:cNvGrpSpPr/>
              <p:nvPr/>
            </p:nvGrpSpPr>
            <p:grpSpPr>
              <a:xfrm rot="20857905">
                <a:off x="6947340" y="745801"/>
                <a:ext cx="383827" cy="135173"/>
                <a:chOff x="4055221" y="4559068"/>
                <a:chExt cx="261723" cy="101389"/>
              </a:xfrm>
            </p:grpSpPr>
            <p:cxnSp>
              <p:nvCxnSpPr>
                <p:cNvPr id="54" name="Straight Arrow Connector 53">
                  <a:extLst>
                    <a:ext uri="{FF2B5EF4-FFF2-40B4-BE49-F238E27FC236}">
                      <a16:creationId xmlns="" xmlns:a16="http://schemas.microsoft.com/office/drawing/2014/main" id="{157BA712-900B-AF3B-773C-644F80BDABB8}"/>
                    </a:ext>
                  </a:extLst>
                </p:cNvPr>
                <p:cNvCxnSpPr/>
                <p:nvPr/>
              </p:nvCxnSpPr>
              <p:spPr>
                <a:xfrm flipV="1">
                  <a:off x="4083796" y="4559068"/>
                  <a:ext cx="233148" cy="101389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Straight Arrow Connector 54">
                  <a:extLst>
                    <a:ext uri="{FF2B5EF4-FFF2-40B4-BE49-F238E27FC236}">
                      <a16:creationId xmlns="" xmlns:a16="http://schemas.microsoft.com/office/drawing/2014/main" id="{10983AF2-2B96-59A2-4704-9D3453416F0C}"/>
                    </a:ext>
                  </a:extLst>
                </p:cNvPr>
                <p:cNvCxnSpPr/>
                <p:nvPr/>
              </p:nvCxnSpPr>
              <p:spPr>
                <a:xfrm flipV="1">
                  <a:off x="4055221" y="4559068"/>
                  <a:ext cx="233148" cy="10138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" name="Group 21">
                <a:extLst>
                  <a:ext uri="{FF2B5EF4-FFF2-40B4-BE49-F238E27FC236}">
                    <a16:creationId xmlns="" xmlns:a16="http://schemas.microsoft.com/office/drawing/2014/main" id="{EA61FEFD-4778-EEBB-D6A5-7DD7B34FCAEB}"/>
                  </a:ext>
                </a:extLst>
              </p:cNvPr>
              <p:cNvGrpSpPr/>
              <p:nvPr/>
            </p:nvGrpSpPr>
            <p:grpSpPr>
              <a:xfrm rot="20857905">
                <a:off x="5899402" y="999334"/>
                <a:ext cx="383827" cy="135173"/>
                <a:chOff x="4055221" y="4559068"/>
                <a:chExt cx="261723" cy="101389"/>
              </a:xfrm>
            </p:grpSpPr>
            <p:cxnSp>
              <p:nvCxnSpPr>
                <p:cNvPr id="52" name="Straight Arrow Connector 51">
                  <a:extLst>
                    <a:ext uri="{FF2B5EF4-FFF2-40B4-BE49-F238E27FC236}">
                      <a16:creationId xmlns="" xmlns:a16="http://schemas.microsoft.com/office/drawing/2014/main" id="{A27BAE0A-B4ED-88A3-AAEB-279ABD7AC5BD}"/>
                    </a:ext>
                  </a:extLst>
                </p:cNvPr>
                <p:cNvCxnSpPr/>
                <p:nvPr/>
              </p:nvCxnSpPr>
              <p:spPr>
                <a:xfrm flipV="1">
                  <a:off x="4083796" y="4559068"/>
                  <a:ext cx="233148" cy="101389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Straight Arrow Connector 52">
                  <a:extLst>
                    <a:ext uri="{FF2B5EF4-FFF2-40B4-BE49-F238E27FC236}">
                      <a16:creationId xmlns="" xmlns:a16="http://schemas.microsoft.com/office/drawing/2014/main" id="{74EC246E-5317-D5E1-45E3-28279674B728}"/>
                    </a:ext>
                  </a:extLst>
                </p:cNvPr>
                <p:cNvCxnSpPr/>
                <p:nvPr/>
              </p:nvCxnSpPr>
              <p:spPr>
                <a:xfrm flipV="1">
                  <a:off x="4055221" y="4559068"/>
                  <a:ext cx="233148" cy="10138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" name="Group 22">
                <a:extLst>
                  <a:ext uri="{FF2B5EF4-FFF2-40B4-BE49-F238E27FC236}">
                    <a16:creationId xmlns="" xmlns:a16="http://schemas.microsoft.com/office/drawing/2014/main" id="{66B0C932-6864-18E5-6F94-798E6AE01A14}"/>
                  </a:ext>
                </a:extLst>
              </p:cNvPr>
              <p:cNvGrpSpPr/>
              <p:nvPr/>
            </p:nvGrpSpPr>
            <p:grpSpPr>
              <a:xfrm rot="20857905">
                <a:off x="5679674" y="695094"/>
                <a:ext cx="383827" cy="135173"/>
                <a:chOff x="4055221" y="4559068"/>
                <a:chExt cx="261723" cy="101389"/>
              </a:xfrm>
            </p:grpSpPr>
            <p:cxnSp>
              <p:nvCxnSpPr>
                <p:cNvPr id="50" name="Straight Arrow Connector 49">
                  <a:extLst>
                    <a:ext uri="{FF2B5EF4-FFF2-40B4-BE49-F238E27FC236}">
                      <a16:creationId xmlns="" xmlns:a16="http://schemas.microsoft.com/office/drawing/2014/main" id="{F1FB056F-2CF6-2ED7-947B-C690CDFC33C0}"/>
                    </a:ext>
                  </a:extLst>
                </p:cNvPr>
                <p:cNvCxnSpPr/>
                <p:nvPr/>
              </p:nvCxnSpPr>
              <p:spPr>
                <a:xfrm flipV="1">
                  <a:off x="4083796" y="4559068"/>
                  <a:ext cx="233148" cy="101389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Straight Arrow Connector 50">
                  <a:extLst>
                    <a:ext uri="{FF2B5EF4-FFF2-40B4-BE49-F238E27FC236}">
                      <a16:creationId xmlns="" xmlns:a16="http://schemas.microsoft.com/office/drawing/2014/main" id="{B7E88A44-44D6-AC32-679C-2BC1A7DCD0EC}"/>
                    </a:ext>
                  </a:extLst>
                </p:cNvPr>
                <p:cNvCxnSpPr/>
                <p:nvPr/>
              </p:nvCxnSpPr>
              <p:spPr>
                <a:xfrm flipV="1">
                  <a:off x="4055221" y="4559068"/>
                  <a:ext cx="233148" cy="10138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" name="Group 23">
                <a:extLst>
                  <a:ext uri="{FF2B5EF4-FFF2-40B4-BE49-F238E27FC236}">
                    <a16:creationId xmlns="" xmlns:a16="http://schemas.microsoft.com/office/drawing/2014/main" id="{B4133471-3B41-B50E-48EE-C9AAE6E7ECB9}"/>
                  </a:ext>
                </a:extLst>
              </p:cNvPr>
              <p:cNvGrpSpPr/>
              <p:nvPr/>
            </p:nvGrpSpPr>
            <p:grpSpPr>
              <a:xfrm rot="17524082">
                <a:off x="2651482" y="1223688"/>
                <a:ext cx="383828" cy="135173"/>
                <a:chOff x="4055221" y="4559068"/>
                <a:chExt cx="261723" cy="101389"/>
              </a:xfrm>
            </p:grpSpPr>
            <p:cxnSp>
              <p:nvCxnSpPr>
                <p:cNvPr id="48" name="Straight Arrow Connector 47">
                  <a:extLst>
                    <a:ext uri="{FF2B5EF4-FFF2-40B4-BE49-F238E27FC236}">
                      <a16:creationId xmlns="" xmlns:a16="http://schemas.microsoft.com/office/drawing/2014/main" id="{E442286E-B2E3-5166-DE2B-0BE83C9D5723}"/>
                    </a:ext>
                  </a:extLst>
                </p:cNvPr>
                <p:cNvCxnSpPr/>
                <p:nvPr/>
              </p:nvCxnSpPr>
              <p:spPr>
                <a:xfrm flipV="1">
                  <a:off x="4083796" y="4559068"/>
                  <a:ext cx="233148" cy="101389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Straight Arrow Connector 48">
                  <a:extLst>
                    <a:ext uri="{FF2B5EF4-FFF2-40B4-BE49-F238E27FC236}">
                      <a16:creationId xmlns="" xmlns:a16="http://schemas.microsoft.com/office/drawing/2014/main" id="{FA9B4C36-073F-5711-05AC-E580F908DCA8}"/>
                    </a:ext>
                  </a:extLst>
                </p:cNvPr>
                <p:cNvCxnSpPr/>
                <p:nvPr/>
              </p:nvCxnSpPr>
              <p:spPr>
                <a:xfrm flipV="1">
                  <a:off x="4055221" y="4559068"/>
                  <a:ext cx="233148" cy="10138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5" name="Group 24">
                <a:extLst>
                  <a:ext uri="{FF2B5EF4-FFF2-40B4-BE49-F238E27FC236}">
                    <a16:creationId xmlns="" xmlns:a16="http://schemas.microsoft.com/office/drawing/2014/main" id="{2A67335B-3E9F-12ED-4682-3777845C55B4}"/>
                  </a:ext>
                </a:extLst>
              </p:cNvPr>
              <p:cNvGrpSpPr/>
              <p:nvPr/>
            </p:nvGrpSpPr>
            <p:grpSpPr>
              <a:xfrm rot="4185111" flipH="1">
                <a:off x="709107" y="1985267"/>
                <a:ext cx="383827" cy="135173"/>
                <a:chOff x="4055221" y="4559068"/>
                <a:chExt cx="261723" cy="101389"/>
              </a:xfrm>
            </p:grpSpPr>
            <p:cxnSp>
              <p:nvCxnSpPr>
                <p:cNvPr id="46" name="Straight Arrow Connector 45">
                  <a:extLst>
                    <a:ext uri="{FF2B5EF4-FFF2-40B4-BE49-F238E27FC236}">
                      <a16:creationId xmlns="" xmlns:a16="http://schemas.microsoft.com/office/drawing/2014/main" id="{DFD36305-AADC-A8AE-C65D-E2C00DBEA035}"/>
                    </a:ext>
                  </a:extLst>
                </p:cNvPr>
                <p:cNvCxnSpPr/>
                <p:nvPr/>
              </p:nvCxnSpPr>
              <p:spPr>
                <a:xfrm flipV="1">
                  <a:off x="4083796" y="4559068"/>
                  <a:ext cx="233148" cy="101389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Straight Arrow Connector 46">
                  <a:extLst>
                    <a:ext uri="{FF2B5EF4-FFF2-40B4-BE49-F238E27FC236}">
                      <a16:creationId xmlns="" xmlns:a16="http://schemas.microsoft.com/office/drawing/2014/main" id="{43A7FC39-1032-E3C1-CB15-87DF02C23EFA}"/>
                    </a:ext>
                  </a:extLst>
                </p:cNvPr>
                <p:cNvCxnSpPr/>
                <p:nvPr/>
              </p:nvCxnSpPr>
              <p:spPr>
                <a:xfrm flipV="1">
                  <a:off x="4055221" y="4559068"/>
                  <a:ext cx="233148" cy="10138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6" name="Group 25">
                <a:extLst>
                  <a:ext uri="{FF2B5EF4-FFF2-40B4-BE49-F238E27FC236}">
                    <a16:creationId xmlns="" xmlns:a16="http://schemas.microsoft.com/office/drawing/2014/main" id="{6B82A2DF-4B15-F370-4F56-7A6F343CE41F}"/>
                  </a:ext>
                </a:extLst>
              </p:cNvPr>
              <p:cNvGrpSpPr/>
              <p:nvPr/>
            </p:nvGrpSpPr>
            <p:grpSpPr>
              <a:xfrm>
                <a:off x="1264121" y="4861002"/>
                <a:ext cx="383827" cy="135173"/>
                <a:chOff x="4055221" y="4559068"/>
                <a:chExt cx="261723" cy="101389"/>
              </a:xfrm>
            </p:grpSpPr>
            <p:cxnSp>
              <p:nvCxnSpPr>
                <p:cNvPr id="44" name="Straight Arrow Connector 43">
                  <a:extLst>
                    <a:ext uri="{FF2B5EF4-FFF2-40B4-BE49-F238E27FC236}">
                      <a16:creationId xmlns="" xmlns:a16="http://schemas.microsoft.com/office/drawing/2014/main" id="{187C90FB-3EF3-EBC7-7E29-B6F47DD4001A}"/>
                    </a:ext>
                  </a:extLst>
                </p:cNvPr>
                <p:cNvCxnSpPr/>
                <p:nvPr/>
              </p:nvCxnSpPr>
              <p:spPr>
                <a:xfrm flipV="1">
                  <a:off x="4083796" y="4559068"/>
                  <a:ext cx="233148" cy="101389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Arrow Connector 44">
                  <a:extLst>
                    <a:ext uri="{FF2B5EF4-FFF2-40B4-BE49-F238E27FC236}">
                      <a16:creationId xmlns="" xmlns:a16="http://schemas.microsoft.com/office/drawing/2014/main" id="{FB355A6C-8D20-782B-D721-1D5807C3117E}"/>
                    </a:ext>
                  </a:extLst>
                </p:cNvPr>
                <p:cNvCxnSpPr/>
                <p:nvPr/>
              </p:nvCxnSpPr>
              <p:spPr>
                <a:xfrm flipV="1">
                  <a:off x="4055221" y="4559068"/>
                  <a:ext cx="233148" cy="10138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7" name="Group 26">
                <a:extLst>
                  <a:ext uri="{FF2B5EF4-FFF2-40B4-BE49-F238E27FC236}">
                    <a16:creationId xmlns="" xmlns:a16="http://schemas.microsoft.com/office/drawing/2014/main" id="{05C49F8A-14AF-355E-B10D-CEA5AA725798}"/>
                  </a:ext>
                </a:extLst>
              </p:cNvPr>
              <p:cNvGrpSpPr/>
              <p:nvPr/>
            </p:nvGrpSpPr>
            <p:grpSpPr>
              <a:xfrm rot="11845882">
                <a:off x="9818621" y="1969435"/>
                <a:ext cx="383827" cy="135173"/>
                <a:chOff x="4055221" y="4559068"/>
                <a:chExt cx="261723" cy="101389"/>
              </a:xfrm>
            </p:grpSpPr>
            <p:cxnSp>
              <p:nvCxnSpPr>
                <p:cNvPr id="42" name="Straight Arrow Connector 41">
                  <a:extLst>
                    <a:ext uri="{FF2B5EF4-FFF2-40B4-BE49-F238E27FC236}">
                      <a16:creationId xmlns="" xmlns:a16="http://schemas.microsoft.com/office/drawing/2014/main" id="{A545B5DE-BAB4-9B80-7E8E-F264C12ED3E1}"/>
                    </a:ext>
                  </a:extLst>
                </p:cNvPr>
                <p:cNvCxnSpPr/>
                <p:nvPr/>
              </p:nvCxnSpPr>
              <p:spPr>
                <a:xfrm flipV="1">
                  <a:off x="4083796" y="4559068"/>
                  <a:ext cx="233148" cy="101389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Straight Arrow Connector 42">
                  <a:extLst>
                    <a:ext uri="{FF2B5EF4-FFF2-40B4-BE49-F238E27FC236}">
                      <a16:creationId xmlns="" xmlns:a16="http://schemas.microsoft.com/office/drawing/2014/main" id="{68777472-0E1C-444D-46FC-47E73B577FF7}"/>
                    </a:ext>
                  </a:extLst>
                </p:cNvPr>
                <p:cNvCxnSpPr/>
                <p:nvPr/>
              </p:nvCxnSpPr>
              <p:spPr>
                <a:xfrm flipV="1">
                  <a:off x="4055221" y="4559068"/>
                  <a:ext cx="233148" cy="10138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" name="Group 27">
                <a:extLst>
                  <a:ext uri="{FF2B5EF4-FFF2-40B4-BE49-F238E27FC236}">
                    <a16:creationId xmlns="" xmlns:a16="http://schemas.microsoft.com/office/drawing/2014/main" id="{2E000B06-0B9E-C30F-A5F8-220552EEA501}"/>
                  </a:ext>
                </a:extLst>
              </p:cNvPr>
              <p:cNvGrpSpPr/>
              <p:nvPr/>
            </p:nvGrpSpPr>
            <p:grpSpPr>
              <a:xfrm rot="11845882">
                <a:off x="9744337" y="1235966"/>
                <a:ext cx="383827" cy="135173"/>
                <a:chOff x="4055221" y="4559068"/>
                <a:chExt cx="261723" cy="101389"/>
              </a:xfrm>
            </p:grpSpPr>
            <p:cxnSp>
              <p:nvCxnSpPr>
                <p:cNvPr id="40" name="Straight Arrow Connector 39">
                  <a:extLst>
                    <a:ext uri="{FF2B5EF4-FFF2-40B4-BE49-F238E27FC236}">
                      <a16:creationId xmlns="" xmlns:a16="http://schemas.microsoft.com/office/drawing/2014/main" id="{7B752669-4D7B-3D9C-8D36-4630330DD6CB}"/>
                    </a:ext>
                  </a:extLst>
                </p:cNvPr>
                <p:cNvCxnSpPr/>
                <p:nvPr/>
              </p:nvCxnSpPr>
              <p:spPr>
                <a:xfrm flipV="1">
                  <a:off x="4083796" y="4559068"/>
                  <a:ext cx="233148" cy="101389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Straight Arrow Connector 40">
                  <a:extLst>
                    <a:ext uri="{FF2B5EF4-FFF2-40B4-BE49-F238E27FC236}">
                      <a16:creationId xmlns="" xmlns:a16="http://schemas.microsoft.com/office/drawing/2014/main" id="{DC8F8AA5-4A6A-D6AC-65FF-4FCF927F0872}"/>
                    </a:ext>
                  </a:extLst>
                </p:cNvPr>
                <p:cNvCxnSpPr/>
                <p:nvPr/>
              </p:nvCxnSpPr>
              <p:spPr>
                <a:xfrm flipV="1">
                  <a:off x="4055221" y="4559068"/>
                  <a:ext cx="233148" cy="10138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9" name="TextBox 28">
                <a:extLst>
                  <a:ext uri="{FF2B5EF4-FFF2-40B4-BE49-F238E27FC236}">
                    <a16:creationId xmlns="" xmlns:a16="http://schemas.microsoft.com/office/drawing/2014/main" id="{90B20DFA-8E1C-83D3-ABF8-3735B0277178}"/>
                  </a:ext>
                </a:extLst>
              </p:cNvPr>
              <p:cNvSpPr txBox="1"/>
              <p:nvPr/>
            </p:nvSpPr>
            <p:spPr>
              <a:xfrm>
                <a:off x="756555" y="295556"/>
                <a:ext cx="488516" cy="3377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b="1" dirty="0">
                    <a:ln>
                      <a:solidFill>
                        <a:schemeClr val="bg1"/>
                      </a:solidFill>
                    </a:ln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="" xmlns:a16="http://schemas.microsoft.com/office/drawing/2014/main" id="{E0F75CCE-9F8F-2B3F-AC5E-90E6A69151D0}"/>
                  </a:ext>
                </a:extLst>
              </p:cNvPr>
              <p:cNvSpPr txBox="1"/>
              <p:nvPr/>
            </p:nvSpPr>
            <p:spPr>
              <a:xfrm>
                <a:off x="3287636" y="330846"/>
                <a:ext cx="411821" cy="3377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b="1" dirty="0">
                    <a:ln>
                      <a:solidFill>
                        <a:schemeClr val="bg1"/>
                      </a:solidFill>
                    </a:ln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="" xmlns:a16="http://schemas.microsoft.com/office/drawing/2014/main" id="{DB165EA9-93C2-BDA5-53A4-33A6022DA323}"/>
                  </a:ext>
                </a:extLst>
              </p:cNvPr>
              <p:cNvSpPr txBox="1"/>
              <p:nvPr/>
            </p:nvSpPr>
            <p:spPr>
              <a:xfrm>
                <a:off x="5632178" y="310350"/>
                <a:ext cx="561666" cy="3377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b="1" dirty="0">
                    <a:ln>
                      <a:solidFill>
                        <a:schemeClr val="bg1"/>
                      </a:solidFill>
                    </a:ln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="" xmlns:a16="http://schemas.microsoft.com/office/drawing/2014/main" id="{C286C705-0C89-A83C-A092-C52A52DF7D1C}"/>
                  </a:ext>
                </a:extLst>
              </p:cNvPr>
              <p:cNvSpPr txBox="1"/>
              <p:nvPr/>
            </p:nvSpPr>
            <p:spPr>
              <a:xfrm>
                <a:off x="7985132" y="358956"/>
                <a:ext cx="561666" cy="3377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b="1" dirty="0">
                    <a:ln>
                      <a:solidFill>
                        <a:schemeClr val="bg1"/>
                      </a:solidFill>
                    </a:ln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="" xmlns:a16="http://schemas.microsoft.com/office/drawing/2014/main" id="{0F589A85-FDC9-DD22-E57B-833A4A9F5167}"/>
                  </a:ext>
                </a:extLst>
              </p:cNvPr>
              <p:cNvSpPr txBox="1"/>
              <p:nvPr/>
            </p:nvSpPr>
            <p:spPr>
              <a:xfrm>
                <a:off x="775604" y="2879498"/>
                <a:ext cx="512619" cy="3377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b="1" dirty="0">
                    <a:ln>
                      <a:solidFill>
                        <a:schemeClr val="bg1"/>
                      </a:solidFill>
                    </a:ln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="" xmlns:a16="http://schemas.microsoft.com/office/drawing/2014/main" id="{E6533724-81FE-D6C6-27AE-B5B005E6C6B4}"/>
                  </a:ext>
                </a:extLst>
              </p:cNvPr>
              <p:cNvSpPr txBox="1"/>
              <p:nvPr/>
            </p:nvSpPr>
            <p:spPr>
              <a:xfrm>
                <a:off x="3247643" y="2889305"/>
                <a:ext cx="452536" cy="3377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b="1" dirty="0">
                    <a:ln>
                      <a:solidFill>
                        <a:schemeClr val="bg1"/>
                      </a:solidFill>
                    </a:ln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="" xmlns:a16="http://schemas.microsoft.com/office/drawing/2014/main" id="{9D2A1656-F487-E25F-0280-3A944FDECD3B}"/>
                  </a:ext>
                </a:extLst>
              </p:cNvPr>
              <p:cNvSpPr txBox="1"/>
              <p:nvPr/>
            </p:nvSpPr>
            <p:spPr>
              <a:xfrm>
                <a:off x="5630328" y="2889305"/>
                <a:ext cx="561666" cy="3377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b="1" dirty="0">
                    <a:ln>
                      <a:solidFill>
                        <a:schemeClr val="bg1"/>
                      </a:solidFill>
                    </a:ln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="" xmlns:a16="http://schemas.microsoft.com/office/drawing/2014/main" id="{C74B15BE-5C4F-B8DA-1829-C04C80EBDE96}"/>
                  </a:ext>
                </a:extLst>
              </p:cNvPr>
              <p:cNvSpPr txBox="1"/>
              <p:nvPr/>
            </p:nvSpPr>
            <p:spPr>
              <a:xfrm>
                <a:off x="7994492" y="2886036"/>
                <a:ext cx="561666" cy="3377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b="1" dirty="0">
                    <a:ln>
                      <a:solidFill>
                        <a:schemeClr val="bg1"/>
                      </a:solidFill>
                    </a:ln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</a:t>
                </a:r>
              </a:p>
            </p:txBody>
          </p:sp>
          <p:grpSp>
            <p:nvGrpSpPr>
              <p:cNvPr id="37" name="Group 36">
                <a:extLst>
                  <a:ext uri="{FF2B5EF4-FFF2-40B4-BE49-F238E27FC236}">
                    <a16:creationId xmlns="" xmlns:a16="http://schemas.microsoft.com/office/drawing/2014/main" id="{72AE313A-2DB0-CED6-51D4-2FD731722479}"/>
                  </a:ext>
                </a:extLst>
              </p:cNvPr>
              <p:cNvGrpSpPr/>
              <p:nvPr/>
            </p:nvGrpSpPr>
            <p:grpSpPr>
              <a:xfrm>
                <a:off x="9190884" y="5123729"/>
                <a:ext cx="922650" cy="0"/>
                <a:chOff x="4854909" y="5191125"/>
                <a:chExt cx="337390" cy="0"/>
              </a:xfrm>
            </p:grpSpPr>
            <p:cxnSp>
              <p:nvCxnSpPr>
                <p:cNvPr id="38" name="Straight Connector 37">
                  <a:extLst>
                    <a:ext uri="{FF2B5EF4-FFF2-40B4-BE49-F238E27FC236}">
                      <a16:creationId xmlns="" xmlns:a16="http://schemas.microsoft.com/office/drawing/2014/main" id="{67FC936D-E151-2498-F87F-593B0EF25B1E}"/>
                    </a:ext>
                  </a:extLst>
                </p:cNvPr>
                <p:cNvCxnSpPr/>
                <p:nvPr/>
              </p:nvCxnSpPr>
              <p:spPr>
                <a:xfrm>
                  <a:off x="4864434" y="5191125"/>
                  <a:ext cx="327865" cy="0"/>
                </a:xfrm>
                <a:prstGeom prst="line">
                  <a:avLst/>
                </a:prstGeom>
                <a:ln w="571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Straight Connector 38">
                  <a:extLst>
                    <a:ext uri="{FF2B5EF4-FFF2-40B4-BE49-F238E27FC236}">
                      <a16:creationId xmlns="" xmlns:a16="http://schemas.microsoft.com/office/drawing/2014/main" id="{B9F57A17-37D2-1E3D-D11B-18F8768A642E}"/>
                    </a:ext>
                  </a:extLst>
                </p:cNvPr>
                <p:cNvCxnSpPr/>
                <p:nvPr/>
              </p:nvCxnSpPr>
              <p:spPr>
                <a:xfrm>
                  <a:off x="4854909" y="5191125"/>
                  <a:ext cx="327865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xmlns="" id="{B9FF417E-72EA-9A64-F8C0-75642D591728}"/>
                </a:ext>
              </a:extLst>
            </p:cNvPr>
            <p:cNvSpPr txBox="1"/>
            <p:nvPr/>
          </p:nvSpPr>
          <p:spPr>
            <a:xfrm>
              <a:off x="9946885" y="5900124"/>
              <a:ext cx="78440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b="1" dirty="0">
                  <a:ln>
                    <a:solidFill>
                      <a:schemeClr val="bg1"/>
                    </a:solidFill>
                  </a:ln>
                  <a:latin typeface="Times New Roman" panose="02020603050405020304" pitchFamily="18" charset="0"/>
                  <a:cs typeface="Times New Roman" panose="02020603050405020304" pitchFamily="18" charset="0"/>
                </a:rPr>
                <a:t>1 µm</a:t>
              </a:r>
            </a:p>
          </p:txBody>
        </p:sp>
      </p:grpSp>
      <p:sp>
        <p:nvSpPr>
          <p:cNvPr id="76" name="TextBox 75"/>
          <p:cNvSpPr txBox="1"/>
          <p:nvPr/>
        </p:nvSpPr>
        <p:spPr>
          <a:xfrm>
            <a:off x="10535948" y="3635275"/>
            <a:ext cx="756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Wo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94108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460229" y="342118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.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310996" y="1637015"/>
            <a:ext cx="5769976" cy="2989571"/>
            <a:chOff x="160164" y="1637015"/>
            <a:chExt cx="5769976" cy="2989571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0164" y="1637015"/>
              <a:ext cx="5769976" cy="2989571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176130" y="2479251"/>
              <a:ext cx="3209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867216" y="2517482"/>
              <a:ext cx="3209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558302" y="2510630"/>
              <a:ext cx="3209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236972" y="2426835"/>
              <a:ext cx="3209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6422024" y="1598931"/>
            <a:ext cx="5769976" cy="3027655"/>
            <a:chOff x="6422024" y="1598931"/>
            <a:chExt cx="5769976" cy="3027655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422024" y="1598931"/>
              <a:ext cx="5769976" cy="3027655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7405792" y="2479250"/>
              <a:ext cx="3209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777855" y="2471395"/>
              <a:ext cx="3209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9470779" y="2466115"/>
              <a:ext cx="3209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116175" y="2393841"/>
              <a:ext cx="3209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8323885" y="4626586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118397" y="462658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25124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/>
          <p:cNvGrpSpPr/>
          <p:nvPr/>
        </p:nvGrpSpPr>
        <p:grpSpPr>
          <a:xfrm>
            <a:off x="615847" y="1441121"/>
            <a:ext cx="11384979" cy="4617947"/>
            <a:chOff x="209075" y="1615797"/>
            <a:chExt cx="11384979" cy="4617947"/>
          </a:xfrm>
        </p:grpSpPr>
        <p:grpSp>
          <p:nvGrpSpPr>
            <p:cNvPr id="28" name="Group 27"/>
            <p:cNvGrpSpPr/>
            <p:nvPr/>
          </p:nvGrpSpPr>
          <p:grpSpPr>
            <a:xfrm>
              <a:off x="1059226" y="1615797"/>
              <a:ext cx="8475020" cy="2751082"/>
              <a:chOff x="1117450" y="1472922"/>
              <a:chExt cx="8475020" cy="2751082"/>
            </a:xfrm>
          </p:grpSpPr>
          <p:grpSp>
            <p:nvGrpSpPr>
              <p:cNvPr id="9" name="Group 8"/>
              <p:cNvGrpSpPr/>
              <p:nvPr/>
            </p:nvGrpSpPr>
            <p:grpSpPr>
              <a:xfrm>
                <a:off x="1141292" y="1472922"/>
                <a:ext cx="8451178" cy="369332"/>
                <a:chOff x="760058" y="1450324"/>
                <a:chExt cx="8451178" cy="369332"/>
              </a:xfrm>
            </p:grpSpPr>
            <p:sp>
              <p:nvSpPr>
                <p:cNvPr id="5" name="TextBox 4"/>
                <p:cNvSpPr txBox="1"/>
                <p:nvPr/>
              </p:nvSpPr>
              <p:spPr>
                <a:xfrm>
                  <a:off x="760058" y="1450324"/>
                  <a:ext cx="75533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ay 4</a:t>
                  </a:r>
                </a:p>
              </p:txBody>
            </p:sp>
            <p:sp>
              <p:nvSpPr>
                <p:cNvPr id="6" name="TextBox 5"/>
                <p:cNvSpPr txBox="1"/>
                <p:nvPr/>
              </p:nvSpPr>
              <p:spPr>
                <a:xfrm>
                  <a:off x="5714766" y="1450324"/>
                  <a:ext cx="87075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ay </a:t>
                  </a:r>
                  <a:r>
                    <a:rPr lang="en-US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</a:t>
                  </a:r>
                  <a:endPara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3068713" y="1450324"/>
                  <a:ext cx="75533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ay 8</a:t>
                  </a: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8340485" y="1450324"/>
                  <a:ext cx="87075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ay </a:t>
                  </a:r>
                  <a:r>
                    <a:rPr lang="en-US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6</a:t>
                  </a:r>
                  <a:endPara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0" name="Group 9"/>
              <p:cNvGrpSpPr/>
              <p:nvPr/>
            </p:nvGrpSpPr>
            <p:grpSpPr>
              <a:xfrm>
                <a:off x="1117450" y="3833860"/>
                <a:ext cx="8207287" cy="390144"/>
                <a:chOff x="760058" y="1450324"/>
                <a:chExt cx="8207287" cy="390144"/>
              </a:xfrm>
            </p:grpSpPr>
            <p:sp>
              <p:nvSpPr>
                <p:cNvPr id="11" name="TextBox 10"/>
                <p:cNvSpPr txBox="1"/>
                <p:nvPr/>
              </p:nvSpPr>
              <p:spPr>
                <a:xfrm>
                  <a:off x="760058" y="1450324"/>
                  <a:ext cx="75533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ay 4</a:t>
                  </a: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5679124" y="1471136"/>
                  <a:ext cx="87075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ay </a:t>
                  </a:r>
                  <a:r>
                    <a:rPr lang="en-US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</a:t>
                  </a:r>
                  <a:endPara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3068713" y="1450324"/>
                  <a:ext cx="87075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Day </a:t>
                  </a:r>
                  <a:r>
                    <a:rPr lang="en-US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</a:t>
                  </a:r>
                  <a:endPara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8096594" y="1450324"/>
                  <a:ext cx="87075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ay </a:t>
                  </a:r>
                  <a:r>
                    <a:rPr lang="en-US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6</a:t>
                  </a:r>
                  <a:endPara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006" y="2080938"/>
              <a:ext cx="2272227" cy="1850660"/>
            </a:xfrm>
            <a:prstGeom prst="rect">
              <a:avLst/>
            </a:prstGeom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27586" y="2080938"/>
              <a:ext cx="2303976" cy="185066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69687" y="2080938"/>
              <a:ext cx="2293719" cy="1850660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15017" y="2076747"/>
              <a:ext cx="2262242" cy="1854851"/>
            </a:xfrm>
            <a:prstGeom prst="rect">
              <a:avLst/>
            </a:prstGeom>
          </p:spPr>
        </p:pic>
        <p:sp>
          <p:nvSpPr>
            <p:cNvPr id="35" name="TextBox 34"/>
            <p:cNvSpPr txBox="1"/>
            <p:nvPr/>
          </p:nvSpPr>
          <p:spPr>
            <a:xfrm>
              <a:off x="10126986" y="2564677"/>
              <a:ext cx="8899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0126986" y="5069705"/>
              <a:ext cx="14670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SG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9075" y="4412017"/>
              <a:ext cx="2277158" cy="1821727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27586" y="4412017"/>
              <a:ext cx="2303976" cy="1821727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69687" y="4412017"/>
              <a:ext cx="2293719" cy="1821727"/>
            </a:xfrm>
            <a:prstGeom prst="rect">
              <a:avLst/>
            </a:prstGeom>
          </p:spPr>
        </p:pic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15016" y="4412016"/>
              <a:ext cx="2262243" cy="1821727"/>
            </a:xfrm>
            <a:prstGeom prst="rect">
              <a:avLst/>
            </a:prstGeom>
          </p:spPr>
        </p:pic>
      </p:grpSp>
      <p:sp>
        <p:nvSpPr>
          <p:cNvPr id="25" name="TextBox 24"/>
          <p:cNvSpPr txBox="1"/>
          <p:nvPr/>
        </p:nvSpPr>
        <p:spPr>
          <a:xfrm>
            <a:off x="5438334" y="6170155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0939882" y="261296"/>
            <a:ext cx="756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Wo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26604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697319" y="1423939"/>
            <a:ext cx="11330321" cy="4589193"/>
            <a:chOff x="392519" y="1615797"/>
            <a:chExt cx="11330321" cy="4589193"/>
          </a:xfrm>
        </p:grpSpPr>
        <p:grpSp>
          <p:nvGrpSpPr>
            <p:cNvPr id="28" name="Group 27"/>
            <p:cNvGrpSpPr/>
            <p:nvPr/>
          </p:nvGrpSpPr>
          <p:grpSpPr>
            <a:xfrm>
              <a:off x="1059226" y="1615797"/>
              <a:ext cx="10663614" cy="3850505"/>
              <a:chOff x="1117450" y="1472922"/>
              <a:chExt cx="10663614" cy="3850505"/>
            </a:xfrm>
          </p:grpSpPr>
          <p:grpSp>
            <p:nvGrpSpPr>
              <p:cNvPr id="9" name="Group 8"/>
              <p:cNvGrpSpPr/>
              <p:nvPr/>
            </p:nvGrpSpPr>
            <p:grpSpPr>
              <a:xfrm>
                <a:off x="1141292" y="1472922"/>
                <a:ext cx="8451178" cy="369332"/>
                <a:chOff x="760058" y="1450324"/>
                <a:chExt cx="8451178" cy="369332"/>
              </a:xfrm>
            </p:grpSpPr>
            <p:sp>
              <p:nvSpPr>
                <p:cNvPr id="5" name="TextBox 4"/>
                <p:cNvSpPr txBox="1"/>
                <p:nvPr/>
              </p:nvSpPr>
              <p:spPr>
                <a:xfrm>
                  <a:off x="760058" y="1450324"/>
                  <a:ext cx="75533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ay 4</a:t>
                  </a:r>
                </a:p>
              </p:txBody>
            </p:sp>
            <p:sp>
              <p:nvSpPr>
                <p:cNvPr id="6" name="TextBox 5"/>
                <p:cNvSpPr txBox="1"/>
                <p:nvPr/>
              </p:nvSpPr>
              <p:spPr>
                <a:xfrm>
                  <a:off x="5714766" y="1450324"/>
                  <a:ext cx="87075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ay </a:t>
                  </a:r>
                  <a:r>
                    <a:rPr lang="en-US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</a:t>
                  </a:r>
                  <a:endPara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3068713" y="1450324"/>
                  <a:ext cx="75533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ay 8</a:t>
                  </a: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8340485" y="1450324"/>
                  <a:ext cx="87075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ay </a:t>
                  </a:r>
                  <a:r>
                    <a:rPr lang="en-US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6</a:t>
                  </a:r>
                  <a:endPara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0" name="Group 9"/>
              <p:cNvGrpSpPr/>
              <p:nvPr/>
            </p:nvGrpSpPr>
            <p:grpSpPr>
              <a:xfrm>
                <a:off x="1117450" y="3833860"/>
                <a:ext cx="8207287" cy="390144"/>
                <a:chOff x="760058" y="1450324"/>
                <a:chExt cx="8207287" cy="390144"/>
              </a:xfrm>
            </p:grpSpPr>
            <p:sp>
              <p:nvSpPr>
                <p:cNvPr id="11" name="TextBox 10"/>
                <p:cNvSpPr txBox="1"/>
                <p:nvPr/>
              </p:nvSpPr>
              <p:spPr>
                <a:xfrm>
                  <a:off x="760058" y="1450324"/>
                  <a:ext cx="75533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ay 4</a:t>
                  </a: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5679124" y="1471136"/>
                  <a:ext cx="87075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ay </a:t>
                  </a:r>
                  <a:r>
                    <a:rPr lang="en-US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</a:t>
                  </a:r>
                  <a:endPara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3068713" y="1450324"/>
                  <a:ext cx="87075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Day </a:t>
                  </a:r>
                  <a:r>
                    <a:rPr lang="en-US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</a:t>
                  </a:r>
                  <a:endPara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8096594" y="1450324"/>
                  <a:ext cx="87075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ay </a:t>
                  </a:r>
                  <a:r>
                    <a:rPr lang="en-US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6</a:t>
                  </a:r>
                  <a:endPara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8" name="TextBox 17"/>
              <p:cNvSpPr txBox="1"/>
              <p:nvPr/>
            </p:nvSpPr>
            <p:spPr>
              <a:xfrm>
                <a:off x="10313996" y="2525606"/>
                <a:ext cx="8899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10313996" y="4954095"/>
                <a:ext cx="14670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 </a:t>
                </a:r>
                <a:r>
                  <a:rPr lang="en-US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</a:t>
                </a:r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SG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aturation sat="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98034" y="2122839"/>
              <a:ext cx="2307204" cy="1829948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aturation sat="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48200" y="4370015"/>
              <a:ext cx="2293718" cy="1834974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aturation sat="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2519" y="4366879"/>
              <a:ext cx="2272227" cy="1829514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80043" y="4370015"/>
              <a:ext cx="2275729" cy="1826378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aturation sat="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43364" y="2125218"/>
              <a:ext cx="2298553" cy="1827919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aturation sat="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80043" y="2122839"/>
              <a:ext cx="2275729" cy="1829948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saturation sat="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2519" y="2122840"/>
              <a:ext cx="2272227" cy="1829948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07708" y="4366880"/>
              <a:ext cx="2302367" cy="1838110"/>
            </a:xfrm>
            <a:prstGeom prst="rect">
              <a:avLst/>
            </a:prstGeom>
          </p:spPr>
        </p:pic>
      </p:grpSp>
      <p:sp>
        <p:nvSpPr>
          <p:cNvPr id="29" name="TextBox 28"/>
          <p:cNvSpPr txBox="1"/>
          <p:nvPr/>
        </p:nvSpPr>
        <p:spPr>
          <a:xfrm>
            <a:off x="10402554" y="229447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TR-8/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Vneo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438334" y="6170155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4068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977981" y="5723285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9241763" y="3161364"/>
            <a:ext cx="2454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rly Placental Explants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1528204" y="1383085"/>
            <a:ext cx="7370699" cy="3556559"/>
            <a:chOff x="1336485" y="1920414"/>
            <a:chExt cx="5332494" cy="2658358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285" t="30576" r="30213" b="30661"/>
            <a:stretch/>
          </p:blipFill>
          <p:spPr>
            <a:xfrm>
              <a:off x="1336485" y="1920414"/>
              <a:ext cx="2572912" cy="2658358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9" t="17793" r="209" b="5232"/>
            <a:stretch/>
          </p:blipFill>
          <p:spPr>
            <a:xfrm>
              <a:off x="4096067" y="1920414"/>
              <a:ext cx="2572912" cy="2658358"/>
            </a:xfrm>
            <a:prstGeom prst="rect">
              <a:avLst/>
            </a:prstGeom>
          </p:spPr>
        </p:pic>
      </p:grpSp>
      <p:sp>
        <p:nvSpPr>
          <p:cNvPr id="6" name="TextBox 5"/>
          <p:cNvSpPr txBox="1"/>
          <p:nvPr/>
        </p:nvSpPr>
        <p:spPr>
          <a:xfrm>
            <a:off x="2111604" y="5201984"/>
            <a:ext cx="20249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ological Replicate 1</a:t>
            </a:r>
            <a:endParaRPr lang="en-I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108276" y="5201984"/>
            <a:ext cx="20249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ological Replicate 2</a:t>
            </a:r>
            <a:endParaRPr lang="en-I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35819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42042" y="209137"/>
            <a:ext cx="11758264" cy="6615191"/>
            <a:chOff x="142042" y="209137"/>
            <a:chExt cx="11758264" cy="6615191"/>
          </a:xfrm>
        </p:grpSpPr>
        <p:sp>
          <p:nvSpPr>
            <p:cNvPr id="3" name="TextBox 2"/>
            <p:cNvSpPr txBox="1"/>
            <p:nvPr/>
          </p:nvSpPr>
          <p:spPr>
            <a:xfrm>
              <a:off x="142042" y="209137"/>
              <a:ext cx="11464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2.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978427" y="2977699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</a:t>
              </a:r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10372304" y="1334579"/>
              <a:ext cx="7561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Wo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0369118" y="4866443"/>
              <a:ext cx="15311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R-8/</a:t>
              </a:r>
              <a:r>
                <a:rPr lang="en-US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Vneo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80569" y="455781"/>
              <a:ext cx="2488853" cy="249626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32928" y="455781"/>
              <a:ext cx="2488853" cy="249626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85287" y="455781"/>
              <a:ext cx="2488853" cy="249626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2497550" y="2376490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2.1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490474" y="639945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.1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191486" y="687149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4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179441" y="2355228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.4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156584" y="2376490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2.3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149508" y="639945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.4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850520" y="687149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8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838475" y="2355228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5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770322" y="2355228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9.7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7763246" y="618683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.1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9464258" y="665887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.3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9452213" y="2333966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9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80569" y="3961362"/>
              <a:ext cx="2480937" cy="2543175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29742" y="3961362"/>
              <a:ext cx="2488853" cy="2543175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82101" y="3961361"/>
              <a:ext cx="2488853" cy="2543175"/>
            </a:xfrm>
            <a:prstGeom prst="rect">
              <a:avLst/>
            </a:prstGeom>
          </p:spPr>
        </p:pic>
        <p:sp>
          <p:nvSpPr>
            <p:cNvPr id="32" name="TextBox 31"/>
            <p:cNvSpPr txBox="1"/>
            <p:nvPr/>
          </p:nvSpPr>
          <p:spPr>
            <a:xfrm>
              <a:off x="5168908" y="5866937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1.3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161832" y="4130392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3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862844" y="4177596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.6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6771168" y="5874612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.8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513084" y="5888199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9.6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506008" y="4151654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7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150779" y="4198858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.9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4103975" y="5866937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9.8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7815857" y="5888199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9.4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7808781" y="4151654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2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9509793" y="4198858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.3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9433627" y="5866937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1.1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6074168" y="6454996"/>
              <a:ext cx="4539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113276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60616" y="-18403"/>
            <a:ext cx="11685074" cy="6729283"/>
            <a:chOff x="460616" y="-18403"/>
            <a:chExt cx="11685074" cy="6729283"/>
          </a:xfrm>
        </p:grpSpPr>
        <p:sp>
          <p:nvSpPr>
            <p:cNvPr id="4" name="TextBox 3"/>
            <p:cNvSpPr txBox="1"/>
            <p:nvPr/>
          </p:nvSpPr>
          <p:spPr>
            <a:xfrm>
              <a:off x="5509730" y="6341548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</a:t>
              </a:r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3061546" y="3766784"/>
              <a:ext cx="2543175" cy="2543175"/>
              <a:chOff x="3109622" y="1079036"/>
              <a:chExt cx="2543175" cy="2543175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09622" y="1079036"/>
                <a:ext cx="2543175" cy="2543175"/>
              </a:xfrm>
              <a:prstGeom prst="rect">
                <a:avLst/>
              </a:prstGeom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3450975" y="2986632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6.1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3443899" y="1250087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.4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5131487" y="1297588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8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5084600" y="2986631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.7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460616" y="3762852"/>
              <a:ext cx="2543175" cy="2543175"/>
              <a:chOff x="277632" y="1079037"/>
              <a:chExt cx="2543175" cy="2543175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7632" y="1079037"/>
                <a:ext cx="2543175" cy="2543175"/>
              </a:xfrm>
              <a:prstGeom prst="rect">
                <a:avLst/>
              </a:prstGeom>
            </p:spPr>
          </p:pic>
          <p:sp>
            <p:nvSpPr>
              <p:cNvPr id="17" name="TextBox 16"/>
              <p:cNvSpPr txBox="1"/>
              <p:nvPr/>
            </p:nvSpPr>
            <p:spPr>
              <a:xfrm>
                <a:off x="635541" y="3007893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5.1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628465" y="1271348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.3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329477" y="1318552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2317432" y="2986631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6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3061546" y="395476"/>
              <a:ext cx="2543175" cy="2543175"/>
              <a:chOff x="9428513" y="1079036"/>
              <a:chExt cx="2543175" cy="2543175"/>
            </a:xfrm>
          </p:grpSpPr>
          <p:pic>
            <p:nvPicPr>
              <p:cNvPr id="22" name="Picture 21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428513" y="1079036"/>
                <a:ext cx="2543175" cy="2543175"/>
              </a:xfrm>
              <a:prstGeom prst="rect">
                <a:avLst/>
              </a:prstGeom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9773876" y="3020461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.4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9773875" y="1215707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.9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1438935" y="1261179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3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11407501" y="3020460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7" name="Group 26"/>
            <p:cNvGrpSpPr/>
            <p:nvPr/>
          </p:nvGrpSpPr>
          <p:grpSpPr>
            <a:xfrm>
              <a:off x="465783" y="395477"/>
              <a:ext cx="2543176" cy="2543174"/>
              <a:chOff x="6737056" y="1079037"/>
              <a:chExt cx="2543176" cy="2543174"/>
            </a:xfrm>
          </p:grpSpPr>
          <p:pic>
            <p:nvPicPr>
              <p:cNvPr id="28" name="Picture 27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37056" y="1079037"/>
                <a:ext cx="2543176" cy="2543174"/>
              </a:xfrm>
              <a:prstGeom prst="rect">
                <a:avLst/>
              </a:prstGeom>
            </p:spPr>
          </p:pic>
          <p:sp>
            <p:nvSpPr>
              <p:cNvPr id="29" name="TextBox 28"/>
              <p:cNvSpPr txBox="1"/>
              <p:nvPr/>
            </p:nvSpPr>
            <p:spPr>
              <a:xfrm>
                <a:off x="7102834" y="3020459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2.3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7102833" y="1215705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.3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8789189" y="1271347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2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8736459" y="3020458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2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3" name="TextBox 32"/>
            <p:cNvSpPr txBox="1"/>
            <p:nvPr/>
          </p:nvSpPr>
          <p:spPr>
            <a:xfrm>
              <a:off x="2601479" y="31589"/>
              <a:ext cx="69121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4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8095199" y="31589"/>
              <a:ext cx="69121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8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5" name="Group 34"/>
            <p:cNvGrpSpPr/>
            <p:nvPr/>
          </p:nvGrpSpPr>
          <p:grpSpPr>
            <a:xfrm>
              <a:off x="8409831" y="3762853"/>
              <a:ext cx="2543175" cy="2543175"/>
              <a:chOff x="3109622" y="4106445"/>
              <a:chExt cx="2543175" cy="2543175"/>
            </a:xfrm>
          </p:grpSpPr>
          <p:pic>
            <p:nvPicPr>
              <p:cNvPr id="36" name="Picture 35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09622" y="4106445"/>
                <a:ext cx="2543175" cy="2543175"/>
              </a:xfrm>
              <a:prstGeom prst="rect">
                <a:avLst/>
              </a:prstGeom>
            </p:spPr>
          </p:pic>
          <p:sp>
            <p:nvSpPr>
              <p:cNvPr id="37" name="TextBox 36"/>
              <p:cNvSpPr txBox="1"/>
              <p:nvPr/>
            </p:nvSpPr>
            <p:spPr>
              <a:xfrm>
                <a:off x="3450975" y="5965837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.9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3460034" y="4278852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1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5129602" y="5987311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.8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5111288" y="4298268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.4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1" name="Group 40"/>
            <p:cNvGrpSpPr/>
            <p:nvPr/>
          </p:nvGrpSpPr>
          <p:grpSpPr>
            <a:xfrm>
              <a:off x="5790777" y="3762852"/>
              <a:ext cx="2543175" cy="2543175"/>
              <a:chOff x="277631" y="4106445"/>
              <a:chExt cx="2543175" cy="2543175"/>
            </a:xfrm>
          </p:grpSpPr>
          <p:pic>
            <p:nvPicPr>
              <p:cNvPr id="42" name="Picture 41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7631" y="4106445"/>
                <a:ext cx="2543175" cy="2543175"/>
              </a:xfrm>
              <a:prstGeom prst="rect">
                <a:avLst/>
              </a:prstGeom>
            </p:spPr>
          </p:pic>
          <p:sp>
            <p:nvSpPr>
              <p:cNvPr id="43" name="TextBox 42"/>
              <p:cNvSpPr txBox="1"/>
              <p:nvPr/>
            </p:nvSpPr>
            <p:spPr>
              <a:xfrm>
                <a:off x="635541" y="6014999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6.1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628465" y="4278454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.7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2329477" y="4335845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2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2269166" y="6014998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.1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7" name="TextBox 46"/>
            <p:cNvSpPr txBox="1"/>
            <p:nvPr/>
          </p:nvSpPr>
          <p:spPr>
            <a:xfrm>
              <a:off x="2601479" y="3396641"/>
              <a:ext cx="79380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12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7969362" y="3396641"/>
              <a:ext cx="79380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16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9" name="Group 48"/>
            <p:cNvGrpSpPr/>
            <p:nvPr/>
          </p:nvGrpSpPr>
          <p:grpSpPr>
            <a:xfrm>
              <a:off x="8411104" y="370143"/>
              <a:ext cx="2543175" cy="2543175"/>
              <a:chOff x="9428512" y="4106443"/>
              <a:chExt cx="2543175" cy="2543175"/>
            </a:xfrm>
          </p:grpSpPr>
          <p:pic>
            <p:nvPicPr>
              <p:cNvPr id="50" name="Picture 49"/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428512" y="4106443"/>
                <a:ext cx="2543175" cy="2543175"/>
              </a:xfrm>
              <a:prstGeom prst="rect">
                <a:avLst/>
              </a:prstGeom>
            </p:spPr>
          </p:pic>
          <p:sp>
            <p:nvSpPr>
              <p:cNvPr id="51" name="TextBox 50"/>
              <p:cNvSpPr txBox="1"/>
              <p:nvPr/>
            </p:nvSpPr>
            <p:spPr>
              <a:xfrm>
                <a:off x="9789456" y="6076593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5.4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9789455" y="4271839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9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11574535" y="4317313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11423081" y="6076592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7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5" name="Group 54"/>
            <p:cNvGrpSpPr/>
            <p:nvPr/>
          </p:nvGrpSpPr>
          <p:grpSpPr>
            <a:xfrm>
              <a:off x="5806463" y="370143"/>
              <a:ext cx="2543176" cy="2543175"/>
              <a:chOff x="6737056" y="4106444"/>
              <a:chExt cx="2543176" cy="2543175"/>
            </a:xfrm>
          </p:grpSpPr>
          <p:pic>
            <p:nvPicPr>
              <p:cNvPr id="56" name="Picture 55"/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37056" y="4106444"/>
                <a:ext cx="2543176" cy="2543175"/>
              </a:xfrm>
              <a:prstGeom prst="rect">
                <a:avLst/>
              </a:prstGeom>
            </p:spPr>
          </p:pic>
          <p:sp>
            <p:nvSpPr>
              <p:cNvPr id="57" name="TextBox 56"/>
              <p:cNvSpPr txBox="1"/>
              <p:nvPr/>
            </p:nvSpPr>
            <p:spPr>
              <a:xfrm>
                <a:off x="7102834" y="6076593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5.6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7102833" y="4271839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.4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8803845" y="4317313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3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8736459" y="6076592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7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1" name="TextBox 60"/>
            <p:cNvSpPr txBox="1"/>
            <p:nvPr/>
          </p:nvSpPr>
          <p:spPr>
            <a:xfrm>
              <a:off x="10614502" y="-18403"/>
              <a:ext cx="15311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R-8/</a:t>
              </a:r>
              <a:r>
                <a:rPr lang="en-US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Vneo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226734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51421" y="41599"/>
            <a:ext cx="11518719" cy="6789742"/>
            <a:chOff x="651421" y="41599"/>
            <a:chExt cx="11518719" cy="6789742"/>
          </a:xfrm>
        </p:grpSpPr>
        <p:sp>
          <p:nvSpPr>
            <p:cNvPr id="4" name="TextBox 3"/>
            <p:cNvSpPr txBox="1"/>
            <p:nvPr/>
          </p:nvSpPr>
          <p:spPr>
            <a:xfrm>
              <a:off x="5848382" y="6462009"/>
              <a:ext cx="4539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d)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1414036" y="41599"/>
              <a:ext cx="7561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Wo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953140" y="112815"/>
              <a:ext cx="69121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4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8446860" y="112815"/>
              <a:ext cx="69121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8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953140" y="3477867"/>
              <a:ext cx="79380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12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8321023" y="3477867"/>
              <a:ext cx="79380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16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0" name="Group 9"/>
            <p:cNvGrpSpPr/>
            <p:nvPr/>
          </p:nvGrpSpPr>
          <p:grpSpPr>
            <a:xfrm>
              <a:off x="651421" y="451369"/>
              <a:ext cx="2543175" cy="2543175"/>
              <a:chOff x="375931" y="4221215"/>
              <a:chExt cx="2543175" cy="2543175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5931" y="4221215"/>
                <a:ext cx="2543175" cy="2543175"/>
              </a:xfrm>
              <a:prstGeom prst="rect">
                <a:avLst/>
              </a:prstGeom>
            </p:spPr>
          </p:pic>
          <p:sp>
            <p:nvSpPr>
              <p:cNvPr id="12" name="TextBox 11"/>
              <p:cNvSpPr txBox="1"/>
              <p:nvPr/>
            </p:nvSpPr>
            <p:spPr>
              <a:xfrm>
                <a:off x="695775" y="6125074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4.2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688699" y="4388529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2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389711" y="4435733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6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2377666" y="6103812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5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3274515" y="451368"/>
              <a:ext cx="2543175" cy="2543175"/>
              <a:chOff x="3165554" y="4234551"/>
              <a:chExt cx="2543175" cy="2543175"/>
            </a:xfrm>
          </p:grpSpPr>
          <p:pic>
            <p:nvPicPr>
              <p:cNvPr id="17" name="Picture 16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65554" y="4234551"/>
                <a:ext cx="2543175" cy="2543175"/>
              </a:xfrm>
              <a:prstGeom prst="rect">
                <a:avLst/>
              </a:prstGeom>
            </p:spPr>
          </p:pic>
          <p:sp>
            <p:nvSpPr>
              <p:cNvPr id="18" name="TextBox 17"/>
              <p:cNvSpPr txBox="1"/>
              <p:nvPr/>
            </p:nvSpPr>
            <p:spPr>
              <a:xfrm>
                <a:off x="3523105" y="6160116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8.2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516029" y="4423571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.8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5217041" y="4470775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2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5204996" y="6138854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8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2" name="Group 21"/>
            <p:cNvGrpSpPr/>
            <p:nvPr/>
          </p:nvGrpSpPr>
          <p:grpSpPr>
            <a:xfrm>
              <a:off x="6280440" y="451368"/>
              <a:ext cx="2543175" cy="2543175"/>
              <a:chOff x="6568452" y="4221215"/>
              <a:chExt cx="2543175" cy="2543175"/>
            </a:xfrm>
          </p:grpSpPr>
          <p:pic>
            <p:nvPicPr>
              <p:cNvPr id="23" name="Picture 22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68452" y="4221215"/>
                <a:ext cx="2543175" cy="2543175"/>
              </a:xfrm>
              <a:prstGeom prst="rect">
                <a:avLst/>
              </a:prstGeom>
            </p:spPr>
          </p:pic>
          <p:sp>
            <p:nvSpPr>
              <p:cNvPr id="24" name="TextBox 23"/>
              <p:cNvSpPr txBox="1"/>
              <p:nvPr/>
            </p:nvSpPr>
            <p:spPr>
              <a:xfrm>
                <a:off x="6917781" y="6160116"/>
                <a:ext cx="5373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9.2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6910705" y="4423571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2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8611717" y="4470775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7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8599672" y="6138854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%</a:t>
                </a:r>
                <a:endParaRPr lang="en-IN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8" name="Group 27"/>
            <p:cNvGrpSpPr/>
            <p:nvPr/>
          </p:nvGrpSpPr>
          <p:grpSpPr>
            <a:xfrm>
              <a:off x="8880126" y="451367"/>
              <a:ext cx="2545955" cy="2543175"/>
              <a:chOff x="9358075" y="4221216"/>
              <a:chExt cx="2545955" cy="2543175"/>
            </a:xfrm>
          </p:grpSpPr>
          <p:pic>
            <p:nvPicPr>
              <p:cNvPr id="29" name="Picture 28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358075" y="4221216"/>
                <a:ext cx="2543175" cy="2543175"/>
              </a:xfrm>
              <a:prstGeom prst="rect">
                <a:avLst/>
              </a:prstGeom>
            </p:spPr>
          </p:pic>
          <p:grpSp>
            <p:nvGrpSpPr>
              <p:cNvPr id="30" name="Group 29"/>
              <p:cNvGrpSpPr/>
              <p:nvPr/>
            </p:nvGrpSpPr>
            <p:grpSpPr>
              <a:xfrm>
                <a:off x="9729812" y="4402309"/>
                <a:ext cx="2174218" cy="1982766"/>
                <a:chOff x="9729812" y="4402309"/>
                <a:chExt cx="2174218" cy="1982766"/>
              </a:xfrm>
            </p:grpSpPr>
            <p:sp>
              <p:nvSpPr>
                <p:cNvPr id="31" name="TextBox 30"/>
                <p:cNvSpPr txBox="1"/>
                <p:nvPr/>
              </p:nvSpPr>
              <p:spPr>
                <a:xfrm>
                  <a:off x="9736888" y="6138854"/>
                  <a:ext cx="53732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7.4%</a:t>
                  </a:r>
                  <a:endPara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9729812" y="4402309"/>
                  <a:ext cx="47320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</a:t>
                  </a:r>
                  <a:r>
                    <a:rPr lang="en-US" sz="10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.1%</a:t>
                  </a:r>
                  <a:endPara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11430824" y="4449513"/>
                  <a:ext cx="47320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.3%</a:t>
                  </a:r>
                  <a:endPara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11418779" y="6117592"/>
                  <a:ext cx="47320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.4%</a:t>
                  </a:r>
                  <a:endPara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1421" y="3891403"/>
              <a:ext cx="2561657" cy="2514983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92997" y="3891402"/>
              <a:ext cx="2524693" cy="2514983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80440" y="3897750"/>
              <a:ext cx="2543175" cy="2508635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80126" y="3891402"/>
              <a:ext cx="2533910" cy="2514983"/>
            </a:xfrm>
            <a:prstGeom prst="rect">
              <a:avLst/>
            </a:prstGeom>
          </p:spPr>
        </p:pic>
        <p:sp>
          <p:nvSpPr>
            <p:cNvPr id="39" name="TextBox 38"/>
            <p:cNvSpPr txBox="1"/>
            <p:nvPr/>
          </p:nvSpPr>
          <p:spPr>
            <a:xfrm>
              <a:off x="891473" y="5897929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0.3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891473" y="4053523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706151" y="4053523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1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679900" y="5876667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6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495495" y="5949970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5.4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492960" y="4059536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3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5336793" y="4059537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4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5283922" y="5928708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.9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6454265" y="5897928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5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6521290" y="4059537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.1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8325968" y="4059537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9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8420244" y="5876666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9046635" y="5897928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3.8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9113660" y="4059537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9.4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0942996" y="4059537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2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0928196" y="5876666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5%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371762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8808060" y="479127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992509" y="4791271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87053" y="2096171"/>
            <a:ext cx="4767485" cy="2771465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43821" y="2096171"/>
            <a:ext cx="4767485" cy="27861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33256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02734" y="3577172"/>
            <a:ext cx="4724809" cy="272665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8697" y="397626"/>
            <a:ext cx="4724809" cy="278611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8697" y="3523809"/>
            <a:ext cx="4730906" cy="278001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02734" y="458592"/>
            <a:ext cx="4724809" cy="2725148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8641355" y="6274564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j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435867" y="6274564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8641355" y="3052436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h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435867" y="3052436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)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31034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476</TotalTime>
  <Words>948</Words>
  <Application>Microsoft Office PowerPoint</Application>
  <PresentationFormat>Widescreen</PresentationFormat>
  <Paragraphs>648</Paragraphs>
  <Slides>18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NDRANI</dc:creator>
  <cp:lastModifiedBy>INDRANI</cp:lastModifiedBy>
  <cp:revision>152</cp:revision>
  <dcterms:created xsi:type="dcterms:W3CDTF">2021-05-25T20:42:22Z</dcterms:created>
  <dcterms:modified xsi:type="dcterms:W3CDTF">2022-12-27T09:49:48Z</dcterms:modified>
</cp:coreProperties>
</file>